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27" r:id="rId2"/>
    <p:sldId id="32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  <a:srgbClr val="333333"/>
    <a:srgbClr val="5F5F5F"/>
    <a:srgbClr val="777777"/>
    <a:srgbClr val="808080"/>
    <a:srgbClr val="969696"/>
    <a:srgbClr val="B2B2B2"/>
    <a:srgbClr val="C0C0C0"/>
    <a:srgbClr val="DDDDDD"/>
    <a:srgbClr val="4D4D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80" autoAdjust="0"/>
    <p:restoredTop sz="94660"/>
  </p:normalViewPr>
  <p:slideViewPr>
    <p:cSldViewPr snapToGrid="0">
      <p:cViewPr>
        <p:scale>
          <a:sx n="125" d="100"/>
          <a:sy n="125" d="100"/>
        </p:scale>
        <p:origin x="720" y="-9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F4FDE4-7931-45CF-B852-CE769093E0B9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74FD8A-9859-4EE2-9E1F-EF1C072134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4394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KS-520 M 0.815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238978-854F-4667-A206-8F569AA2170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206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48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図プレースホルダー 6">
            <a:extLst>
              <a:ext uri="{FF2B5EF4-FFF2-40B4-BE49-F238E27FC236}">
                <a16:creationId xmlns:a16="http://schemas.microsoft.com/office/drawing/2014/main" id="{6195BB73-0575-45A3-A0F0-42FF32778D40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80533" y="1319238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8" name="図プレースホルダー 6">
            <a:extLst>
              <a:ext uri="{FF2B5EF4-FFF2-40B4-BE49-F238E27FC236}">
                <a16:creationId xmlns:a16="http://schemas.microsoft.com/office/drawing/2014/main" id="{1EBF9B5A-A138-4B0D-A890-F444108B74E4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2357469" y="1319238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9" name="図プレースホルダー 6">
            <a:extLst>
              <a:ext uri="{FF2B5EF4-FFF2-40B4-BE49-F238E27FC236}">
                <a16:creationId xmlns:a16="http://schemas.microsoft.com/office/drawing/2014/main" id="{EC9F3C95-BB33-471F-9DCB-990810CC5600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4534405" y="1319238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0" name="図プレースホルダー 6">
            <a:extLst>
              <a:ext uri="{FF2B5EF4-FFF2-40B4-BE49-F238E27FC236}">
                <a16:creationId xmlns:a16="http://schemas.microsoft.com/office/drawing/2014/main" id="{2A4A1264-9F90-48B3-9A4D-98AB4A626AB5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180533" y="315300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1" name="図プレースホルダー 6">
            <a:extLst>
              <a:ext uri="{FF2B5EF4-FFF2-40B4-BE49-F238E27FC236}">
                <a16:creationId xmlns:a16="http://schemas.microsoft.com/office/drawing/2014/main" id="{9C556ADF-C792-4EBA-B89A-1D9D7EE1B88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2357469" y="315300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2" name="図プレースホルダー 6">
            <a:extLst>
              <a:ext uri="{FF2B5EF4-FFF2-40B4-BE49-F238E27FC236}">
                <a16:creationId xmlns:a16="http://schemas.microsoft.com/office/drawing/2014/main" id="{0BD3333C-7E70-41B2-B5F1-394DB17FAB20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4534405" y="315300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3" name="図プレースホルダー 6">
            <a:extLst>
              <a:ext uri="{FF2B5EF4-FFF2-40B4-BE49-F238E27FC236}">
                <a16:creationId xmlns:a16="http://schemas.microsoft.com/office/drawing/2014/main" id="{7F9F6B07-80B8-4B33-93A2-A82E5BEFE38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80533" y="498298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4" name="図プレースホルダー 6">
            <a:extLst>
              <a:ext uri="{FF2B5EF4-FFF2-40B4-BE49-F238E27FC236}">
                <a16:creationId xmlns:a16="http://schemas.microsoft.com/office/drawing/2014/main" id="{D86439F9-D97A-48FD-A8C9-4DA7BC126851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2357469" y="498298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15" name="図プレースホルダー 6">
            <a:extLst>
              <a:ext uri="{FF2B5EF4-FFF2-40B4-BE49-F238E27FC236}">
                <a16:creationId xmlns:a16="http://schemas.microsoft.com/office/drawing/2014/main" id="{87C06A22-267E-47D7-B583-8CFFECEF0D94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4534405" y="498298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22" name="図プレースホルダー 6">
            <a:extLst>
              <a:ext uri="{FF2B5EF4-FFF2-40B4-BE49-F238E27FC236}">
                <a16:creationId xmlns:a16="http://schemas.microsoft.com/office/drawing/2014/main" id="{1787799A-B6B5-4CF4-8ED4-A00501533BBA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180533" y="681296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23" name="図プレースホルダー 6">
            <a:extLst>
              <a:ext uri="{FF2B5EF4-FFF2-40B4-BE49-F238E27FC236}">
                <a16:creationId xmlns:a16="http://schemas.microsoft.com/office/drawing/2014/main" id="{1411F599-0E61-43B2-B06E-A337BF546467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2357469" y="681296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24" name="図プレースホルダー 6">
            <a:extLst>
              <a:ext uri="{FF2B5EF4-FFF2-40B4-BE49-F238E27FC236}">
                <a16:creationId xmlns:a16="http://schemas.microsoft.com/office/drawing/2014/main" id="{CAE5CCA3-E8A6-4015-86F9-828B74A27908}"/>
              </a:ext>
            </a:extLst>
          </p:cNvPr>
          <p:cNvSpPr>
            <a:spLocks noGrp="1"/>
          </p:cNvSpPr>
          <p:nvPr>
            <p:ph type="pic" sz="quarter" idx="21"/>
          </p:nvPr>
        </p:nvSpPr>
        <p:spPr>
          <a:xfrm>
            <a:off x="4534405" y="6812960"/>
            <a:ext cx="2160000" cy="1800000"/>
          </a:xfrm>
        </p:spPr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6408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0266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9520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図プレースホルダー 6">
            <a:extLst>
              <a:ext uri="{FF2B5EF4-FFF2-40B4-BE49-F238E27FC236}">
                <a16:creationId xmlns:a16="http://schemas.microsoft.com/office/drawing/2014/main" id="{D6788D9D-507A-4E44-B650-3122439FEB2C}"/>
              </a:ext>
            </a:extLst>
          </p:cNvPr>
          <p:cNvSpPr>
            <a:spLocks noGrp="1" noChangeAspect="1"/>
          </p:cNvSpPr>
          <p:nvPr>
            <p:ph type="pic" sz="quarter" idx="10"/>
          </p:nvPr>
        </p:nvSpPr>
        <p:spPr>
          <a:xfrm>
            <a:off x="591111" y="375957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8" name="図プレースホルダー 6">
            <a:extLst>
              <a:ext uri="{FF2B5EF4-FFF2-40B4-BE49-F238E27FC236}">
                <a16:creationId xmlns:a16="http://schemas.microsoft.com/office/drawing/2014/main" id="{FC7BC13E-4632-47E4-907C-F8E30A497F05}"/>
              </a:ext>
            </a:extLst>
          </p:cNvPr>
          <p:cNvSpPr>
            <a:spLocks noGrp="1" noChangeAspect="1"/>
          </p:cNvSpPr>
          <p:nvPr>
            <p:ph type="pic" sz="quarter" idx="11"/>
          </p:nvPr>
        </p:nvSpPr>
        <p:spPr>
          <a:xfrm>
            <a:off x="2608730" y="375957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16" name="図プレースホルダー 6">
            <a:extLst>
              <a:ext uri="{FF2B5EF4-FFF2-40B4-BE49-F238E27FC236}">
                <a16:creationId xmlns:a16="http://schemas.microsoft.com/office/drawing/2014/main" id="{CF8806A9-E7AD-413A-849C-B6B187CFE685}"/>
              </a:ext>
            </a:extLst>
          </p:cNvPr>
          <p:cNvSpPr>
            <a:spLocks noGrp="1" noChangeAspect="1"/>
          </p:cNvSpPr>
          <p:nvPr>
            <p:ph type="pic" sz="quarter" idx="19"/>
          </p:nvPr>
        </p:nvSpPr>
        <p:spPr>
          <a:xfrm>
            <a:off x="4610996" y="375957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17" name="図プレースホルダー 6">
            <a:extLst>
              <a:ext uri="{FF2B5EF4-FFF2-40B4-BE49-F238E27FC236}">
                <a16:creationId xmlns:a16="http://schemas.microsoft.com/office/drawing/2014/main" id="{F5BC03F8-E654-4D9C-80B9-0FB8F32FE6C3}"/>
              </a:ext>
            </a:extLst>
          </p:cNvPr>
          <p:cNvSpPr>
            <a:spLocks noGrp="1" noChangeAspect="1"/>
          </p:cNvSpPr>
          <p:nvPr>
            <p:ph type="pic" sz="quarter" idx="20"/>
          </p:nvPr>
        </p:nvSpPr>
        <p:spPr>
          <a:xfrm>
            <a:off x="591111" y="2312333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18" name="図プレースホルダー 6">
            <a:extLst>
              <a:ext uri="{FF2B5EF4-FFF2-40B4-BE49-F238E27FC236}">
                <a16:creationId xmlns:a16="http://schemas.microsoft.com/office/drawing/2014/main" id="{B23883A9-085C-42F3-B089-0EE5364DB10B}"/>
              </a:ext>
            </a:extLst>
          </p:cNvPr>
          <p:cNvSpPr>
            <a:spLocks noGrp="1" noChangeAspect="1"/>
          </p:cNvSpPr>
          <p:nvPr>
            <p:ph type="pic" sz="quarter" idx="21"/>
          </p:nvPr>
        </p:nvSpPr>
        <p:spPr>
          <a:xfrm>
            <a:off x="2608730" y="2312333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19" name="図プレースホルダー 6">
            <a:extLst>
              <a:ext uri="{FF2B5EF4-FFF2-40B4-BE49-F238E27FC236}">
                <a16:creationId xmlns:a16="http://schemas.microsoft.com/office/drawing/2014/main" id="{441D7A52-5638-42EE-A64F-3B242A72E4A3}"/>
              </a:ext>
            </a:extLst>
          </p:cNvPr>
          <p:cNvSpPr>
            <a:spLocks noGrp="1" noChangeAspect="1"/>
          </p:cNvSpPr>
          <p:nvPr>
            <p:ph type="pic" sz="quarter" idx="22"/>
          </p:nvPr>
        </p:nvSpPr>
        <p:spPr>
          <a:xfrm>
            <a:off x="4610996" y="2312333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0" name="図プレースホルダー 6">
            <a:extLst>
              <a:ext uri="{FF2B5EF4-FFF2-40B4-BE49-F238E27FC236}">
                <a16:creationId xmlns:a16="http://schemas.microsoft.com/office/drawing/2014/main" id="{7102A03A-F887-42AE-BE7C-9FEEA8242D04}"/>
              </a:ext>
            </a:extLst>
          </p:cNvPr>
          <p:cNvSpPr>
            <a:spLocks noGrp="1" noChangeAspect="1"/>
          </p:cNvSpPr>
          <p:nvPr>
            <p:ph type="pic" sz="quarter" idx="23"/>
          </p:nvPr>
        </p:nvSpPr>
        <p:spPr>
          <a:xfrm>
            <a:off x="591111" y="4268152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1" name="図プレースホルダー 6">
            <a:extLst>
              <a:ext uri="{FF2B5EF4-FFF2-40B4-BE49-F238E27FC236}">
                <a16:creationId xmlns:a16="http://schemas.microsoft.com/office/drawing/2014/main" id="{BCF4D37B-C6B5-4298-B1A3-23B9B9F25A41}"/>
              </a:ext>
            </a:extLst>
          </p:cNvPr>
          <p:cNvSpPr>
            <a:spLocks noGrp="1" noChangeAspect="1"/>
          </p:cNvSpPr>
          <p:nvPr>
            <p:ph type="pic" sz="quarter" idx="24"/>
          </p:nvPr>
        </p:nvSpPr>
        <p:spPr>
          <a:xfrm>
            <a:off x="2608730" y="4268152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2" name="図プレースホルダー 6">
            <a:extLst>
              <a:ext uri="{FF2B5EF4-FFF2-40B4-BE49-F238E27FC236}">
                <a16:creationId xmlns:a16="http://schemas.microsoft.com/office/drawing/2014/main" id="{133304A9-7D8C-4EF0-A550-8C326EB226AD}"/>
              </a:ext>
            </a:extLst>
          </p:cNvPr>
          <p:cNvSpPr>
            <a:spLocks noGrp="1" noChangeAspect="1"/>
          </p:cNvSpPr>
          <p:nvPr>
            <p:ph type="pic" sz="quarter" idx="25"/>
          </p:nvPr>
        </p:nvSpPr>
        <p:spPr>
          <a:xfrm>
            <a:off x="4610996" y="4268152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3" name="図プレースホルダー 6">
            <a:extLst>
              <a:ext uri="{FF2B5EF4-FFF2-40B4-BE49-F238E27FC236}">
                <a16:creationId xmlns:a16="http://schemas.microsoft.com/office/drawing/2014/main" id="{4B4F2AD5-E201-4FEF-B666-48B4D9C68447}"/>
              </a:ext>
            </a:extLst>
          </p:cNvPr>
          <p:cNvSpPr>
            <a:spLocks noGrp="1" noChangeAspect="1"/>
          </p:cNvSpPr>
          <p:nvPr>
            <p:ph type="pic" sz="quarter" idx="26"/>
          </p:nvPr>
        </p:nvSpPr>
        <p:spPr>
          <a:xfrm>
            <a:off x="591111" y="6223971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4" name="図プレースホルダー 6">
            <a:extLst>
              <a:ext uri="{FF2B5EF4-FFF2-40B4-BE49-F238E27FC236}">
                <a16:creationId xmlns:a16="http://schemas.microsoft.com/office/drawing/2014/main" id="{67BA69E2-7391-4A81-B29F-EDB1E83C6CEA}"/>
              </a:ext>
            </a:extLst>
          </p:cNvPr>
          <p:cNvSpPr>
            <a:spLocks noGrp="1" noChangeAspect="1"/>
          </p:cNvSpPr>
          <p:nvPr>
            <p:ph type="pic" sz="quarter" idx="27"/>
          </p:nvPr>
        </p:nvSpPr>
        <p:spPr>
          <a:xfrm>
            <a:off x="2608730" y="6223971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25" name="図プレースホルダー 6">
            <a:extLst>
              <a:ext uri="{FF2B5EF4-FFF2-40B4-BE49-F238E27FC236}">
                <a16:creationId xmlns:a16="http://schemas.microsoft.com/office/drawing/2014/main" id="{3B8FB442-9DCD-4BEA-BEBB-68D45B9C9430}"/>
              </a:ext>
            </a:extLst>
          </p:cNvPr>
          <p:cNvSpPr>
            <a:spLocks noGrp="1" noChangeAspect="1"/>
          </p:cNvSpPr>
          <p:nvPr>
            <p:ph type="pic" sz="quarter" idx="28"/>
          </p:nvPr>
        </p:nvSpPr>
        <p:spPr>
          <a:xfrm>
            <a:off x="4610996" y="6223971"/>
            <a:ext cx="1800000" cy="1800000"/>
          </a:xfrm>
          <a:prstGeom prst="ellipse">
            <a:avLst/>
          </a:prstGeom>
        </p:spPr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720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085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2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982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968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168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668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18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282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921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29744-CFF3-416F-ABD8-B2972962BC6A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754AD-EB48-4C1C-B976-DE5271D0AE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93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2" r:id="rId10"/>
    <p:sldLayoutId id="2147483670" r:id="rId11"/>
    <p:sldLayoutId id="2147483671" r:id="rId12"/>
    <p:sldLayoutId id="2147483673" r:id="rId13"/>
  </p:sldLayoutIdLst>
  <p:txStyles>
    <p:titleStyle>
      <a:lvl1pPr algn="l" defTabSz="633039" rtl="0" eaLnBrk="1" latinLnBrk="0" hangingPunct="1">
        <a:lnSpc>
          <a:spcPct val="90000"/>
        </a:lnSpc>
        <a:spcBef>
          <a:spcPct val="0"/>
        </a:spcBef>
        <a:buNone/>
        <a:defRPr kumimoji="1"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0" indent="-158260" algn="l" defTabSz="633039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kumimoji="1" sz="1938" kern="1200">
          <a:solidFill>
            <a:schemeClr val="tx1"/>
          </a:solidFill>
          <a:latin typeface="+mn-lt"/>
          <a:ea typeface="+mn-ea"/>
          <a:cs typeface="+mn-cs"/>
        </a:defRPr>
      </a:lvl1pPr>
      <a:lvl2pPr marL="47477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図 39">
            <a:extLst>
              <a:ext uri="{FF2B5EF4-FFF2-40B4-BE49-F238E27FC236}">
                <a16:creationId xmlns:a16="http://schemas.microsoft.com/office/drawing/2014/main" id="{887A1CEB-9B22-4823-B97C-0D5331A644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910" t="14107" r="23339" b="17143"/>
          <a:stretch/>
        </p:blipFill>
        <p:spPr>
          <a:xfrm>
            <a:off x="378413" y="3657464"/>
            <a:ext cx="1980000" cy="19800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11D7345D-B3EE-4F0E-BC09-28AAE6BF566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35" t="15906" r="21515" b="15748"/>
          <a:stretch/>
        </p:blipFill>
        <p:spPr>
          <a:xfrm>
            <a:off x="378412" y="1574651"/>
            <a:ext cx="1980002" cy="1968376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D176F6CB-1883-47EF-98B0-6F0E5A2CA13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479" t="11807" r="21771" b="19443"/>
          <a:stretch/>
        </p:blipFill>
        <p:spPr>
          <a:xfrm>
            <a:off x="389738" y="5783418"/>
            <a:ext cx="1980001" cy="19800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297A913-E62E-43C0-8D64-4B70A3E6924A}"/>
              </a:ext>
            </a:extLst>
          </p:cNvPr>
          <p:cNvSpPr txBox="1"/>
          <p:nvPr/>
        </p:nvSpPr>
        <p:spPr>
          <a:xfrm rot="16200000">
            <a:off x="-2639264" y="4246814"/>
            <a:ext cx="57136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Meniscus                  Cartilage             Bone and</a:t>
            </a:r>
            <a:r>
              <a:rPr kumimoji="1" lang="ja-JP" altLang="en-US" dirty="0"/>
              <a:t>　</a:t>
            </a:r>
            <a:r>
              <a:rPr kumimoji="1" lang="en-US" altLang="ja-JP" dirty="0"/>
              <a:t>ROI </a:t>
            </a:r>
            <a:endParaRPr lang="ja-JP" altLang="en-US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307397" y="1543596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A-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307397" y="3654401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B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-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307397" y="5776750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noProof="0" dirty="0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C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-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9F2A7D9-44F0-4344-9F0D-0E27B835CA92}"/>
              </a:ext>
            </a:extLst>
          </p:cNvPr>
          <p:cNvSpPr txBox="1"/>
          <p:nvPr/>
        </p:nvSpPr>
        <p:spPr>
          <a:xfrm>
            <a:off x="83662" y="34925"/>
            <a:ext cx="2954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  <a:cs typeface="+mn-cs"/>
              </a:rPr>
              <a:t>Supplementary Fig. 1 		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9084E857-32F7-4F32-80D8-862954DA97D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0647" t="25160" r="19745" b="15232"/>
          <a:stretch/>
        </p:blipFill>
        <p:spPr>
          <a:xfrm rot="10800000">
            <a:off x="4535904" y="3657464"/>
            <a:ext cx="1980000" cy="198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0173C6B-6863-4823-ABAF-96959759DFB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964" t="24512" r="19964" b="15416"/>
          <a:stretch/>
        </p:blipFill>
        <p:spPr>
          <a:xfrm rot="10800000">
            <a:off x="2471650" y="3657464"/>
            <a:ext cx="1980000" cy="198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F722D10-2823-4781-AB76-A4B6546D708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000000"/>
              </a:clrFrom>
              <a:clrTo>
                <a:srgbClr val="000000">
                  <a:alpha val="0"/>
                </a:srgbClr>
              </a:clrTo>
            </a:clrChang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19731" t="23856" r="19731" b="15606"/>
          <a:stretch/>
        </p:blipFill>
        <p:spPr>
          <a:xfrm rot="10800000">
            <a:off x="4535904" y="1687905"/>
            <a:ext cx="1980000" cy="198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DFB4850-8D8F-4DA7-842F-FC6C699237C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9801" t="24756" r="20701" b="15746"/>
          <a:stretch/>
        </p:blipFill>
        <p:spPr>
          <a:xfrm rot="10800000">
            <a:off x="4539396" y="5783418"/>
            <a:ext cx="1980000" cy="198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E862418-1259-44DD-BD48-5A617E1CCFB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8793" t="23913" r="19723" b="14603"/>
          <a:stretch/>
        </p:blipFill>
        <p:spPr>
          <a:xfrm rot="10800000">
            <a:off x="2471650" y="5783418"/>
            <a:ext cx="1980000" cy="19800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48151340-5558-46E1-9AB3-52B9F5CCE76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000000"/>
              </a:clrFrom>
              <a:clrTo>
                <a:srgbClr val="000000">
                  <a:alpha val="0"/>
                </a:srgbClr>
              </a:clrTo>
            </a:clrChang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19731" t="23856" r="19731" b="15606"/>
          <a:stretch/>
        </p:blipFill>
        <p:spPr>
          <a:xfrm rot="10800000">
            <a:off x="2481923" y="1687905"/>
            <a:ext cx="1980000" cy="1980000"/>
          </a:xfrm>
          <a:prstGeom prst="rect">
            <a:avLst/>
          </a:prstGeom>
        </p:spPr>
      </p:pic>
      <p:sp>
        <p:nvSpPr>
          <p:cNvPr id="49" name="フリーフォーム: 図形 48">
            <a:extLst>
              <a:ext uri="{FF2B5EF4-FFF2-40B4-BE49-F238E27FC236}">
                <a16:creationId xmlns:a16="http://schemas.microsoft.com/office/drawing/2014/main" id="{B8C37A97-79E2-4FCF-A91F-9803BE541F1B}"/>
              </a:ext>
            </a:extLst>
          </p:cNvPr>
          <p:cNvSpPr/>
          <p:nvPr/>
        </p:nvSpPr>
        <p:spPr>
          <a:xfrm rot="155099">
            <a:off x="5738066" y="2209396"/>
            <a:ext cx="551975" cy="957025"/>
          </a:xfrm>
          <a:custGeom>
            <a:avLst/>
            <a:gdLst>
              <a:gd name="connsiteX0" fmla="*/ 94735 w 580767"/>
              <a:gd name="connsiteY0" fmla="*/ 12357 h 1000897"/>
              <a:gd name="connsiteX1" fmla="*/ 218303 w 580767"/>
              <a:gd name="connsiteY1" fmla="*/ 0 h 1000897"/>
              <a:gd name="connsiteX2" fmla="*/ 354227 w 580767"/>
              <a:gd name="connsiteY2" fmla="*/ 8238 h 1000897"/>
              <a:gd name="connsiteX3" fmla="*/ 543697 w 580767"/>
              <a:gd name="connsiteY3" fmla="*/ 205946 h 1000897"/>
              <a:gd name="connsiteX4" fmla="*/ 580767 w 580767"/>
              <a:gd name="connsiteY4" fmla="*/ 543697 h 1000897"/>
              <a:gd name="connsiteX5" fmla="*/ 481913 w 580767"/>
              <a:gd name="connsiteY5" fmla="*/ 807308 h 1000897"/>
              <a:gd name="connsiteX6" fmla="*/ 275967 w 580767"/>
              <a:gd name="connsiteY6" fmla="*/ 1000897 h 1000897"/>
              <a:gd name="connsiteX7" fmla="*/ 86497 w 580767"/>
              <a:gd name="connsiteY7" fmla="*/ 992660 h 1000897"/>
              <a:gd name="connsiteX8" fmla="*/ 28832 w 580767"/>
              <a:gd name="connsiteY8" fmla="*/ 951470 h 1000897"/>
              <a:gd name="connsiteX9" fmla="*/ 0 w 580767"/>
              <a:gd name="connsiteY9" fmla="*/ 659027 h 1000897"/>
              <a:gd name="connsiteX10" fmla="*/ 74140 w 580767"/>
              <a:gd name="connsiteY10" fmla="*/ 399535 h 1000897"/>
              <a:gd name="connsiteX11" fmla="*/ 57665 w 580767"/>
              <a:gd name="connsiteY11" fmla="*/ 156519 h 1000897"/>
              <a:gd name="connsiteX12" fmla="*/ 94735 w 580767"/>
              <a:gd name="connsiteY12" fmla="*/ 12357 h 1000897"/>
              <a:gd name="connsiteX0" fmla="*/ 94735 w 580767"/>
              <a:gd name="connsiteY0" fmla="*/ 12357 h 1000897"/>
              <a:gd name="connsiteX1" fmla="*/ 218303 w 580767"/>
              <a:gd name="connsiteY1" fmla="*/ 0 h 1000897"/>
              <a:gd name="connsiteX2" fmla="*/ 354227 w 580767"/>
              <a:gd name="connsiteY2" fmla="*/ 8238 h 1000897"/>
              <a:gd name="connsiteX3" fmla="*/ 543697 w 580767"/>
              <a:gd name="connsiteY3" fmla="*/ 205946 h 1000897"/>
              <a:gd name="connsiteX4" fmla="*/ 580767 w 580767"/>
              <a:gd name="connsiteY4" fmla="*/ 543697 h 1000897"/>
              <a:gd name="connsiteX5" fmla="*/ 481913 w 580767"/>
              <a:gd name="connsiteY5" fmla="*/ 807308 h 1000897"/>
              <a:gd name="connsiteX6" fmla="*/ 275967 w 580767"/>
              <a:gd name="connsiteY6" fmla="*/ 1000897 h 1000897"/>
              <a:gd name="connsiteX7" fmla="*/ 86497 w 580767"/>
              <a:gd name="connsiteY7" fmla="*/ 992660 h 1000897"/>
              <a:gd name="connsiteX8" fmla="*/ 28832 w 580767"/>
              <a:gd name="connsiteY8" fmla="*/ 951470 h 1000897"/>
              <a:gd name="connsiteX9" fmla="*/ 0 w 580767"/>
              <a:gd name="connsiteY9" fmla="*/ 659027 h 1000897"/>
              <a:gd name="connsiteX10" fmla="*/ 74140 w 580767"/>
              <a:gd name="connsiteY10" fmla="*/ 399535 h 1000897"/>
              <a:gd name="connsiteX11" fmla="*/ 57665 w 580767"/>
              <a:gd name="connsiteY11" fmla="*/ 156519 h 1000897"/>
              <a:gd name="connsiteX12" fmla="*/ 94735 w 580767"/>
              <a:gd name="connsiteY12" fmla="*/ 12357 h 1000897"/>
              <a:gd name="connsiteX0" fmla="*/ 94735 w 580767"/>
              <a:gd name="connsiteY0" fmla="*/ 4119 h 992659"/>
              <a:gd name="connsiteX1" fmla="*/ 354227 w 580767"/>
              <a:gd name="connsiteY1" fmla="*/ 0 h 992659"/>
              <a:gd name="connsiteX2" fmla="*/ 543697 w 580767"/>
              <a:gd name="connsiteY2" fmla="*/ 197708 h 992659"/>
              <a:gd name="connsiteX3" fmla="*/ 580767 w 580767"/>
              <a:gd name="connsiteY3" fmla="*/ 535459 h 992659"/>
              <a:gd name="connsiteX4" fmla="*/ 481913 w 580767"/>
              <a:gd name="connsiteY4" fmla="*/ 799070 h 992659"/>
              <a:gd name="connsiteX5" fmla="*/ 275967 w 580767"/>
              <a:gd name="connsiteY5" fmla="*/ 992659 h 992659"/>
              <a:gd name="connsiteX6" fmla="*/ 86497 w 580767"/>
              <a:gd name="connsiteY6" fmla="*/ 984422 h 992659"/>
              <a:gd name="connsiteX7" fmla="*/ 28832 w 580767"/>
              <a:gd name="connsiteY7" fmla="*/ 943232 h 992659"/>
              <a:gd name="connsiteX8" fmla="*/ 0 w 580767"/>
              <a:gd name="connsiteY8" fmla="*/ 650789 h 992659"/>
              <a:gd name="connsiteX9" fmla="*/ 74140 w 580767"/>
              <a:gd name="connsiteY9" fmla="*/ 391297 h 992659"/>
              <a:gd name="connsiteX10" fmla="*/ 57665 w 580767"/>
              <a:gd name="connsiteY10" fmla="*/ 148281 h 992659"/>
              <a:gd name="connsiteX11" fmla="*/ 94735 w 580767"/>
              <a:gd name="connsiteY11" fmla="*/ 4119 h 992659"/>
              <a:gd name="connsiteX0" fmla="*/ 94735 w 580767"/>
              <a:gd name="connsiteY0" fmla="*/ 0 h 988540"/>
              <a:gd name="connsiteX1" fmla="*/ 543697 w 580767"/>
              <a:gd name="connsiteY1" fmla="*/ 193589 h 988540"/>
              <a:gd name="connsiteX2" fmla="*/ 580767 w 580767"/>
              <a:gd name="connsiteY2" fmla="*/ 531340 h 988540"/>
              <a:gd name="connsiteX3" fmla="*/ 481913 w 580767"/>
              <a:gd name="connsiteY3" fmla="*/ 794951 h 988540"/>
              <a:gd name="connsiteX4" fmla="*/ 275967 w 580767"/>
              <a:gd name="connsiteY4" fmla="*/ 988540 h 988540"/>
              <a:gd name="connsiteX5" fmla="*/ 86497 w 580767"/>
              <a:gd name="connsiteY5" fmla="*/ 980303 h 988540"/>
              <a:gd name="connsiteX6" fmla="*/ 28832 w 580767"/>
              <a:gd name="connsiteY6" fmla="*/ 939113 h 988540"/>
              <a:gd name="connsiteX7" fmla="*/ 0 w 580767"/>
              <a:gd name="connsiteY7" fmla="*/ 646670 h 988540"/>
              <a:gd name="connsiteX8" fmla="*/ 74140 w 580767"/>
              <a:gd name="connsiteY8" fmla="*/ 387178 h 988540"/>
              <a:gd name="connsiteX9" fmla="*/ 57665 w 580767"/>
              <a:gd name="connsiteY9" fmla="*/ 144162 h 988540"/>
              <a:gd name="connsiteX10" fmla="*/ 94735 w 580767"/>
              <a:gd name="connsiteY10" fmla="*/ 0 h 988540"/>
              <a:gd name="connsiteX0" fmla="*/ 94735 w 580767"/>
              <a:gd name="connsiteY0" fmla="*/ 0 h 988540"/>
              <a:gd name="connsiteX1" fmla="*/ 543697 w 580767"/>
              <a:gd name="connsiteY1" fmla="*/ 193589 h 988540"/>
              <a:gd name="connsiteX2" fmla="*/ 580767 w 580767"/>
              <a:gd name="connsiteY2" fmla="*/ 531340 h 988540"/>
              <a:gd name="connsiteX3" fmla="*/ 481913 w 580767"/>
              <a:gd name="connsiteY3" fmla="*/ 794951 h 988540"/>
              <a:gd name="connsiteX4" fmla="*/ 275967 w 580767"/>
              <a:gd name="connsiteY4" fmla="*/ 988540 h 988540"/>
              <a:gd name="connsiteX5" fmla="*/ 86497 w 580767"/>
              <a:gd name="connsiteY5" fmla="*/ 980303 h 988540"/>
              <a:gd name="connsiteX6" fmla="*/ 28832 w 580767"/>
              <a:gd name="connsiteY6" fmla="*/ 939113 h 988540"/>
              <a:gd name="connsiteX7" fmla="*/ 0 w 580767"/>
              <a:gd name="connsiteY7" fmla="*/ 646670 h 988540"/>
              <a:gd name="connsiteX8" fmla="*/ 74140 w 580767"/>
              <a:gd name="connsiteY8" fmla="*/ 387178 h 988540"/>
              <a:gd name="connsiteX9" fmla="*/ 94735 w 580767"/>
              <a:gd name="connsiteY9" fmla="*/ 0 h 988540"/>
              <a:gd name="connsiteX0" fmla="*/ 94735 w 580767"/>
              <a:gd name="connsiteY0" fmla="*/ 13845 h 1002385"/>
              <a:gd name="connsiteX1" fmla="*/ 543697 w 580767"/>
              <a:gd name="connsiteY1" fmla="*/ 207434 h 1002385"/>
              <a:gd name="connsiteX2" fmla="*/ 580767 w 580767"/>
              <a:gd name="connsiteY2" fmla="*/ 545185 h 1002385"/>
              <a:gd name="connsiteX3" fmla="*/ 481913 w 580767"/>
              <a:gd name="connsiteY3" fmla="*/ 808796 h 1002385"/>
              <a:gd name="connsiteX4" fmla="*/ 275967 w 580767"/>
              <a:gd name="connsiteY4" fmla="*/ 1002385 h 1002385"/>
              <a:gd name="connsiteX5" fmla="*/ 86497 w 580767"/>
              <a:gd name="connsiteY5" fmla="*/ 994148 h 1002385"/>
              <a:gd name="connsiteX6" fmla="*/ 28832 w 580767"/>
              <a:gd name="connsiteY6" fmla="*/ 952958 h 1002385"/>
              <a:gd name="connsiteX7" fmla="*/ 0 w 580767"/>
              <a:gd name="connsiteY7" fmla="*/ 660515 h 1002385"/>
              <a:gd name="connsiteX8" fmla="*/ 74140 w 580767"/>
              <a:gd name="connsiteY8" fmla="*/ 401023 h 1002385"/>
              <a:gd name="connsiteX9" fmla="*/ 94735 w 580767"/>
              <a:gd name="connsiteY9" fmla="*/ 13845 h 1002385"/>
              <a:gd name="connsiteX0" fmla="*/ 94735 w 580767"/>
              <a:gd name="connsiteY0" fmla="*/ 9562 h 998102"/>
              <a:gd name="connsiteX1" fmla="*/ 576648 w 580767"/>
              <a:gd name="connsiteY1" fmla="*/ 314362 h 998102"/>
              <a:gd name="connsiteX2" fmla="*/ 580767 w 580767"/>
              <a:gd name="connsiteY2" fmla="*/ 540902 h 998102"/>
              <a:gd name="connsiteX3" fmla="*/ 481913 w 580767"/>
              <a:gd name="connsiteY3" fmla="*/ 804513 h 998102"/>
              <a:gd name="connsiteX4" fmla="*/ 275967 w 580767"/>
              <a:gd name="connsiteY4" fmla="*/ 998102 h 998102"/>
              <a:gd name="connsiteX5" fmla="*/ 86497 w 580767"/>
              <a:gd name="connsiteY5" fmla="*/ 989865 h 998102"/>
              <a:gd name="connsiteX6" fmla="*/ 28832 w 580767"/>
              <a:gd name="connsiteY6" fmla="*/ 948675 h 998102"/>
              <a:gd name="connsiteX7" fmla="*/ 0 w 580767"/>
              <a:gd name="connsiteY7" fmla="*/ 656232 h 998102"/>
              <a:gd name="connsiteX8" fmla="*/ 74140 w 580767"/>
              <a:gd name="connsiteY8" fmla="*/ 396740 h 998102"/>
              <a:gd name="connsiteX9" fmla="*/ 94735 w 580767"/>
              <a:gd name="connsiteY9" fmla="*/ 9562 h 998102"/>
              <a:gd name="connsiteX0" fmla="*/ 94735 w 580767"/>
              <a:gd name="connsiteY0" fmla="*/ 18277 h 1006817"/>
              <a:gd name="connsiteX1" fmla="*/ 576648 w 580767"/>
              <a:gd name="connsiteY1" fmla="*/ 323077 h 1006817"/>
              <a:gd name="connsiteX2" fmla="*/ 580767 w 580767"/>
              <a:gd name="connsiteY2" fmla="*/ 549617 h 1006817"/>
              <a:gd name="connsiteX3" fmla="*/ 481913 w 580767"/>
              <a:gd name="connsiteY3" fmla="*/ 813228 h 1006817"/>
              <a:gd name="connsiteX4" fmla="*/ 275967 w 580767"/>
              <a:gd name="connsiteY4" fmla="*/ 1006817 h 1006817"/>
              <a:gd name="connsiteX5" fmla="*/ 86497 w 580767"/>
              <a:gd name="connsiteY5" fmla="*/ 998580 h 1006817"/>
              <a:gd name="connsiteX6" fmla="*/ 28832 w 580767"/>
              <a:gd name="connsiteY6" fmla="*/ 957390 h 1006817"/>
              <a:gd name="connsiteX7" fmla="*/ 0 w 580767"/>
              <a:gd name="connsiteY7" fmla="*/ 664947 h 1006817"/>
              <a:gd name="connsiteX8" fmla="*/ 74140 w 580767"/>
              <a:gd name="connsiteY8" fmla="*/ 405455 h 1006817"/>
              <a:gd name="connsiteX9" fmla="*/ 94735 w 580767"/>
              <a:gd name="connsiteY9" fmla="*/ 18277 h 1006817"/>
              <a:gd name="connsiteX0" fmla="*/ 94735 w 576648"/>
              <a:gd name="connsiteY0" fmla="*/ 18277 h 1006817"/>
              <a:gd name="connsiteX1" fmla="*/ 576648 w 576648"/>
              <a:gd name="connsiteY1" fmla="*/ 323077 h 1006817"/>
              <a:gd name="connsiteX2" fmla="*/ 481913 w 576648"/>
              <a:gd name="connsiteY2" fmla="*/ 813228 h 1006817"/>
              <a:gd name="connsiteX3" fmla="*/ 275967 w 576648"/>
              <a:gd name="connsiteY3" fmla="*/ 1006817 h 1006817"/>
              <a:gd name="connsiteX4" fmla="*/ 86497 w 576648"/>
              <a:gd name="connsiteY4" fmla="*/ 998580 h 1006817"/>
              <a:gd name="connsiteX5" fmla="*/ 28832 w 576648"/>
              <a:gd name="connsiteY5" fmla="*/ 957390 h 1006817"/>
              <a:gd name="connsiteX6" fmla="*/ 0 w 576648"/>
              <a:gd name="connsiteY6" fmla="*/ 664947 h 1006817"/>
              <a:gd name="connsiteX7" fmla="*/ 74140 w 576648"/>
              <a:gd name="connsiteY7" fmla="*/ 405455 h 1006817"/>
              <a:gd name="connsiteX8" fmla="*/ 94735 w 576648"/>
              <a:gd name="connsiteY8" fmla="*/ 18277 h 1006817"/>
              <a:gd name="connsiteX0" fmla="*/ 94735 w 576648"/>
              <a:gd name="connsiteY0" fmla="*/ 18277 h 1006817"/>
              <a:gd name="connsiteX1" fmla="*/ 576648 w 576648"/>
              <a:gd name="connsiteY1" fmla="*/ 323077 h 1006817"/>
              <a:gd name="connsiteX2" fmla="*/ 275967 w 576648"/>
              <a:gd name="connsiteY2" fmla="*/ 1006817 h 1006817"/>
              <a:gd name="connsiteX3" fmla="*/ 86497 w 576648"/>
              <a:gd name="connsiteY3" fmla="*/ 998580 h 1006817"/>
              <a:gd name="connsiteX4" fmla="*/ 28832 w 576648"/>
              <a:gd name="connsiteY4" fmla="*/ 957390 h 1006817"/>
              <a:gd name="connsiteX5" fmla="*/ 0 w 576648"/>
              <a:gd name="connsiteY5" fmla="*/ 664947 h 1006817"/>
              <a:gd name="connsiteX6" fmla="*/ 74140 w 576648"/>
              <a:gd name="connsiteY6" fmla="*/ 405455 h 1006817"/>
              <a:gd name="connsiteX7" fmla="*/ 94735 w 576648"/>
              <a:gd name="connsiteY7" fmla="*/ 18277 h 1006817"/>
              <a:gd name="connsiteX0" fmla="*/ 94735 w 576648"/>
              <a:gd name="connsiteY0" fmla="*/ 18277 h 998580"/>
              <a:gd name="connsiteX1" fmla="*/ 576648 w 576648"/>
              <a:gd name="connsiteY1" fmla="*/ 323077 h 998580"/>
              <a:gd name="connsiteX2" fmla="*/ 86497 w 576648"/>
              <a:gd name="connsiteY2" fmla="*/ 998580 h 998580"/>
              <a:gd name="connsiteX3" fmla="*/ 28832 w 576648"/>
              <a:gd name="connsiteY3" fmla="*/ 957390 h 998580"/>
              <a:gd name="connsiteX4" fmla="*/ 0 w 576648"/>
              <a:gd name="connsiteY4" fmla="*/ 664947 h 998580"/>
              <a:gd name="connsiteX5" fmla="*/ 74140 w 576648"/>
              <a:gd name="connsiteY5" fmla="*/ 405455 h 998580"/>
              <a:gd name="connsiteX6" fmla="*/ 94735 w 576648"/>
              <a:gd name="connsiteY6" fmla="*/ 18277 h 998580"/>
              <a:gd name="connsiteX0" fmla="*/ 94735 w 581310"/>
              <a:gd name="connsiteY0" fmla="*/ 18277 h 998580"/>
              <a:gd name="connsiteX1" fmla="*/ 576648 w 581310"/>
              <a:gd name="connsiteY1" fmla="*/ 323077 h 998580"/>
              <a:gd name="connsiteX2" fmla="*/ 86497 w 581310"/>
              <a:gd name="connsiteY2" fmla="*/ 998580 h 998580"/>
              <a:gd name="connsiteX3" fmla="*/ 28832 w 581310"/>
              <a:gd name="connsiteY3" fmla="*/ 957390 h 998580"/>
              <a:gd name="connsiteX4" fmla="*/ 0 w 581310"/>
              <a:gd name="connsiteY4" fmla="*/ 664947 h 998580"/>
              <a:gd name="connsiteX5" fmla="*/ 74140 w 581310"/>
              <a:gd name="connsiteY5" fmla="*/ 405455 h 998580"/>
              <a:gd name="connsiteX6" fmla="*/ 94735 w 581310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0 w 583521"/>
              <a:gd name="connsiteY3" fmla="*/ 664947 h 998580"/>
              <a:gd name="connsiteX4" fmla="*/ 74140 w 583521"/>
              <a:gd name="connsiteY4" fmla="*/ 405455 h 998580"/>
              <a:gd name="connsiteX5" fmla="*/ 94735 w 583521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647"/>
              <a:gd name="connsiteY0" fmla="*/ 18277 h 994868"/>
              <a:gd name="connsiteX1" fmla="*/ 568410 w 575647"/>
              <a:gd name="connsiteY1" fmla="*/ 323077 h 994868"/>
              <a:gd name="connsiteX2" fmla="*/ 93024 w 575647"/>
              <a:gd name="connsiteY2" fmla="*/ 994868 h 994868"/>
              <a:gd name="connsiteX3" fmla="*/ 0 w 575647"/>
              <a:gd name="connsiteY3" fmla="*/ 718493 h 994868"/>
              <a:gd name="connsiteX4" fmla="*/ 49427 w 575647"/>
              <a:gd name="connsiteY4" fmla="*/ 207747 h 994868"/>
              <a:gd name="connsiteX5" fmla="*/ 86497 w 575647"/>
              <a:gd name="connsiteY5" fmla="*/ 18277 h 994868"/>
              <a:gd name="connsiteX0" fmla="*/ 86497 w 575820"/>
              <a:gd name="connsiteY0" fmla="*/ 18277 h 995490"/>
              <a:gd name="connsiteX1" fmla="*/ 568410 w 575820"/>
              <a:gd name="connsiteY1" fmla="*/ 323077 h 995490"/>
              <a:gd name="connsiteX2" fmla="*/ 93024 w 575820"/>
              <a:gd name="connsiteY2" fmla="*/ 994868 h 995490"/>
              <a:gd name="connsiteX3" fmla="*/ 0 w 575820"/>
              <a:gd name="connsiteY3" fmla="*/ 718493 h 995490"/>
              <a:gd name="connsiteX4" fmla="*/ 49427 w 575820"/>
              <a:gd name="connsiteY4" fmla="*/ 207747 h 995490"/>
              <a:gd name="connsiteX5" fmla="*/ 86497 w 575820"/>
              <a:gd name="connsiteY5" fmla="*/ 18277 h 995490"/>
              <a:gd name="connsiteX0" fmla="*/ 71329 w 560652"/>
              <a:gd name="connsiteY0" fmla="*/ 18277 h 995490"/>
              <a:gd name="connsiteX1" fmla="*/ 553242 w 560652"/>
              <a:gd name="connsiteY1" fmla="*/ 323077 h 995490"/>
              <a:gd name="connsiteX2" fmla="*/ 77856 w 560652"/>
              <a:gd name="connsiteY2" fmla="*/ 994868 h 995490"/>
              <a:gd name="connsiteX3" fmla="*/ 0 w 560652"/>
              <a:gd name="connsiteY3" fmla="*/ 723866 h 995490"/>
              <a:gd name="connsiteX4" fmla="*/ 34259 w 560652"/>
              <a:gd name="connsiteY4" fmla="*/ 207747 h 995490"/>
              <a:gd name="connsiteX5" fmla="*/ 71329 w 560652"/>
              <a:gd name="connsiteY5" fmla="*/ 18277 h 995490"/>
              <a:gd name="connsiteX0" fmla="*/ 71329 w 560652"/>
              <a:gd name="connsiteY0" fmla="*/ 18277 h 995490"/>
              <a:gd name="connsiteX1" fmla="*/ 553242 w 560652"/>
              <a:gd name="connsiteY1" fmla="*/ 323077 h 995490"/>
              <a:gd name="connsiteX2" fmla="*/ 77856 w 560652"/>
              <a:gd name="connsiteY2" fmla="*/ 994868 h 995490"/>
              <a:gd name="connsiteX3" fmla="*/ 0 w 560652"/>
              <a:gd name="connsiteY3" fmla="*/ 723866 h 995490"/>
              <a:gd name="connsiteX4" fmla="*/ 34259 w 560652"/>
              <a:gd name="connsiteY4" fmla="*/ 207747 h 995490"/>
              <a:gd name="connsiteX5" fmla="*/ 71329 w 560652"/>
              <a:gd name="connsiteY5" fmla="*/ 18277 h 995490"/>
              <a:gd name="connsiteX0" fmla="*/ 70827 w 560150"/>
              <a:gd name="connsiteY0" fmla="*/ 18277 h 1039277"/>
              <a:gd name="connsiteX1" fmla="*/ 552740 w 560150"/>
              <a:gd name="connsiteY1" fmla="*/ 323077 h 1039277"/>
              <a:gd name="connsiteX2" fmla="*/ 77354 w 560150"/>
              <a:gd name="connsiteY2" fmla="*/ 994868 h 1039277"/>
              <a:gd name="connsiteX3" fmla="*/ 0 w 560150"/>
              <a:gd name="connsiteY3" fmla="*/ 870627 h 1039277"/>
              <a:gd name="connsiteX4" fmla="*/ 33757 w 560150"/>
              <a:gd name="connsiteY4" fmla="*/ 207747 h 1039277"/>
              <a:gd name="connsiteX5" fmla="*/ 70827 w 560150"/>
              <a:gd name="connsiteY5" fmla="*/ 18277 h 1039277"/>
              <a:gd name="connsiteX0" fmla="*/ 70827 w 560150"/>
              <a:gd name="connsiteY0" fmla="*/ 18277 h 1039277"/>
              <a:gd name="connsiteX1" fmla="*/ 552740 w 560150"/>
              <a:gd name="connsiteY1" fmla="*/ 323077 h 1039277"/>
              <a:gd name="connsiteX2" fmla="*/ 77354 w 560150"/>
              <a:gd name="connsiteY2" fmla="*/ 994868 h 1039277"/>
              <a:gd name="connsiteX3" fmla="*/ 0 w 560150"/>
              <a:gd name="connsiteY3" fmla="*/ 870627 h 1039277"/>
              <a:gd name="connsiteX4" fmla="*/ 33757 w 560150"/>
              <a:gd name="connsiteY4" fmla="*/ 207747 h 1039277"/>
              <a:gd name="connsiteX5" fmla="*/ 70827 w 560150"/>
              <a:gd name="connsiteY5" fmla="*/ 18277 h 1039277"/>
              <a:gd name="connsiteX0" fmla="*/ 70827 w 560150"/>
              <a:gd name="connsiteY0" fmla="*/ 18277 h 1039277"/>
              <a:gd name="connsiteX1" fmla="*/ 552740 w 560150"/>
              <a:gd name="connsiteY1" fmla="*/ 323077 h 1039277"/>
              <a:gd name="connsiteX2" fmla="*/ 77354 w 560150"/>
              <a:gd name="connsiteY2" fmla="*/ 994868 h 1039277"/>
              <a:gd name="connsiteX3" fmla="*/ 0 w 560150"/>
              <a:gd name="connsiteY3" fmla="*/ 870627 h 1039277"/>
              <a:gd name="connsiteX4" fmla="*/ 33757 w 560150"/>
              <a:gd name="connsiteY4" fmla="*/ 207747 h 1039277"/>
              <a:gd name="connsiteX5" fmla="*/ 70827 w 560150"/>
              <a:gd name="connsiteY5" fmla="*/ 18277 h 1039277"/>
              <a:gd name="connsiteX0" fmla="*/ 70867 w 560190"/>
              <a:gd name="connsiteY0" fmla="*/ 18277 h 995490"/>
              <a:gd name="connsiteX1" fmla="*/ 552780 w 560190"/>
              <a:gd name="connsiteY1" fmla="*/ 323077 h 995490"/>
              <a:gd name="connsiteX2" fmla="*/ 77394 w 560190"/>
              <a:gd name="connsiteY2" fmla="*/ 994868 h 995490"/>
              <a:gd name="connsiteX3" fmla="*/ 40 w 560190"/>
              <a:gd name="connsiteY3" fmla="*/ 870627 h 995490"/>
              <a:gd name="connsiteX4" fmla="*/ 33797 w 560190"/>
              <a:gd name="connsiteY4" fmla="*/ 207747 h 995490"/>
              <a:gd name="connsiteX5" fmla="*/ 70867 w 560190"/>
              <a:gd name="connsiteY5" fmla="*/ 18277 h 995490"/>
              <a:gd name="connsiteX0" fmla="*/ 70867 w 558324"/>
              <a:gd name="connsiteY0" fmla="*/ 18277 h 995313"/>
              <a:gd name="connsiteX1" fmla="*/ 552780 w 558324"/>
              <a:gd name="connsiteY1" fmla="*/ 323077 h 995313"/>
              <a:gd name="connsiteX2" fmla="*/ 77394 w 558324"/>
              <a:gd name="connsiteY2" fmla="*/ 994868 h 995313"/>
              <a:gd name="connsiteX3" fmla="*/ 40 w 558324"/>
              <a:gd name="connsiteY3" fmla="*/ 870627 h 995313"/>
              <a:gd name="connsiteX4" fmla="*/ 33797 w 558324"/>
              <a:gd name="connsiteY4" fmla="*/ 207747 h 995313"/>
              <a:gd name="connsiteX5" fmla="*/ 70867 w 558324"/>
              <a:gd name="connsiteY5" fmla="*/ 18277 h 995313"/>
              <a:gd name="connsiteX0" fmla="*/ 70867 w 553614"/>
              <a:gd name="connsiteY0" fmla="*/ 16094 h 993230"/>
              <a:gd name="connsiteX1" fmla="*/ 547994 w 553614"/>
              <a:gd name="connsiteY1" fmla="*/ 348635 h 993230"/>
              <a:gd name="connsiteX2" fmla="*/ 77394 w 553614"/>
              <a:gd name="connsiteY2" fmla="*/ 992685 h 993230"/>
              <a:gd name="connsiteX3" fmla="*/ 40 w 553614"/>
              <a:gd name="connsiteY3" fmla="*/ 868444 h 993230"/>
              <a:gd name="connsiteX4" fmla="*/ 33797 w 553614"/>
              <a:gd name="connsiteY4" fmla="*/ 205564 h 993230"/>
              <a:gd name="connsiteX5" fmla="*/ 70867 w 553614"/>
              <a:gd name="connsiteY5" fmla="*/ 16094 h 993230"/>
              <a:gd name="connsiteX0" fmla="*/ 70867 w 553614"/>
              <a:gd name="connsiteY0" fmla="*/ 18610 h 995746"/>
              <a:gd name="connsiteX1" fmla="*/ 547994 w 553614"/>
              <a:gd name="connsiteY1" fmla="*/ 351151 h 995746"/>
              <a:gd name="connsiteX2" fmla="*/ 77394 w 553614"/>
              <a:gd name="connsiteY2" fmla="*/ 995201 h 995746"/>
              <a:gd name="connsiteX3" fmla="*/ 40 w 553614"/>
              <a:gd name="connsiteY3" fmla="*/ 870960 h 995746"/>
              <a:gd name="connsiteX4" fmla="*/ 33797 w 553614"/>
              <a:gd name="connsiteY4" fmla="*/ 208080 h 995746"/>
              <a:gd name="connsiteX5" fmla="*/ 70867 w 553614"/>
              <a:gd name="connsiteY5" fmla="*/ 18610 h 995746"/>
              <a:gd name="connsiteX0" fmla="*/ 70867 w 553614"/>
              <a:gd name="connsiteY0" fmla="*/ 18610 h 995746"/>
              <a:gd name="connsiteX1" fmla="*/ 547994 w 553614"/>
              <a:gd name="connsiteY1" fmla="*/ 351151 h 995746"/>
              <a:gd name="connsiteX2" fmla="*/ 77394 w 553614"/>
              <a:gd name="connsiteY2" fmla="*/ 995201 h 995746"/>
              <a:gd name="connsiteX3" fmla="*/ 40 w 553614"/>
              <a:gd name="connsiteY3" fmla="*/ 870960 h 995746"/>
              <a:gd name="connsiteX4" fmla="*/ 33797 w 553614"/>
              <a:gd name="connsiteY4" fmla="*/ 208080 h 995746"/>
              <a:gd name="connsiteX5" fmla="*/ 70867 w 553614"/>
              <a:gd name="connsiteY5" fmla="*/ 18610 h 995746"/>
              <a:gd name="connsiteX0" fmla="*/ 76738 w 553614"/>
              <a:gd name="connsiteY0" fmla="*/ 18315 h 998778"/>
              <a:gd name="connsiteX1" fmla="*/ 547994 w 553614"/>
              <a:gd name="connsiteY1" fmla="*/ 354183 h 998778"/>
              <a:gd name="connsiteX2" fmla="*/ 77394 w 553614"/>
              <a:gd name="connsiteY2" fmla="*/ 998233 h 998778"/>
              <a:gd name="connsiteX3" fmla="*/ 40 w 553614"/>
              <a:gd name="connsiteY3" fmla="*/ 873992 h 998778"/>
              <a:gd name="connsiteX4" fmla="*/ 33797 w 553614"/>
              <a:gd name="connsiteY4" fmla="*/ 211112 h 998778"/>
              <a:gd name="connsiteX5" fmla="*/ 76738 w 553614"/>
              <a:gd name="connsiteY5" fmla="*/ 18315 h 998778"/>
              <a:gd name="connsiteX0" fmla="*/ 76738 w 553614"/>
              <a:gd name="connsiteY0" fmla="*/ 26572 h 1007035"/>
              <a:gd name="connsiteX1" fmla="*/ 547994 w 553614"/>
              <a:gd name="connsiteY1" fmla="*/ 362440 h 1007035"/>
              <a:gd name="connsiteX2" fmla="*/ 77394 w 553614"/>
              <a:gd name="connsiteY2" fmla="*/ 1006490 h 1007035"/>
              <a:gd name="connsiteX3" fmla="*/ 40 w 553614"/>
              <a:gd name="connsiteY3" fmla="*/ 882249 h 1007035"/>
              <a:gd name="connsiteX4" fmla="*/ 33797 w 553614"/>
              <a:gd name="connsiteY4" fmla="*/ 219369 h 1007035"/>
              <a:gd name="connsiteX5" fmla="*/ 76738 w 553614"/>
              <a:gd name="connsiteY5" fmla="*/ 26572 h 1007035"/>
              <a:gd name="connsiteX0" fmla="*/ 76738 w 553614"/>
              <a:gd name="connsiteY0" fmla="*/ 30978 h 1011441"/>
              <a:gd name="connsiteX1" fmla="*/ 547994 w 553614"/>
              <a:gd name="connsiteY1" fmla="*/ 366846 h 1011441"/>
              <a:gd name="connsiteX2" fmla="*/ 77394 w 553614"/>
              <a:gd name="connsiteY2" fmla="*/ 1010896 h 1011441"/>
              <a:gd name="connsiteX3" fmla="*/ 40 w 553614"/>
              <a:gd name="connsiteY3" fmla="*/ 886655 h 1011441"/>
              <a:gd name="connsiteX4" fmla="*/ 33797 w 553614"/>
              <a:gd name="connsiteY4" fmla="*/ 223775 h 1011441"/>
              <a:gd name="connsiteX5" fmla="*/ 76738 w 553614"/>
              <a:gd name="connsiteY5" fmla="*/ 30978 h 1011441"/>
              <a:gd name="connsiteX0" fmla="*/ 76739 w 553599"/>
              <a:gd name="connsiteY0" fmla="*/ 30978 h 989238"/>
              <a:gd name="connsiteX1" fmla="*/ 547995 w 553599"/>
              <a:gd name="connsiteY1" fmla="*/ 366846 h 989238"/>
              <a:gd name="connsiteX2" fmla="*/ 76402 w 553599"/>
              <a:gd name="connsiteY2" fmla="*/ 988574 h 989238"/>
              <a:gd name="connsiteX3" fmla="*/ 41 w 553599"/>
              <a:gd name="connsiteY3" fmla="*/ 886655 h 989238"/>
              <a:gd name="connsiteX4" fmla="*/ 33798 w 553599"/>
              <a:gd name="connsiteY4" fmla="*/ 223775 h 989238"/>
              <a:gd name="connsiteX5" fmla="*/ 76739 w 553599"/>
              <a:gd name="connsiteY5" fmla="*/ 30978 h 989238"/>
              <a:gd name="connsiteX0" fmla="*/ 90111 w 566971"/>
              <a:gd name="connsiteY0" fmla="*/ 30978 h 989238"/>
              <a:gd name="connsiteX1" fmla="*/ 561367 w 566971"/>
              <a:gd name="connsiteY1" fmla="*/ 366846 h 989238"/>
              <a:gd name="connsiteX2" fmla="*/ 89774 w 566971"/>
              <a:gd name="connsiteY2" fmla="*/ 988574 h 989238"/>
              <a:gd name="connsiteX3" fmla="*/ 33 w 566971"/>
              <a:gd name="connsiteY3" fmla="*/ 797796 h 989238"/>
              <a:gd name="connsiteX4" fmla="*/ 47170 w 566971"/>
              <a:gd name="connsiteY4" fmla="*/ 223775 h 989238"/>
              <a:gd name="connsiteX5" fmla="*/ 90111 w 566971"/>
              <a:gd name="connsiteY5" fmla="*/ 30978 h 989238"/>
              <a:gd name="connsiteX0" fmla="*/ 90111 w 566997"/>
              <a:gd name="connsiteY0" fmla="*/ 30978 h 998081"/>
              <a:gd name="connsiteX1" fmla="*/ 561367 w 566997"/>
              <a:gd name="connsiteY1" fmla="*/ 366846 h 998081"/>
              <a:gd name="connsiteX2" fmla="*/ 89774 w 566997"/>
              <a:gd name="connsiteY2" fmla="*/ 988574 h 998081"/>
              <a:gd name="connsiteX3" fmla="*/ 33 w 566997"/>
              <a:gd name="connsiteY3" fmla="*/ 797796 h 998081"/>
              <a:gd name="connsiteX4" fmla="*/ 47170 w 566997"/>
              <a:gd name="connsiteY4" fmla="*/ 223775 h 998081"/>
              <a:gd name="connsiteX5" fmla="*/ 90111 w 566997"/>
              <a:gd name="connsiteY5" fmla="*/ 30978 h 998081"/>
              <a:gd name="connsiteX0" fmla="*/ 90111 w 561367"/>
              <a:gd name="connsiteY0" fmla="*/ 30978 h 999388"/>
              <a:gd name="connsiteX1" fmla="*/ 561367 w 561367"/>
              <a:gd name="connsiteY1" fmla="*/ 366846 h 999388"/>
              <a:gd name="connsiteX2" fmla="*/ 89774 w 561367"/>
              <a:gd name="connsiteY2" fmla="*/ 988574 h 999388"/>
              <a:gd name="connsiteX3" fmla="*/ 33 w 561367"/>
              <a:gd name="connsiteY3" fmla="*/ 797796 h 999388"/>
              <a:gd name="connsiteX4" fmla="*/ 47170 w 561367"/>
              <a:gd name="connsiteY4" fmla="*/ 223775 h 999388"/>
              <a:gd name="connsiteX5" fmla="*/ 90111 w 561367"/>
              <a:gd name="connsiteY5" fmla="*/ 30978 h 999388"/>
              <a:gd name="connsiteX0" fmla="*/ 90111 w 561367"/>
              <a:gd name="connsiteY0" fmla="*/ 30978 h 999388"/>
              <a:gd name="connsiteX1" fmla="*/ 561367 w 561367"/>
              <a:gd name="connsiteY1" fmla="*/ 366846 h 999388"/>
              <a:gd name="connsiteX2" fmla="*/ 89774 w 561367"/>
              <a:gd name="connsiteY2" fmla="*/ 988574 h 999388"/>
              <a:gd name="connsiteX3" fmla="*/ 33 w 561367"/>
              <a:gd name="connsiteY3" fmla="*/ 797796 h 999388"/>
              <a:gd name="connsiteX4" fmla="*/ 63384 w 561367"/>
              <a:gd name="connsiteY4" fmla="*/ 376414 h 999388"/>
              <a:gd name="connsiteX5" fmla="*/ 90111 w 561367"/>
              <a:gd name="connsiteY5" fmla="*/ 30978 h 999388"/>
              <a:gd name="connsiteX0" fmla="*/ 90111 w 561367"/>
              <a:gd name="connsiteY0" fmla="*/ 30978 h 999388"/>
              <a:gd name="connsiteX1" fmla="*/ 561367 w 561367"/>
              <a:gd name="connsiteY1" fmla="*/ 366846 h 999388"/>
              <a:gd name="connsiteX2" fmla="*/ 89774 w 561367"/>
              <a:gd name="connsiteY2" fmla="*/ 988574 h 999388"/>
              <a:gd name="connsiteX3" fmla="*/ 33 w 561367"/>
              <a:gd name="connsiteY3" fmla="*/ 797796 h 999388"/>
              <a:gd name="connsiteX4" fmla="*/ 63384 w 561367"/>
              <a:gd name="connsiteY4" fmla="*/ 376414 h 999388"/>
              <a:gd name="connsiteX5" fmla="*/ 90111 w 561367"/>
              <a:gd name="connsiteY5" fmla="*/ 30978 h 999388"/>
              <a:gd name="connsiteX0" fmla="*/ 90111 w 561367"/>
              <a:gd name="connsiteY0" fmla="*/ 30978 h 999388"/>
              <a:gd name="connsiteX1" fmla="*/ 561367 w 561367"/>
              <a:gd name="connsiteY1" fmla="*/ 366846 h 999388"/>
              <a:gd name="connsiteX2" fmla="*/ 89774 w 561367"/>
              <a:gd name="connsiteY2" fmla="*/ 988574 h 999388"/>
              <a:gd name="connsiteX3" fmla="*/ 33 w 561367"/>
              <a:gd name="connsiteY3" fmla="*/ 797796 h 999388"/>
              <a:gd name="connsiteX4" fmla="*/ 63384 w 561367"/>
              <a:gd name="connsiteY4" fmla="*/ 376414 h 999388"/>
              <a:gd name="connsiteX5" fmla="*/ 90111 w 561367"/>
              <a:gd name="connsiteY5" fmla="*/ 30978 h 999388"/>
              <a:gd name="connsiteX0" fmla="*/ 90111 w 561367"/>
              <a:gd name="connsiteY0" fmla="*/ 30978 h 999388"/>
              <a:gd name="connsiteX1" fmla="*/ 561367 w 561367"/>
              <a:gd name="connsiteY1" fmla="*/ 366846 h 999388"/>
              <a:gd name="connsiteX2" fmla="*/ 89774 w 561367"/>
              <a:gd name="connsiteY2" fmla="*/ 988574 h 999388"/>
              <a:gd name="connsiteX3" fmla="*/ 33 w 561367"/>
              <a:gd name="connsiteY3" fmla="*/ 797796 h 999388"/>
              <a:gd name="connsiteX4" fmla="*/ 63384 w 561367"/>
              <a:gd name="connsiteY4" fmla="*/ 376414 h 999388"/>
              <a:gd name="connsiteX5" fmla="*/ 90111 w 561367"/>
              <a:gd name="connsiteY5" fmla="*/ 30978 h 999388"/>
              <a:gd name="connsiteX0" fmla="*/ 118352 w 561367"/>
              <a:gd name="connsiteY0" fmla="*/ 30805 h 1000511"/>
              <a:gd name="connsiteX1" fmla="*/ 561367 w 561367"/>
              <a:gd name="connsiteY1" fmla="*/ 367969 h 1000511"/>
              <a:gd name="connsiteX2" fmla="*/ 89774 w 561367"/>
              <a:gd name="connsiteY2" fmla="*/ 989697 h 1000511"/>
              <a:gd name="connsiteX3" fmla="*/ 33 w 561367"/>
              <a:gd name="connsiteY3" fmla="*/ 798919 h 1000511"/>
              <a:gd name="connsiteX4" fmla="*/ 63384 w 561367"/>
              <a:gd name="connsiteY4" fmla="*/ 377537 h 1000511"/>
              <a:gd name="connsiteX5" fmla="*/ 118352 w 561367"/>
              <a:gd name="connsiteY5" fmla="*/ 30805 h 1000511"/>
              <a:gd name="connsiteX0" fmla="*/ 118352 w 561367"/>
              <a:gd name="connsiteY0" fmla="*/ 30805 h 1000511"/>
              <a:gd name="connsiteX1" fmla="*/ 561367 w 561367"/>
              <a:gd name="connsiteY1" fmla="*/ 367969 h 1000511"/>
              <a:gd name="connsiteX2" fmla="*/ 89774 w 561367"/>
              <a:gd name="connsiteY2" fmla="*/ 989697 h 1000511"/>
              <a:gd name="connsiteX3" fmla="*/ 33 w 561367"/>
              <a:gd name="connsiteY3" fmla="*/ 798919 h 1000511"/>
              <a:gd name="connsiteX4" fmla="*/ 63384 w 561367"/>
              <a:gd name="connsiteY4" fmla="*/ 377537 h 1000511"/>
              <a:gd name="connsiteX5" fmla="*/ 118352 w 561367"/>
              <a:gd name="connsiteY5" fmla="*/ 30805 h 1000511"/>
              <a:gd name="connsiteX0" fmla="*/ 118352 w 561367"/>
              <a:gd name="connsiteY0" fmla="*/ 30922 h 1000628"/>
              <a:gd name="connsiteX1" fmla="*/ 561367 w 561367"/>
              <a:gd name="connsiteY1" fmla="*/ 368086 h 1000628"/>
              <a:gd name="connsiteX2" fmla="*/ 89774 w 561367"/>
              <a:gd name="connsiteY2" fmla="*/ 989814 h 1000628"/>
              <a:gd name="connsiteX3" fmla="*/ 33 w 561367"/>
              <a:gd name="connsiteY3" fmla="*/ 799036 h 1000628"/>
              <a:gd name="connsiteX4" fmla="*/ 63384 w 561367"/>
              <a:gd name="connsiteY4" fmla="*/ 377654 h 1000628"/>
              <a:gd name="connsiteX5" fmla="*/ 118352 w 561367"/>
              <a:gd name="connsiteY5" fmla="*/ 30922 h 1000628"/>
              <a:gd name="connsiteX0" fmla="*/ 118352 w 561367"/>
              <a:gd name="connsiteY0" fmla="*/ 23317 h 993023"/>
              <a:gd name="connsiteX1" fmla="*/ 561367 w 561367"/>
              <a:gd name="connsiteY1" fmla="*/ 360481 h 993023"/>
              <a:gd name="connsiteX2" fmla="*/ 89774 w 561367"/>
              <a:gd name="connsiteY2" fmla="*/ 982209 h 993023"/>
              <a:gd name="connsiteX3" fmla="*/ 33 w 561367"/>
              <a:gd name="connsiteY3" fmla="*/ 791431 h 993023"/>
              <a:gd name="connsiteX4" fmla="*/ 63384 w 561367"/>
              <a:gd name="connsiteY4" fmla="*/ 370049 h 993023"/>
              <a:gd name="connsiteX5" fmla="*/ 118352 w 561367"/>
              <a:gd name="connsiteY5" fmla="*/ 23317 h 993023"/>
              <a:gd name="connsiteX0" fmla="*/ 118352 w 561367"/>
              <a:gd name="connsiteY0" fmla="*/ 30643 h 1000349"/>
              <a:gd name="connsiteX1" fmla="*/ 561367 w 561367"/>
              <a:gd name="connsiteY1" fmla="*/ 367807 h 1000349"/>
              <a:gd name="connsiteX2" fmla="*/ 89774 w 561367"/>
              <a:gd name="connsiteY2" fmla="*/ 989535 h 1000349"/>
              <a:gd name="connsiteX3" fmla="*/ 33 w 561367"/>
              <a:gd name="connsiteY3" fmla="*/ 798757 h 1000349"/>
              <a:gd name="connsiteX4" fmla="*/ 63384 w 561367"/>
              <a:gd name="connsiteY4" fmla="*/ 377375 h 1000349"/>
              <a:gd name="connsiteX5" fmla="*/ 118352 w 561367"/>
              <a:gd name="connsiteY5" fmla="*/ 30643 h 1000349"/>
              <a:gd name="connsiteX0" fmla="*/ 121773 w 561367"/>
              <a:gd name="connsiteY0" fmla="*/ 31259 h 994731"/>
              <a:gd name="connsiteX1" fmla="*/ 561367 w 561367"/>
              <a:gd name="connsiteY1" fmla="*/ 362189 h 994731"/>
              <a:gd name="connsiteX2" fmla="*/ 89774 w 561367"/>
              <a:gd name="connsiteY2" fmla="*/ 983917 h 994731"/>
              <a:gd name="connsiteX3" fmla="*/ 33 w 561367"/>
              <a:gd name="connsiteY3" fmla="*/ 793139 h 994731"/>
              <a:gd name="connsiteX4" fmla="*/ 63384 w 561367"/>
              <a:gd name="connsiteY4" fmla="*/ 371757 h 994731"/>
              <a:gd name="connsiteX5" fmla="*/ 121773 w 561367"/>
              <a:gd name="connsiteY5" fmla="*/ 31259 h 994731"/>
              <a:gd name="connsiteX0" fmla="*/ 121773 w 561367"/>
              <a:gd name="connsiteY0" fmla="*/ 36160 h 999632"/>
              <a:gd name="connsiteX1" fmla="*/ 561367 w 561367"/>
              <a:gd name="connsiteY1" fmla="*/ 367090 h 999632"/>
              <a:gd name="connsiteX2" fmla="*/ 89774 w 561367"/>
              <a:gd name="connsiteY2" fmla="*/ 988818 h 999632"/>
              <a:gd name="connsiteX3" fmla="*/ 33 w 561367"/>
              <a:gd name="connsiteY3" fmla="*/ 798040 h 999632"/>
              <a:gd name="connsiteX4" fmla="*/ 63384 w 561367"/>
              <a:gd name="connsiteY4" fmla="*/ 376658 h 999632"/>
              <a:gd name="connsiteX5" fmla="*/ 121773 w 561367"/>
              <a:gd name="connsiteY5" fmla="*/ 36160 h 999632"/>
              <a:gd name="connsiteX0" fmla="*/ 121773 w 561367"/>
              <a:gd name="connsiteY0" fmla="*/ 31541 h 995013"/>
              <a:gd name="connsiteX1" fmla="*/ 561367 w 561367"/>
              <a:gd name="connsiteY1" fmla="*/ 362471 h 995013"/>
              <a:gd name="connsiteX2" fmla="*/ 89774 w 561367"/>
              <a:gd name="connsiteY2" fmla="*/ 984199 h 995013"/>
              <a:gd name="connsiteX3" fmla="*/ 33 w 561367"/>
              <a:gd name="connsiteY3" fmla="*/ 793421 h 995013"/>
              <a:gd name="connsiteX4" fmla="*/ 63384 w 561367"/>
              <a:gd name="connsiteY4" fmla="*/ 372039 h 995013"/>
              <a:gd name="connsiteX5" fmla="*/ 121773 w 561367"/>
              <a:gd name="connsiteY5" fmla="*/ 31541 h 995013"/>
              <a:gd name="connsiteX0" fmla="*/ 121773 w 561367"/>
              <a:gd name="connsiteY0" fmla="*/ 35490 h 998962"/>
              <a:gd name="connsiteX1" fmla="*/ 561367 w 561367"/>
              <a:gd name="connsiteY1" fmla="*/ 366420 h 998962"/>
              <a:gd name="connsiteX2" fmla="*/ 89774 w 561367"/>
              <a:gd name="connsiteY2" fmla="*/ 988148 h 998962"/>
              <a:gd name="connsiteX3" fmla="*/ 33 w 561367"/>
              <a:gd name="connsiteY3" fmla="*/ 797370 h 998962"/>
              <a:gd name="connsiteX4" fmla="*/ 63384 w 561367"/>
              <a:gd name="connsiteY4" fmla="*/ 375988 h 998962"/>
              <a:gd name="connsiteX5" fmla="*/ 121773 w 561367"/>
              <a:gd name="connsiteY5" fmla="*/ 35490 h 998962"/>
              <a:gd name="connsiteX0" fmla="*/ 89279 w 561367"/>
              <a:gd name="connsiteY0" fmla="*/ 36172 h 993396"/>
              <a:gd name="connsiteX1" fmla="*/ 561367 w 561367"/>
              <a:gd name="connsiteY1" fmla="*/ 360854 h 993396"/>
              <a:gd name="connsiteX2" fmla="*/ 89774 w 561367"/>
              <a:gd name="connsiteY2" fmla="*/ 982582 h 993396"/>
              <a:gd name="connsiteX3" fmla="*/ 33 w 561367"/>
              <a:gd name="connsiteY3" fmla="*/ 791804 h 993396"/>
              <a:gd name="connsiteX4" fmla="*/ 63384 w 561367"/>
              <a:gd name="connsiteY4" fmla="*/ 370422 h 993396"/>
              <a:gd name="connsiteX5" fmla="*/ 89279 w 561367"/>
              <a:gd name="connsiteY5" fmla="*/ 36172 h 993396"/>
              <a:gd name="connsiteX0" fmla="*/ 89279 w 561367"/>
              <a:gd name="connsiteY0" fmla="*/ 36172 h 993396"/>
              <a:gd name="connsiteX1" fmla="*/ 561367 w 561367"/>
              <a:gd name="connsiteY1" fmla="*/ 360854 h 993396"/>
              <a:gd name="connsiteX2" fmla="*/ 89774 w 561367"/>
              <a:gd name="connsiteY2" fmla="*/ 982582 h 993396"/>
              <a:gd name="connsiteX3" fmla="*/ 33 w 561367"/>
              <a:gd name="connsiteY3" fmla="*/ 791804 h 993396"/>
              <a:gd name="connsiteX4" fmla="*/ 53107 w 561367"/>
              <a:gd name="connsiteY4" fmla="*/ 297148 h 993396"/>
              <a:gd name="connsiteX5" fmla="*/ 89279 w 561367"/>
              <a:gd name="connsiteY5" fmla="*/ 36172 h 993396"/>
              <a:gd name="connsiteX0" fmla="*/ 89279 w 561367"/>
              <a:gd name="connsiteY0" fmla="*/ 36172 h 993396"/>
              <a:gd name="connsiteX1" fmla="*/ 561367 w 561367"/>
              <a:gd name="connsiteY1" fmla="*/ 360854 h 993396"/>
              <a:gd name="connsiteX2" fmla="*/ 89774 w 561367"/>
              <a:gd name="connsiteY2" fmla="*/ 982582 h 993396"/>
              <a:gd name="connsiteX3" fmla="*/ 33 w 561367"/>
              <a:gd name="connsiteY3" fmla="*/ 791804 h 993396"/>
              <a:gd name="connsiteX4" fmla="*/ 53107 w 561367"/>
              <a:gd name="connsiteY4" fmla="*/ 297148 h 993396"/>
              <a:gd name="connsiteX5" fmla="*/ 89279 w 561367"/>
              <a:gd name="connsiteY5" fmla="*/ 36172 h 993396"/>
              <a:gd name="connsiteX0" fmla="*/ 89279 w 561367"/>
              <a:gd name="connsiteY0" fmla="*/ 36172 h 993396"/>
              <a:gd name="connsiteX1" fmla="*/ 561367 w 561367"/>
              <a:gd name="connsiteY1" fmla="*/ 360854 h 993396"/>
              <a:gd name="connsiteX2" fmla="*/ 89774 w 561367"/>
              <a:gd name="connsiteY2" fmla="*/ 982582 h 993396"/>
              <a:gd name="connsiteX3" fmla="*/ 33 w 561367"/>
              <a:gd name="connsiteY3" fmla="*/ 791804 h 993396"/>
              <a:gd name="connsiteX4" fmla="*/ 53107 w 561367"/>
              <a:gd name="connsiteY4" fmla="*/ 297148 h 993396"/>
              <a:gd name="connsiteX5" fmla="*/ 89279 w 561367"/>
              <a:gd name="connsiteY5" fmla="*/ 36172 h 993396"/>
              <a:gd name="connsiteX0" fmla="*/ 60380 w 532468"/>
              <a:gd name="connsiteY0" fmla="*/ 36172 h 993396"/>
              <a:gd name="connsiteX1" fmla="*/ 532468 w 532468"/>
              <a:gd name="connsiteY1" fmla="*/ 360854 h 993396"/>
              <a:gd name="connsiteX2" fmla="*/ 60875 w 532468"/>
              <a:gd name="connsiteY2" fmla="*/ 982582 h 993396"/>
              <a:gd name="connsiteX3" fmla="*/ 57 w 532468"/>
              <a:gd name="connsiteY3" fmla="*/ 652503 h 993396"/>
              <a:gd name="connsiteX4" fmla="*/ 24208 w 532468"/>
              <a:gd name="connsiteY4" fmla="*/ 297148 h 993396"/>
              <a:gd name="connsiteX5" fmla="*/ 60380 w 532468"/>
              <a:gd name="connsiteY5" fmla="*/ 36172 h 993396"/>
              <a:gd name="connsiteX0" fmla="*/ 60385 w 532473"/>
              <a:gd name="connsiteY0" fmla="*/ 36172 h 917235"/>
              <a:gd name="connsiteX1" fmla="*/ 532473 w 532473"/>
              <a:gd name="connsiteY1" fmla="*/ 360854 h 917235"/>
              <a:gd name="connsiteX2" fmla="*/ 57189 w 532473"/>
              <a:gd name="connsiteY2" fmla="*/ 899491 h 917235"/>
              <a:gd name="connsiteX3" fmla="*/ 62 w 532473"/>
              <a:gd name="connsiteY3" fmla="*/ 652503 h 917235"/>
              <a:gd name="connsiteX4" fmla="*/ 24213 w 532473"/>
              <a:gd name="connsiteY4" fmla="*/ 297148 h 917235"/>
              <a:gd name="connsiteX5" fmla="*/ 60385 w 532473"/>
              <a:gd name="connsiteY5" fmla="*/ 36172 h 917235"/>
              <a:gd name="connsiteX0" fmla="*/ 60385 w 532473"/>
              <a:gd name="connsiteY0" fmla="*/ 36172 h 916325"/>
              <a:gd name="connsiteX1" fmla="*/ 532473 w 532473"/>
              <a:gd name="connsiteY1" fmla="*/ 360854 h 916325"/>
              <a:gd name="connsiteX2" fmla="*/ 57189 w 532473"/>
              <a:gd name="connsiteY2" fmla="*/ 899491 h 916325"/>
              <a:gd name="connsiteX3" fmla="*/ 62 w 532473"/>
              <a:gd name="connsiteY3" fmla="*/ 652503 h 916325"/>
              <a:gd name="connsiteX4" fmla="*/ 24213 w 532473"/>
              <a:gd name="connsiteY4" fmla="*/ 297148 h 916325"/>
              <a:gd name="connsiteX5" fmla="*/ 60385 w 532473"/>
              <a:gd name="connsiteY5" fmla="*/ 36172 h 916325"/>
              <a:gd name="connsiteX0" fmla="*/ 60385 w 532473"/>
              <a:gd name="connsiteY0" fmla="*/ 36172 h 916325"/>
              <a:gd name="connsiteX1" fmla="*/ 532473 w 532473"/>
              <a:gd name="connsiteY1" fmla="*/ 360854 h 916325"/>
              <a:gd name="connsiteX2" fmla="*/ 57189 w 532473"/>
              <a:gd name="connsiteY2" fmla="*/ 899491 h 916325"/>
              <a:gd name="connsiteX3" fmla="*/ 62 w 532473"/>
              <a:gd name="connsiteY3" fmla="*/ 652503 h 916325"/>
              <a:gd name="connsiteX4" fmla="*/ 24213 w 532473"/>
              <a:gd name="connsiteY4" fmla="*/ 297148 h 916325"/>
              <a:gd name="connsiteX5" fmla="*/ 60385 w 532473"/>
              <a:gd name="connsiteY5" fmla="*/ 36172 h 916325"/>
              <a:gd name="connsiteX0" fmla="*/ 60385 w 515171"/>
              <a:gd name="connsiteY0" fmla="*/ 38591 h 916567"/>
              <a:gd name="connsiteX1" fmla="*/ 515171 w 515171"/>
              <a:gd name="connsiteY1" fmla="*/ 342658 h 916567"/>
              <a:gd name="connsiteX2" fmla="*/ 57189 w 515171"/>
              <a:gd name="connsiteY2" fmla="*/ 901910 h 916567"/>
              <a:gd name="connsiteX3" fmla="*/ 62 w 515171"/>
              <a:gd name="connsiteY3" fmla="*/ 654922 h 916567"/>
              <a:gd name="connsiteX4" fmla="*/ 24213 w 515171"/>
              <a:gd name="connsiteY4" fmla="*/ 299567 h 916567"/>
              <a:gd name="connsiteX5" fmla="*/ 60385 w 515171"/>
              <a:gd name="connsiteY5" fmla="*/ 38591 h 916567"/>
              <a:gd name="connsiteX0" fmla="*/ 60385 w 550134"/>
              <a:gd name="connsiteY0" fmla="*/ 38591 h 901910"/>
              <a:gd name="connsiteX1" fmla="*/ 515171 w 550134"/>
              <a:gd name="connsiteY1" fmla="*/ 342658 h 901910"/>
              <a:gd name="connsiteX2" fmla="*/ 472071 w 550134"/>
              <a:gd name="connsiteY2" fmla="*/ 680099 h 901910"/>
              <a:gd name="connsiteX3" fmla="*/ 57189 w 550134"/>
              <a:gd name="connsiteY3" fmla="*/ 901910 h 901910"/>
              <a:gd name="connsiteX4" fmla="*/ 62 w 550134"/>
              <a:gd name="connsiteY4" fmla="*/ 654922 h 901910"/>
              <a:gd name="connsiteX5" fmla="*/ 24213 w 550134"/>
              <a:gd name="connsiteY5" fmla="*/ 299567 h 901910"/>
              <a:gd name="connsiteX6" fmla="*/ 60385 w 550134"/>
              <a:gd name="connsiteY6" fmla="*/ 38591 h 901910"/>
              <a:gd name="connsiteX0" fmla="*/ 60385 w 550134"/>
              <a:gd name="connsiteY0" fmla="*/ 38591 h 902839"/>
              <a:gd name="connsiteX1" fmla="*/ 515171 w 550134"/>
              <a:gd name="connsiteY1" fmla="*/ 342658 h 902839"/>
              <a:gd name="connsiteX2" fmla="*/ 472071 w 550134"/>
              <a:gd name="connsiteY2" fmla="*/ 680099 h 902839"/>
              <a:gd name="connsiteX3" fmla="*/ 57189 w 550134"/>
              <a:gd name="connsiteY3" fmla="*/ 901910 h 902839"/>
              <a:gd name="connsiteX4" fmla="*/ 62 w 550134"/>
              <a:gd name="connsiteY4" fmla="*/ 654922 h 902839"/>
              <a:gd name="connsiteX5" fmla="*/ 24213 w 550134"/>
              <a:gd name="connsiteY5" fmla="*/ 299567 h 902839"/>
              <a:gd name="connsiteX6" fmla="*/ 60385 w 550134"/>
              <a:gd name="connsiteY6" fmla="*/ 38591 h 902839"/>
              <a:gd name="connsiteX0" fmla="*/ 60385 w 550134"/>
              <a:gd name="connsiteY0" fmla="*/ 38591 h 916301"/>
              <a:gd name="connsiteX1" fmla="*/ 515171 w 550134"/>
              <a:gd name="connsiteY1" fmla="*/ 342658 h 916301"/>
              <a:gd name="connsiteX2" fmla="*/ 472071 w 550134"/>
              <a:gd name="connsiteY2" fmla="*/ 680099 h 916301"/>
              <a:gd name="connsiteX3" fmla="*/ 57189 w 550134"/>
              <a:gd name="connsiteY3" fmla="*/ 901910 h 916301"/>
              <a:gd name="connsiteX4" fmla="*/ 62 w 550134"/>
              <a:gd name="connsiteY4" fmla="*/ 654922 h 916301"/>
              <a:gd name="connsiteX5" fmla="*/ 24213 w 550134"/>
              <a:gd name="connsiteY5" fmla="*/ 299567 h 916301"/>
              <a:gd name="connsiteX6" fmla="*/ 60385 w 550134"/>
              <a:gd name="connsiteY6" fmla="*/ 38591 h 916301"/>
              <a:gd name="connsiteX0" fmla="*/ 60385 w 515171"/>
              <a:gd name="connsiteY0" fmla="*/ 38591 h 916301"/>
              <a:gd name="connsiteX1" fmla="*/ 515171 w 515171"/>
              <a:gd name="connsiteY1" fmla="*/ 342658 h 916301"/>
              <a:gd name="connsiteX2" fmla="*/ 472071 w 515171"/>
              <a:gd name="connsiteY2" fmla="*/ 680099 h 916301"/>
              <a:gd name="connsiteX3" fmla="*/ 57189 w 515171"/>
              <a:gd name="connsiteY3" fmla="*/ 901910 h 916301"/>
              <a:gd name="connsiteX4" fmla="*/ 62 w 515171"/>
              <a:gd name="connsiteY4" fmla="*/ 654922 h 916301"/>
              <a:gd name="connsiteX5" fmla="*/ 24213 w 515171"/>
              <a:gd name="connsiteY5" fmla="*/ 299567 h 916301"/>
              <a:gd name="connsiteX6" fmla="*/ 60385 w 515171"/>
              <a:gd name="connsiteY6" fmla="*/ 38591 h 916301"/>
              <a:gd name="connsiteX0" fmla="*/ 60385 w 515171"/>
              <a:gd name="connsiteY0" fmla="*/ 38591 h 916301"/>
              <a:gd name="connsiteX1" fmla="*/ 515171 w 515171"/>
              <a:gd name="connsiteY1" fmla="*/ 342658 h 916301"/>
              <a:gd name="connsiteX2" fmla="*/ 472071 w 515171"/>
              <a:gd name="connsiteY2" fmla="*/ 680099 h 916301"/>
              <a:gd name="connsiteX3" fmla="*/ 57189 w 515171"/>
              <a:gd name="connsiteY3" fmla="*/ 901910 h 916301"/>
              <a:gd name="connsiteX4" fmla="*/ 62 w 515171"/>
              <a:gd name="connsiteY4" fmla="*/ 654922 h 916301"/>
              <a:gd name="connsiteX5" fmla="*/ 24213 w 515171"/>
              <a:gd name="connsiteY5" fmla="*/ 299567 h 916301"/>
              <a:gd name="connsiteX6" fmla="*/ 60385 w 515171"/>
              <a:gd name="connsiteY6" fmla="*/ 38591 h 916301"/>
              <a:gd name="connsiteX0" fmla="*/ 60385 w 515171"/>
              <a:gd name="connsiteY0" fmla="*/ 38591 h 916301"/>
              <a:gd name="connsiteX1" fmla="*/ 515171 w 515171"/>
              <a:gd name="connsiteY1" fmla="*/ 342658 h 916301"/>
              <a:gd name="connsiteX2" fmla="*/ 472071 w 515171"/>
              <a:gd name="connsiteY2" fmla="*/ 680099 h 916301"/>
              <a:gd name="connsiteX3" fmla="*/ 57189 w 515171"/>
              <a:gd name="connsiteY3" fmla="*/ 901910 h 916301"/>
              <a:gd name="connsiteX4" fmla="*/ 62 w 515171"/>
              <a:gd name="connsiteY4" fmla="*/ 654922 h 916301"/>
              <a:gd name="connsiteX5" fmla="*/ 24213 w 515171"/>
              <a:gd name="connsiteY5" fmla="*/ 299567 h 916301"/>
              <a:gd name="connsiteX6" fmla="*/ 60385 w 515171"/>
              <a:gd name="connsiteY6" fmla="*/ 38591 h 916301"/>
              <a:gd name="connsiteX0" fmla="*/ 60385 w 506038"/>
              <a:gd name="connsiteY0" fmla="*/ 37957 h 915667"/>
              <a:gd name="connsiteX1" fmla="*/ 506038 w 506038"/>
              <a:gd name="connsiteY1" fmla="*/ 347200 h 915667"/>
              <a:gd name="connsiteX2" fmla="*/ 472071 w 506038"/>
              <a:gd name="connsiteY2" fmla="*/ 679465 h 915667"/>
              <a:gd name="connsiteX3" fmla="*/ 57189 w 506038"/>
              <a:gd name="connsiteY3" fmla="*/ 901276 h 915667"/>
              <a:gd name="connsiteX4" fmla="*/ 62 w 506038"/>
              <a:gd name="connsiteY4" fmla="*/ 654288 h 915667"/>
              <a:gd name="connsiteX5" fmla="*/ 24213 w 506038"/>
              <a:gd name="connsiteY5" fmla="*/ 298933 h 915667"/>
              <a:gd name="connsiteX6" fmla="*/ 60385 w 506038"/>
              <a:gd name="connsiteY6" fmla="*/ 37957 h 915667"/>
              <a:gd name="connsiteX0" fmla="*/ 60385 w 506038"/>
              <a:gd name="connsiteY0" fmla="*/ 37957 h 915667"/>
              <a:gd name="connsiteX1" fmla="*/ 506038 w 506038"/>
              <a:gd name="connsiteY1" fmla="*/ 347200 h 915667"/>
              <a:gd name="connsiteX2" fmla="*/ 472071 w 506038"/>
              <a:gd name="connsiteY2" fmla="*/ 679465 h 915667"/>
              <a:gd name="connsiteX3" fmla="*/ 57189 w 506038"/>
              <a:gd name="connsiteY3" fmla="*/ 901276 h 915667"/>
              <a:gd name="connsiteX4" fmla="*/ 62 w 506038"/>
              <a:gd name="connsiteY4" fmla="*/ 654288 h 915667"/>
              <a:gd name="connsiteX5" fmla="*/ 24213 w 506038"/>
              <a:gd name="connsiteY5" fmla="*/ 298933 h 915667"/>
              <a:gd name="connsiteX6" fmla="*/ 60385 w 506038"/>
              <a:gd name="connsiteY6" fmla="*/ 37957 h 915667"/>
              <a:gd name="connsiteX0" fmla="*/ 60385 w 506038"/>
              <a:gd name="connsiteY0" fmla="*/ 37957 h 915667"/>
              <a:gd name="connsiteX1" fmla="*/ 506038 w 506038"/>
              <a:gd name="connsiteY1" fmla="*/ 347200 h 915667"/>
              <a:gd name="connsiteX2" fmla="*/ 472071 w 506038"/>
              <a:gd name="connsiteY2" fmla="*/ 679465 h 915667"/>
              <a:gd name="connsiteX3" fmla="*/ 57189 w 506038"/>
              <a:gd name="connsiteY3" fmla="*/ 901276 h 915667"/>
              <a:gd name="connsiteX4" fmla="*/ 62 w 506038"/>
              <a:gd name="connsiteY4" fmla="*/ 654288 h 915667"/>
              <a:gd name="connsiteX5" fmla="*/ 24213 w 506038"/>
              <a:gd name="connsiteY5" fmla="*/ 298933 h 915667"/>
              <a:gd name="connsiteX6" fmla="*/ 60385 w 506038"/>
              <a:gd name="connsiteY6" fmla="*/ 37957 h 915667"/>
              <a:gd name="connsiteX0" fmla="*/ 60385 w 506038"/>
              <a:gd name="connsiteY0" fmla="*/ 15724 h 893434"/>
              <a:gd name="connsiteX1" fmla="*/ 506038 w 506038"/>
              <a:gd name="connsiteY1" fmla="*/ 324967 h 893434"/>
              <a:gd name="connsiteX2" fmla="*/ 472071 w 506038"/>
              <a:gd name="connsiteY2" fmla="*/ 657232 h 893434"/>
              <a:gd name="connsiteX3" fmla="*/ 57189 w 506038"/>
              <a:gd name="connsiteY3" fmla="*/ 879043 h 893434"/>
              <a:gd name="connsiteX4" fmla="*/ 62 w 506038"/>
              <a:gd name="connsiteY4" fmla="*/ 632055 h 893434"/>
              <a:gd name="connsiteX5" fmla="*/ 24213 w 506038"/>
              <a:gd name="connsiteY5" fmla="*/ 276700 h 893434"/>
              <a:gd name="connsiteX6" fmla="*/ 60385 w 506038"/>
              <a:gd name="connsiteY6" fmla="*/ 15724 h 893434"/>
              <a:gd name="connsiteX0" fmla="*/ 60385 w 506038"/>
              <a:gd name="connsiteY0" fmla="*/ 9433 h 887143"/>
              <a:gd name="connsiteX1" fmla="*/ 408960 w 506038"/>
              <a:gd name="connsiteY1" fmla="*/ 73393 h 887143"/>
              <a:gd name="connsiteX2" fmla="*/ 506038 w 506038"/>
              <a:gd name="connsiteY2" fmla="*/ 318676 h 887143"/>
              <a:gd name="connsiteX3" fmla="*/ 472071 w 506038"/>
              <a:gd name="connsiteY3" fmla="*/ 650941 h 887143"/>
              <a:gd name="connsiteX4" fmla="*/ 57189 w 506038"/>
              <a:gd name="connsiteY4" fmla="*/ 872752 h 887143"/>
              <a:gd name="connsiteX5" fmla="*/ 62 w 506038"/>
              <a:gd name="connsiteY5" fmla="*/ 625764 h 887143"/>
              <a:gd name="connsiteX6" fmla="*/ 24213 w 506038"/>
              <a:gd name="connsiteY6" fmla="*/ 270409 h 887143"/>
              <a:gd name="connsiteX7" fmla="*/ 60385 w 506038"/>
              <a:gd name="connsiteY7" fmla="*/ 9433 h 887143"/>
              <a:gd name="connsiteX0" fmla="*/ 60385 w 506038"/>
              <a:gd name="connsiteY0" fmla="*/ 9433 h 887143"/>
              <a:gd name="connsiteX1" fmla="*/ 408960 w 506038"/>
              <a:gd name="connsiteY1" fmla="*/ 73393 h 887143"/>
              <a:gd name="connsiteX2" fmla="*/ 506038 w 506038"/>
              <a:gd name="connsiteY2" fmla="*/ 318676 h 887143"/>
              <a:gd name="connsiteX3" fmla="*/ 472071 w 506038"/>
              <a:gd name="connsiteY3" fmla="*/ 650941 h 887143"/>
              <a:gd name="connsiteX4" fmla="*/ 57189 w 506038"/>
              <a:gd name="connsiteY4" fmla="*/ 872752 h 887143"/>
              <a:gd name="connsiteX5" fmla="*/ 62 w 506038"/>
              <a:gd name="connsiteY5" fmla="*/ 625764 h 887143"/>
              <a:gd name="connsiteX6" fmla="*/ 24213 w 506038"/>
              <a:gd name="connsiteY6" fmla="*/ 270409 h 887143"/>
              <a:gd name="connsiteX7" fmla="*/ 60385 w 506038"/>
              <a:gd name="connsiteY7" fmla="*/ 9433 h 887143"/>
              <a:gd name="connsiteX0" fmla="*/ 60385 w 506038"/>
              <a:gd name="connsiteY0" fmla="*/ 9433 h 887143"/>
              <a:gd name="connsiteX1" fmla="*/ 408960 w 506038"/>
              <a:gd name="connsiteY1" fmla="*/ 73393 h 887143"/>
              <a:gd name="connsiteX2" fmla="*/ 506038 w 506038"/>
              <a:gd name="connsiteY2" fmla="*/ 318676 h 887143"/>
              <a:gd name="connsiteX3" fmla="*/ 472071 w 506038"/>
              <a:gd name="connsiteY3" fmla="*/ 650941 h 887143"/>
              <a:gd name="connsiteX4" fmla="*/ 57189 w 506038"/>
              <a:gd name="connsiteY4" fmla="*/ 872752 h 887143"/>
              <a:gd name="connsiteX5" fmla="*/ 62 w 506038"/>
              <a:gd name="connsiteY5" fmla="*/ 625764 h 887143"/>
              <a:gd name="connsiteX6" fmla="*/ 24213 w 506038"/>
              <a:gd name="connsiteY6" fmla="*/ 270409 h 887143"/>
              <a:gd name="connsiteX7" fmla="*/ 60385 w 506038"/>
              <a:gd name="connsiteY7" fmla="*/ 9433 h 887143"/>
              <a:gd name="connsiteX0" fmla="*/ 60385 w 506038"/>
              <a:gd name="connsiteY0" fmla="*/ 9433 h 887143"/>
              <a:gd name="connsiteX1" fmla="*/ 408960 w 506038"/>
              <a:gd name="connsiteY1" fmla="*/ 73393 h 887143"/>
              <a:gd name="connsiteX2" fmla="*/ 506038 w 506038"/>
              <a:gd name="connsiteY2" fmla="*/ 318676 h 887143"/>
              <a:gd name="connsiteX3" fmla="*/ 472071 w 506038"/>
              <a:gd name="connsiteY3" fmla="*/ 650941 h 887143"/>
              <a:gd name="connsiteX4" fmla="*/ 57189 w 506038"/>
              <a:gd name="connsiteY4" fmla="*/ 872752 h 887143"/>
              <a:gd name="connsiteX5" fmla="*/ 62 w 506038"/>
              <a:gd name="connsiteY5" fmla="*/ 625764 h 887143"/>
              <a:gd name="connsiteX6" fmla="*/ 24213 w 506038"/>
              <a:gd name="connsiteY6" fmla="*/ 270409 h 887143"/>
              <a:gd name="connsiteX7" fmla="*/ 60385 w 506038"/>
              <a:gd name="connsiteY7" fmla="*/ 9433 h 887143"/>
              <a:gd name="connsiteX0" fmla="*/ 60385 w 506038"/>
              <a:gd name="connsiteY0" fmla="*/ 13617 h 891327"/>
              <a:gd name="connsiteX1" fmla="*/ 408960 w 506038"/>
              <a:gd name="connsiteY1" fmla="*/ 77577 h 891327"/>
              <a:gd name="connsiteX2" fmla="*/ 506038 w 506038"/>
              <a:gd name="connsiteY2" fmla="*/ 322860 h 891327"/>
              <a:gd name="connsiteX3" fmla="*/ 472071 w 506038"/>
              <a:gd name="connsiteY3" fmla="*/ 655125 h 891327"/>
              <a:gd name="connsiteX4" fmla="*/ 57189 w 506038"/>
              <a:gd name="connsiteY4" fmla="*/ 876936 h 891327"/>
              <a:gd name="connsiteX5" fmla="*/ 62 w 506038"/>
              <a:gd name="connsiteY5" fmla="*/ 629948 h 891327"/>
              <a:gd name="connsiteX6" fmla="*/ 24213 w 506038"/>
              <a:gd name="connsiteY6" fmla="*/ 274593 h 891327"/>
              <a:gd name="connsiteX7" fmla="*/ 60385 w 506038"/>
              <a:gd name="connsiteY7" fmla="*/ 13617 h 891327"/>
              <a:gd name="connsiteX0" fmla="*/ 46895 w 506038"/>
              <a:gd name="connsiteY0" fmla="*/ 16943 h 882140"/>
              <a:gd name="connsiteX1" fmla="*/ 408960 w 506038"/>
              <a:gd name="connsiteY1" fmla="*/ 68390 h 882140"/>
              <a:gd name="connsiteX2" fmla="*/ 506038 w 506038"/>
              <a:gd name="connsiteY2" fmla="*/ 313673 h 882140"/>
              <a:gd name="connsiteX3" fmla="*/ 472071 w 506038"/>
              <a:gd name="connsiteY3" fmla="*/ 645938 h 882140"/>
              <a:gd name="connsiteX4" fmla="*/ 57189 w 506038"/>
              <a:gd name="connsiteY4" fmla="*/ 867749 h 882140"/>
              <a:gd name="connsiteX5" fmla="*/ 62 w 506038"/>
              <a:gd name="connsiteY5" fmla="*/ 620761 h 882140"/>
              <a:gd name="connsiteX6" fmla="*/ 24213 w 506038"/>
              <a:gd name="connsiteY6" fmla="*/ 265406 h 882140"/>
              <a:gd name="connsiteX7" fmla="*/ 46895 w 506038"/>
              <a:gd name="connsiteY7" fmla="*/ 16943 h 882140"/>
              <a:gd name="connsiteX0" fmla="*/ 46895 w 506038"/>
              <a:gd name="connsiteY0" fmla="*/ 16943 h 882140"/>
              <a:gd name="connsiteX1" fmla="*/ 408960 w 506038"/>
              <a:gd name="connsiteY1" fmla="*/ 68390 h 882140"/>
              <a:gd name="connsiteX2" fmla="*/ 506038 w 506038"/>
              <a:gd name="connsiteY2" fmla="*/ 313673 h 882140"/>
              <a:gd name="connsiteX3" fmla="*/ 472071 w 506038"/>
              <a:gd name="connsiteY3" fmla="*/ 645938 h 882140"/>
              <a:gd name="connsiteX4" fmla="*/ 57189 w 506038"/>
              <a:gd name="connsiteY4" fmla="*/ 867749 h 882140"/>
              <a:gd name="connsiteX5" fmla="*/ 62 w 506038"/>
              <a:gd name="connsiteY5" fmla="*/ 620761 h 882140"/>
              <a:gd name="connsiteX6" fmla="*/ 24213 w 506038"/>
              <a:gd name="connsiteY6" fmla="*/ 265406 h 882140"/>
              <a:gd name="connsiteX7" fmla="*/ 46895 w 506038"/>
              <a:gd name="connsiteY7" fmla="*/ 16943 h 882140"/>
              <a:gd name="connsiteX0" fmla="*/ 46895 w 506038"/>
              <a:gd name="connsiteY0" fmla="*/ 16943 h 882140"/>
              <a:gd name="connsiteX1" fmla="*/ 408960 w 506038"/>
              <a:gd name="connsiteY1" fmla="*/ 68390 h 882140"/>
              <a:gd name="connsiteX2" fmla="*/ 506038 w 506038"/>
              <a:gd name="connsiteY2" fmla="*/ 313673 h 882140"/>
              <a:gd name="connsiteX3" fmla="*/ 472071 w 506038"/>
              <a:gd name="connsiteY3" fmla="*/ 645938 h 882140"/>
              <a:gd name="connsiteX4" fmla="*/ 57189 w 506038"/>
              <a:gd name="connsiteY4" fmla="*/ 867749 h 882140"/>
              <a:gd name="connsiteX5" fmla="*/ 62 w 506038"/>
              <a:gd name="connsiteY5" fmla="*/ 620761 h 882140"/>
              <a:gd name="connsiteX6" fmla="*/ 24213 w 506038"/>
              <a:gd name="connsiteY6" fmla="*/ 265406 h 882140"/>
              <a:gd name="connsiteX7" fmla="*/ 46895 w 506038"/>
              <a:gd name="connsiteY7" fmla="*/ 16943 h 882140"/>
              <a:gd name="connsiteX0" fmla="*/ 46895 w 506038"/>
              <a:gd name="connsiteY0" fmla="*/ 29542 h 894739"/>
              <a:gd name="connsiteX1" fmla="*/ 408960 w 506038"/>
              <a:gd name="connsiteY1" fmla="*/ 80989 h 894739"/>
              <a:gd name="connsiteX2" fmla="*/ 506038 w 506038"/>
              <a:gd name="connsiteY2" fmla="*/ 326272 h 894739"/>
              <a:gd name="connsiteX3" fmla="*/ 472071 w 506038"/>
              <a:gd name="connsiteY3" fmla="*/ 658537 h 894739"/>
              <a:gd name="connsiteX4" fmla="*/ 57189 w 506038"/>
              <a:gd name="connsiteY4" fmla="*/ 880348 h 894739"/>
              <a:gd name="connsiteX5" fmla="*/ 62 w 506038"/>
              <a:gd name="connsiteY5" fmla="*/ 633360 h 894739"/>
              <a:gd name="connsiteX6" fmla="*/ 24213 w 506038"/>
              <a:gd name="connsiteY6" fmla="*/ 278005 h 894739"/>
              <a:gd name="connsiteX7" fmla="*/ 46895 w 506038"/>
              <a:gd name="connsiteY7" fmla="*/ 29542 h 894739"/>
              <a:gd name="connsiteX0" fmla="*/ 46895 w 506038"/>
              <a:gd name="connsiteY0" fmla="*/ 30594 h 895791"/>
              <a:gd name="connsiteX1" fmla="*/ 408960 w 506038"/>
              <a:gd name="connsiteY1" fmla="*/ 82041 h 895791"/>
              <a:gd name="connsiteX2" fmla="*/ 506038 w 506038"/>
              <a:gd name="connsiteY2" fmla="*/ 327324 h 895791"/>
              <a:gd name="connsiteX3" fmla="*/ 472071 w 506038"/>
              <a:gd name="connsiteY3" fmla="*/ 659589 h 895791"/>
              <a:gd name="connsiteX4" fmla="*/ 57189 w 506038"/>
              <a:gd name="connsiteY4" fmla="*/ 881400 h 895791"/>
              <a:gd name="connsiteX5" fmla="*/ 62 w 506038"/>
              <a:gd name="connsiteY5" fmla="*/ 634412 h 895791"/>
              <a:gd name="connsiteX6" fmla="*/ 24213 w 506038"/>
              <a:gd name="connsiteY6" fmla="*/ 279057 h 895791"/>
              <a:gd name="connsiteX7" fmla="*/ 46895 w 506038"/>
              <a:gd name="connsiteY7" fmla="*/ 30594 h 895791"/>
              <a:gd name="connsiteX0" fmla="*/ 54432 w 506038"/>
              <a:gd name="connsiteY0" fmla="*/ 34209 h 887856"/>
              <a:gd name="connsiteX1" fmla="*/ 408960 w 506038"/>
              <a:gd name="connsiteY1" fmla="*/ 74106 h 887856"/>
              <a:gd name="connsiteX2" fmla="*/ 506038 w 506038"/>
              <a:gd name="connsiteY2" fmla="*/ 319389 h 887856"/>
              <a:gd name="connsiteX3" fmla="*/ 472071 w 506038"/>
              <a:gd name="connsiteY3" fmla="*/ 651654 h 887856"/>
              <a:gd name="connsiteX4" fmla="*/ 57189 w 506038"/>
              <a:gd name="connsiteY4" fmla="*/ 873465 h 887856"/>
              <a:gd name="connsiteX5" fmla="*/ 62 w 506038"/>
              <a:gd name="connsiteY5" fmla="*/ 626477 h 887856"/>
              <a:gd name="connsiteX6" fmla="*/ 24213 w 506038"/>
              <a:gd name="connsiteY6" fmla="*/ 271122 h 887856"/>
              <a:gd name="connsiteX7" fmla="*/ 54432 w 506038"/>
              <a:gd name="connsiteY7" fmla="*/ 34209 h 887856"/>
              <a:gd name="connsiteX0" fmla="*/ 54432 w 506038"/>
              <a:gd name="connsiteY0" fmla="*/ 49621 h 903268"/>
              <a:gd name="connsiteX1" fmla="*/ 408960 w 506038"/>
              <a:gd name="connsiteY1" fmla="*/ 89518 h 903268"/>
              <a:gd name="connsiteX2" fmla="*/ 506038 w 506038"/>
              <a:gd name="connsiteY2" fmla="*/ 334801 h 903268"/>
              <a:gd name="connsiteX3" fmla="*/ 472071 w 506038"/>
              <a:gd name="connsiteY3" fmla="*/ 667066 h 903268"/>
              <a:gd name="connsiteX4" fmla="*/ 57189 w 506038"/>
              <a:gd name="connsiteY4" fmla="*/ 888877 h 903268"/>
              <a:gd name="connsiteX5" fmla="*/ 62 w 506038"/>
              <a:gd name="connsiteY5" fmla="*/ 641889 h 903268"/>
              <a:gd name="connsiteX6" fmla="*/ 24213 w 506038"/>
              <a:gd name="connsiteY6" fmla="*/ 286534 h 903268"/>
              <a:gd name="connsiteX7" fmla="*/ 54432 w 506038"/>
              <a:gd name="connsiteY7" fmla="*/ 49621 h 903268"/>
              <a:gd name="connsiteX0" fmla="*/ 54432 w 506038"/>
              <a:gd name="connsiteY0" fmla="*/ 42183 h 895830"/>
              <a:gd name="connsiteX1" fmla="*/ 408960 w 506038"/>
              <a:gd name="connsiteY1" fmla="*/ 82080 h 895830"/>
              <a:gd name="connsiteX2" fmla="*/ 506038 w 506038"/>
              <a:gd name="connsiteY2" fmla="*/ 327363 h 895830"/>
              <a:gd name="connsiteX3" fmla="*/ 472071 w 506038"/>
              <a:gd name="connsiteY3" fmla="*/ 659628 h 895830"/>
              <a:gd name="connsiteX4" fmla="*/ 57189 w 506038"/>
              <a:gd name="connsiteY4" fmla="*/ 881439 h 895830"/>
              <a:gd name="connsiteX5" fmla="*/ 62 w 506038"/>
              <a:gd name="connsiteY5" fmla="*/ 634451 h 895830"/>
              <a:gd name="connsiteX6" fmla="*/ 24213 w 506038"/>
              <a:gd name="connsiteY6" fmla="*/ 279096 h 895830"/>
              <a:gd name="connsiteX7" fmla="*/ 54432 w 506038"/>
              <a:gd name="connsiteY7" fmla="*/ 42183 h 895830"/>
              <a:gd name="connsiteX0" fmla="*/ 54432 w 506038"/>
              <a:gd name="connsiteY0" fmla="*/ 31542 h 885189"/>
              <a:gd name="connsiteX1" fmla="*/ 174423 w 506038"/>
              <a:gd name="connsiteY1" fmla="*/ 8453 h 885189"/>
              <a:gd name="connsiteX2" fmla="*/ 408960 w 506038"/>
              <a:gd name="connsiteY2" fmla="*/ 71439 h 885189"/>
              <a:gd name="connsiteX3" fmla="*/ 506038 w 506038"/>
              <a:gd name="connsiteY3" fmla="*/ 316722 h 885189"/>
              <a:gd name="connsiteX4" fmla="*/ 472071 w 506038"/>
              <a:gd name="connsiteY4" fmla="*/ 648987 h 885189"/>
              <a:gd name="connsiteX5" fmla="*/ 57189 w 506038"/>
              <a:gd name="connsiteY5" fmla="*/ 870798 h 885189"/>
              <a:gd name="connsiteX6" fmla="*/ 62 w 506038"/>
              <a:gd name="connsiteY6" fmla="*/ 623810 h 885189"/>
              <a:gd name="connsiteX7" fmla="*/ 24213 w 506038"/>
              <a:gd name="connsiteY7" fmla="*/ 268455 h 885189"/>
              <a:gd name="connsiteX8" fmla="*/ 54432 w 506038"/>
              <a:gd name="connsiteY8" fmla="*/ 31542 h 885189"/>
              <a:gd name="connsiteX0" fmla="*/ 54432 w 506038"/>
              <a:gd name="connsiteY0" fmla="*/ 47151 h 900798"/>
              <a:gd name="connsiteX1" fmla="*/ 174423 w 506038"/>
              <a:gd name="connsiteY1" fmla="*/ 24062 h 900798"/>
              <a:gd name="connsiteX2" fmla="*/ 408960 w 506038"/>
              <a:gd name="connsiteY2" fmla="*/ 87048 h 900798"/>
              <a:gd name="connsiteX3" fmla="*/ 506038 w 506038"/>
              <a:gd name="connsiteY3" fmla="*/ 332331 h 900798"/>
              <a:gd name="connsiteX4" fmla="*/ 472071 w 506038"/>
              <a:gd name="connsiteY4" fmla="*/ 664596 h 900798"/>
              <a:gd name="connsiteX5" fmla="*/ 57189 w 506038"/>
              <a:gd name="connsiteY5" fmla="*/ 886407 h 900798"/>
              <a:gd name="connsiteX6" fmla="*/ 62 w 506038"/>
              <a:gd name="connsiteY6" fmla="*/ 639419 h 900798"/>
              <a:gd name="connsiteX7" fmla="*/ 24213 w 506038"/>
              <a:gd name="connsiteY7" fmla="*/ 284064 h 900798"/>
              <a:gd name="connsiteX8" fmla="*/ 54432 w 506038"/>
              <a:gd name="connsiteY8" fmla="*/ 47151 h 90079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42881 h 896528"/>
              <a:gd name="connsiteX1" fmla="*/ 174423 w 506038"/>
              <a:gd name="connsiteY1" fmla="*/ 19792 h 896528"/>
              <a:gd name="connsiteX2" fmla="*/ 408960 w 506038"/>
              <a:gd name="connsiteY2" fmla="*/ 82778 h 896528"/>
              <a:gd name="connsiteX3" fmla="*/ 506038 w 506038"/>
              <a:gd name="connsiteY3" fmla="*/ 328061 h 896528"/>
              <a:gd name="connsiteX4" fmla="*/ 472071 w 506038"/>
              <a:gd name="connsiteY4" fmla="*/ 660326 h 896528"/>
              <a:gd name="connsiteX5" fmla="*/ 57189 w 506038"/>
              <a:gd name="connsiteY5" fmla="*/ 882137 h 896528"/>
              <a:gd name="connsiteX6" fmla="*/ 62 w 506038"/>
              <a:gd name="connsiteY6" fmla="*/ 635149 h 896528"/>
              <a:gd name="connsiteX7" fmla="*/ 24213 w 506038"/>
              <a:gd name="connsiteY7" fmla="*/ 279794 h 896528"/>
              <a:gd name="connsiteX8" fmla="*/ 54432 w 506038"/>
              <a:gd name="connsiteY8" fmla="*/ 42881 h 896528"/>
              <a:gd name="connsiteX0" fmla="*/ 54432 w 506038"/>
              <a:gd name="connsiteY0" fmla="*/ 37376 h 891023"/>
              <a:gd name="connsiteX1" fmla="*/ 174423 w 506038"/>
              <a:gd name="connsiteY1" fmla="*/ 14287 h 891023"/>
              <a:gd name="connsiteX2" fmla="*/ 408960 w 506038"/>
              <a:gd name="connsiteY2" fmla="*/ 77273 h 891023"/>
              <a:gd name="connsiteX3" fmla="*/ 506038 w 506038"/>
              <a:gd name="connsiteY3" fmla="*/ 322556 h 891023"/>
              <a:gd name="connsiteX4" fmla="*/ 472071 w 506038"/>
              <a:gd name="connsiteY4" fmla="*/ 654821 h 891023"/>
              <a:gd name="connsiteX5" fmla="*/ 57189 w 506038"/>
              <a:gd name="connsiteY5" fmla="*/ 876632 h 891023"/>
              <a:gd name="connsiteX6" fmla="*/ 62 w 506038"/>
              <a:gd name="connsiteY6" fmla="*/ 629644 h 891023"/>
              <a:gd name="connsiteX7" fmla="*/ 24213 w 506038"/>
              <a:gd name="connsiteY7" fmla="*/ 274289 h 891023"/>
              <a:gd name="connsiteX8" fmla="*/ 54432 w 506038"/>
              <a:gd name="connsiteY8" fmla="*/ 37376 h 891023"/>
              <a:gd name="connsiteX0" fmla="*/ 54432 w 515459"/>
              <a:gd name="connsiteY0" fmla="*/ 37376 h 891023"/>
              <a:gd name="connsiteX1" fmla="*/ 174423 w 515459"/>
              <a:gd name="connsiteY1" fmla="*/ 14287 h 891023"/>
              <a:gd name="connsiteX2" fmla="*/ 408960 w 515459"/>
              <a:gd name="connsiteY2" fmla="*/ 77273 h 891023"/>
              <a:gd name="connsiteX3" fmla="*/ 515459 w 515459"/>
              <a:gd name="connsiteY3" fmla="*/ 317217 h 891023"/>
              <a:gd name="connsiteX4" fmla="*/ 472071 w 515459"/>
              <a:gd name="connsiteY4" fmla="*/ 654821 h 891023"/>
              <a:gd name="connsiteX5" fmla="*/ 57189 w 515459"/>
              <a:gd name="connsiteY5" fmla="*/ 876632 h 891023"/>
              <a:gd name="connsiteX6" fmla="*/ 62 w 515459"/>
              <a:gd name="connsiteY6" fmla="*/ 629644 h 891023"/>
              <a:gd name="connsiteX7" fmla="*/ 24213 w 515459"/>
              <a:gd name="connsiteY7" fmla="*/ 274289 h 891023"/>
              <a:gd name="connsiteX8" fmla="*/ 54432 w 515459"/>
              <a:gd name="connsiteY8" fmla="*/ 37376 h 891023"/>
              <a:gd name="connsiteX0" fmla="*/ 54432 w 515459"/>
              <a:gd name="connsiteY0" fmla="*/ 37376 h 889634"/>
              <a:gd name="connsiteX1" fmla="*/ 174423 w 515459"/>
              <a:gd name="connsiteY1" fmla="*/ 14287 h 889634"/>
              <a:gd name="connsiteX2" fmla="*/ 408960 w 515459"/>
              <a:gd name="connsiteY2" fmla="*/ 77273 h 889634"/>
              <a:gd name="connsiteX3" fmla="*/ 515459 w 515459"/>
              <a:gd name="connsiteY3" fmla="*/ 317217 h 889634"/>
              <a:gd name="connsiteX4" fmla="*/ 488612 w 515459"/>
              <a:gd name="connsiteY4" fmla="*/ 646701 h 889634"/>
              <a:gd name="connsiteX5" fmla="*/ 57189 w 515459"/>
              <a:gd name="connsiteY5" fmla="*/ 876632 h 889634"/>
              <a:gd name="connsiteX6" fmla="*/ 62 w 515459"/>
              <a:gd name="connsiteY6" fmla="*/ 629644 h 889634"/>
              <a:gd name="connsiteX7" fmla="*/ 24213 w 515459"/>
              <a:gd name="connsiteY7" fmla="*/ 274289 h 889634"/>
              <a:gd name="connsiteX8" fmla="*/ 54432 w 515459"/>
              <a:gd name="connsiteY8" fmla="*/ 37376 h 889634"/>
              <a:gd name="connsiteX0" fmla="*/ 54415 w 515442"/>
              <a:gd name="connsiteY0" fmla="*/ 37376 h 891137"/>
              <a:gd name="connsiteX1" fmla="*/ 174406 w 515442"/>
              <a:gd name="connsiteY1" fmla="*/ 14287 h 891137"/>
              <a:gd name="connsiteX2" fmla="*/ 408943 w 515442"/>
              <a:gd name="connsiteY2" fmla="*/ 77273 h 891137"/>
              <a:gd name="connsiteX3" fmla="*/ 515442 w 515442"/>
              <a:gd name="connsiteY3" fmla="*/ 317217 h 891137"/>
              <a:gd name="connsiteX4" fmla="*/ 488595 w 515442"/>
              <a:gd name="connsiteY4" fmla="*/ 646701 h 891137"/>
              <a:gd name="connsiteX5" fmla="*/ 71739 w 515442"/>
              <a:gd name="connsiteY5" fmla="*/ 878418 h 891137"/>
              <a:gd name="connsiteX6" fmla="*/ 45 w 515442"/>
              <a:gd name="connsiteY6" fmla="*/ 629644 h 891137"/>
              <a:gd name="connsiteX7" fmla="*/ 24196 w 515442"/>
              <a:gd name="connsiteY7" fmla="*/ 274289 h 891137"/>
              <a:gd name="connsiteX8" fmla="*/ 54415 w 515442"/>
              <a:gd name="connsiteY8" fmla="*/ 37376 h 891137"/>
              <a:gd name="connsiteX0" fmla="*/ 47194 w 508221"/>
              <a:gd name="connsiteY0" fmla="*/ 37376 h 891137"/>
              <a:gd name="connsiteX1" fmla="*/ 167185 w 508221"/>
              <a:gd name="connsiteY1" fmla="*/ 14287 h 891137"/>
              <a:gd name="connsiteX2" fmla="*/ 401722 w 508221"/>
              <a:gd name="connsiteY2" fmla="*/ 77273 h 891137"/>
              <a:gd name="connsiteX3" fmla="*/ 508221 w 508221"/>
              <a:gd name="connsiteY3" fmla="*/ 317217 h 891137"/>
              <a:gd name="connsiteX4" fmla="*/ 481374 w 508221"/>
              <a:gd name="connsiteY4" fmla="*/ 646701 h 891137"/>
              <a:gd name="connsiteX5" fmla="*/ 64518 w 508221"/>
              <a:gd name="connsiteY5" fmla="*/ 878418 h 891137"/>
              <a:gd name="connsiteX6" fmla="*/ 53 w 508221"/>
              <a:gd name="connsiteY6" fmla="*/ 629312 h 891137"/>
              <a:gd name="connsiteX7" fmla="*/ 16975 w 508221"/>
              <a:gd name="connsiteY7" fmla="*/ 274289 h 891137"/>
              <a:gd name="connsiteX8" fmla="*/ 47194 w 508221"/>
              <a:gd name="connsiteY8" fmla="*/ 37376 h 891137"/>
              <a:gd name="connsiteX0" fmla="*/ 47141 w 508168"/>
              <a:gd name="connsiteY0" fmla="*/ 37376 h 891137"/>
              <a:gd name="connsiteX1" fmla="*/ 167132 w 508168"/>
              <a:gd name="connsiteY1" fmla="*/ 14287 h 891137"/>
              <a:gd name="connsiteX2" fmla="*/ 401669 w 508168"/>
              <a:gd name="connsiteY2" fmla="*/ 77273 h 891137"/>
              <a:gd name="connsiteX3" fmla="*/ 508168 w 508168"/>
              <a:gd name="connsiteY3" fmla="*/ 317217 h 891137"/>
              <a:gd name="connsiteX4" fmla="*/ 481321 w 508168"/>
              <a:gd name="connsiteY4" fmla="*/ 646701 h 891137"/>
              <a:gd name="connsiteX5" fmla="*/ 64465 w 508168"/>
              <a:gd name="connsiteY5" fmla="*/ 878418 h 891137"/>
              <a:gd name="connsiteX6" fmla="*/ 0 w 508168"/>
              <a:gd name="connsiteY6" fmla="*/ 629312 h 891137"/>
              <a:gd name="connsiteX7" fmla="*/ 16922 w 508168"/>
              <a:gd name="connsiteY7" fmla="*/ 274289 h 891137"/>
              <a:gd name="connsiteX8" fmla="*/ 47141 w 508168"/>
              <a:gd name="connsiteY8" fmla="*/ 37376 h 891137"/>
              <a:gd name="connsiteX0" fmla="*/ 23262 w 508168"/>
              <a:gd name="connsiteY0" fmla="*/ 41285 h 889043"/>
              <a:gd name="connsiteX1" fmla="*/ 167132 w 508168"/>
              <a:gd name="connsiteY1" fmla="*/ 12193 h 889043"/>
              <a:gd name="connsiteX2" fmla="*/ 401669 w 508168"/>
              <a:gd name="connsiteY2" fmla="*/ 75179 h 889043"/>
              <a:gd name="connsiteX3" fmla="*/ 508168 w 508168"/>
              <a:gd name="connsiteY3" fmla="*/ 315123 h 889043"/>
              <a:gd name="connsiteX4" fmla="*/ 481321 w 508168"/>
              <a:gd name="connsiteY4" fmla="*/ 644607 h 889043"/>
              <a:gd name="connsiteX5" fmla="*/ 64465 w 508168"/>
              <a:gd name="connsiteY5" fmla="*/ 876324 h 889043"/>
              <a:gd name="connsiteX6" fmla="*/ 0 w 508168"/>
              <a:gd name="connsiteY6" fmla="*/ 627218 h 889043"/>
              <a:gd name="connsiteX7" fmla="*/ 16922 w 508168"/>
              <a:gd name="connsiteY7" fmla="*/ 272195 h 889043"/>
              <a:gd name="connsiteX8" fmla="*/ 23262 w 508168"/>
              <a:gd name="connsiteY8" fmla="*/ 41285 h 889043"/>
              <a:gd name="connsiteX0" fmla="*/ 23262 w 508168"/>
              <a:gd name="connsiteY0" fmla="*/ 41285 h 889043"/>
              <a:gd name="connsiteX1" fmla="*/ 167132 w 508168"/>
              <a:gd name="connsiteY1" fmla="*/ 12193 h 889043"/>
              <a:gd name="connsiteX2" fmla="*/ 401669 w 508168"/>
              <a:gd name="connsiteY2" fmla="*/ 75179 h 889043"/>
              <a:gd name="connsiteX3" fmla="*/ 508168 w 508168"/>
              <a:gd name="connsiteY3" fmla="*/ 315123 h 889043"/>
              <a:gd name="connsiteX4" fmla="*/ 481321 w 508168"/>
              <a:gd name="connsiteY4" fmla="*/ 644607 h 889043"/>
              <a:gd name="connsiteX5" fmla="*/ 64465 w 508168"/>
              <a:gd name="connsiteY5" fmla="*/ 876324 h 889043"/>
              <a:gd name="connsiteX6" fmla="*/ 0 w 508168"/>
              <a:gd name="connsiteY6" fmla="*/ 627218 h 889043"/>
              <a:gd name="connsiteX7" fmla="*/ 4440 w 508168"/>
              <a:gd name="connsiteY7" fmla="*/ 262952 h 889043"/>
              <a:gd name="connsiteX8" fmla="*/ 23262 w 508168"/>
              <a:gd name="connsiteY8" fmla="*/ 41285 h 889043"/>
              <a:gd name="connsiteX0" fmla="*/ 23262 w 508168"/>
              <a:gd name="connsiteY0" fmla="*/ 41285 h 889043"/>
              <a:gd name="connsiteX1" fmla="*/ 167132 w 508168"/>
              <a:gd name="connsiteY1" fmla="*/ 12193 h 889043"/>
              <a:gd name="connsiteX2" fmla="*/ 401669 w 508168"/>
              <a:gd name="connsiteY2" fmla="*/ 75179 h 889043"/>
              <a:gd name="connsiteX3" fmla="*/ 508168 w 508168"/>
              <a:gd name="connsiteY3" fmla="*/ 315123 h 889043"/>
              <a:gd name="connsiteX4" fmla="*/ 481321 w 508168"/>
              <a:gd name="connsiteY4" fmla="*/ 644607 h 889043"/>
              <a:gd name="connsiteX5" fmla="*/ 64465 w 508168"/>
              <a:gd name="connsiteY5" fmla="*/ 876324 h 889043"/>
              <a:gd name="connsiteX6" fmla="*/ 0 w 508168"/>
              <a:gd name="connsiteY6" fmla="*/ 627218 h 889043"/>
              <a:gd name="connsiteX7" fmla="*/ 4440 w 508168"/>
              <a:gd name="connsiteY7" fmla="*/ 262952 h 889043"/>
              <a:gd name="connsiteX8" fmla="*/ 23262 w 508168"/>
              <a:gd name="connsiteY8" fmla="*/ 41285 h 889043"/>
              <a:gd name="connsiteX0" fmla="*/ 23262 w 508168"/>
              <a:gd name="connsiteY0" fmla="*/ 41285 h 889043"/>
              <a:gd name="connsiteX1" fmla="*/ 167132 w 508168"/>
              <a:gd name="connsiteY1" fmla="*/ 12193 h 889043"/>
              <a:gd name="connsiteX2" fmla="*/ 413934 w 508168"/>
              <a:gd name="connsiteY2" fmla="*/ 79524 h 889043"/>
              <a:gd name="connsiteX3" fmla="*/ 508168 w 508168"/>
              <a:gd name="connsiteY3" fmla="*/ 315123 h 889043"/>
              <a:gd name="connsiteX4" fmla="*/ 481321 w 508168"/>
              <a:gd name="connsiteY4" fmla="*/ 644607 h 889043"/>
              <a:gd name="connsiteX5" fmla="*/ 64465 w 508168"/>
              <a:gd name="connsiteY5" fmla="*/ 876324 h 889043"/>
              <a:gd name="connsiteX6" fmla="*/ 0 w 508168"/>
              <a:gd name="connsiteY6" fmla="*/ 627218 h 889043"/>
              <a:gd name="connsiteX7" fmla="*/ 4440 w 508168"/>
              <a:gd name="connsiteY7" fmla="*/ 262952 h 889043"/>
              <a:gd name="connsiteX8" fmla="*/ 23262 w 508168"/>
              <a:gd name="connsiteY8" fmla="*/ 41285 h 889043"/>
              <a:gd name="connsiteX0" fmla="*/ 23262 w 508168"/>
              <a:gd name="connsiteY0" fmla="*/ 41285 h 883479"/>
              <a:gd name="connsiteX1" fmla="*/ 167132 w 508168"/>
              <a:gd name="connsiteY1" fmla="*/ 12193 h 883479"/>
              <a:gd name="connsiteX2" fmla="*/ 413934 w 508168"/>
              <a:gd name="connsiteY2" fmla="*/ 79524 h 883479"/>
              <a:gd name="connsiteX3" fmla="*/ 508168 w 508168"/>
              <a:gd name="connsiteY3" fmla="*/ 315123 h 883479"/>
              <a:gd name="connsiteX4" fmla="*/ 481321 w 508168"/>
              <a:gd name="connsiteY4" fmla="*/ 644607 h 883479"/>
              <a:gd name="connsiteX5" fmla="*/ 64465 w 508168"/>
              <a:gd name="connsiteY5" fmla="*/ 876324 h 883479"/>
              <a:gd name="connsiteX6" fmla="*/ 0 w 508168"/>
              <a:gd name="connsiteY6" fmla="*/ 627218 h 883479"/>
              <a:gd name="connsiteX7" fmla="*/ 4440 w 508168"/>
              <a:gd name="connsiteY7" fmla="*/ 262952 h 883479"/>
              <a:gd name="connsiteX8" fmla="*/ 23262 w 508168"/>
              <a:gd name="connsiteY8" fmla="*/ 41285 h 883479"/>
              <a:gd name="connsiteX0" fmla="*/ 23262 w 508168"/>
              <a:gd name="connsiteY0" fmla="*/ 41285 h 895403"/>
              <a:gd name="connsiteX1" fmla="*/ 167132 w 508168"/>
              <a:gd name="connsiteY1" fmla="*/ 12193 h 895403"/>
              <a:gd name="connsiteX2" fmla="*/ 413934 w 508168"/>
              <a:gd name="connsiteY2" fmla="*/ 79524 h 895403"/>
              <a:gd name="connsiteX3" fmla="*/ 508168 w 508168"/>
              <a:gd name="connsiteY3" fmla="*/ 315123 h 895403"/>
              <a:gd name="connsiteX4" fmla="*/ 481321 w 508168"/>
              <a:gd name="connsiteY4" fmla="*/ 644607 h 895403"/>
              <a:gd name="connsiteX5" fmla="*/ 64465 w 508168"/>
              <a:gd name="connsiteY5" fmla="*/ 876324 h 895403"/>
              <a:gd name="connsiteX6" fmla="*/ 0 w 508168"/>
              <a:gd name="connsiteY6" fmla="*/ 627218 h 895403"/>
              <a:gd name="connsiteX7" fmla="*/ 4440 w 508168"/>
              <a:gd name="connsiteY7" fmla="*/ 262952 h 895403"/>
              <a:gd name="connsiteX8" fmla="*/ 23262 w 508168"/>
              <a:gd name="connsiteY8" fmla="*/ 41285 h 8954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08168" h="895403">
                <a:moveTo>
                  <a:pt x="23262" y="41285"/>
                </a:moveTo>
                <a:cubicBezTo>
                  <a:pt x="47767" y="-5196"/>
                  <a:pt x="53576" y="-8610"/>
                  <a:pt x="167132" y="12193"/>
                </a:cubicBezTo>
                <a:cubicBezTo>
                  <a:pt x="265089" y="-1972"/>
                  <a:pt x="358135" y="24998"/>
                  <a:pt x="413934" y="79524"/>
                </a:cubicBezTo>
                <a:cubicBezTo>
                  <a:pt x="482782" y="166998"/>
                  <a:pt x="493153" y="223036"/>
                  <a:pt x="508168" y="315123"/>
                </a:cubicBezTo>
                <a:cubicBezTo>
                  <a:pt x="469843" y="465008"/>
                  <a:pt x="520274" y="553114"/>
                  <a:pt x="481321" y="644607"/>
                </a:cubicBezTo>
                <a:cubicBezTo>
                  <a:pt x="374612" y="849292"/>
                  <a:pt x="273995" y="937492"/>
                  <a:pt x="64465" y="876324"/>
                </a:cubicBezTo>
                <a:cubicBezTo>
                  <a:pt x="41205" y="846554"/>
                  <a:pt x="37994" y="789583"/>
                  <a:pt x="0" y="627218"/>
                </a:cubicBezTo>
                <a:cubicBezTo>
                  <a:pt x="38623" y="427635"/>
                  <a:pt x="-1171" y="420715"/>
                  <a:pt x="4440" y="262952"/>
                </a:cubicBezTo>
                <a:cubicBezTo>
                  <a:pt x="48451" y="153631"/>
                  <a:pt x="23682" y="123527"/>
                  <a:pt x="23262" y="41285"/>
                </a:cubicBezTo>
                <a:close/>
              </a:path>
            </a:pathLst>
          </a:custGeom>
          <a:noFill/>
          <a:ln w="28575">
            <a:solidFill>
              <a:srgbClr val="00206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フリーフォーム: 図形 49">
            <a:extLst>
              <a:ext uri="{FF2B5EF4-FFF2-40B4-BE49-F238E27FC236}">
                <a16:creationId xmlns:a16="http://schemas.microsoft.com/office/drawing/2014/main" id="{0D728C2B-5F96-4E98-9A51-BD4A8D1A0BAE}"/>
              </a:ext>
            </a:extLst>
          </p:cNvPr>
          <p:cNvSpPr/>
          <p:nvPr/>
        </p:nvSpPr>
        <p:spPr>
          <a:xfrm flipH="1">
            <a:off x="4709896" y="2201971"/>
            <a:ext cx="612614" cy="830835"/>
          </a:xfrm>
          <a:custGeom>
            <a:avLst/>
            <a:gdLst>
              <a:gd name="connsiteX0" fmla="*/ 94735 w 580767"/>
              <a:gd name="connsiteY0" fmla="*/ 12357 h 1000897"/>
              <a:gd name="connsiteX1" fmla="*/ 218303 w 580767"/>
              <a:gd name="connsiteY1" fmla="*/ 0 h 1000897"/>
              <a:gd name="connsiteX2" fmla="*/ 354227 w 580767"/>
              <a:gd name="connsiteY2" fmla="*/ 8238 h 1000897"/>
              <a:gd name="connsiteX3" fmla="*/ 543697 w 580767"/>
              <a:gd name="connsiteY3" fmla="*/ 205946 h 1000897"/>
              <a:gd name="connsiteX4" fmla="*/ 580767 w 580767"/>
              <a:gd name="connsiteY4" fmla="*/ 543697 h 1000897"/>
              <a:gd name="connsiteX5" fmla="*/ 481913 w 580767"/>
              <a:gd name="connsiteY5" fmla="*/ 807308 h 1000897"/>
              <a:gd name="connsiteX6" fmla="*/ 275967 w 580767"/>
              <a:gd name="connsiteY6" fmla="*/ 1000897 h 1000897"/>
              <a:gd name="connsiteX7" fmla="*/ 86497 w 580767"/>
              <a:gd name="connsiteY7" fmla="*/ 992660 h 1000897"/>
              <a:gd name="connsiteX8" fmla="*/ 28832 w 580767"/>
              <a:gd name="connsiteY8" fmla="*/ 951470 h 1000897"/>
              <a:gd name="connsiteX9" fmla="*/ 0 w 580767"/>
              <a:gd name="connsiteY9" fmla="*/ 659027 h 1000897"/>
              <a:gd name="connsiteX10" fmla="*/ 74140 w 580767"/>
              <a:gd name="connsiteY10" fmla="*/ 399535 h 1000897"/>
              <a:gd name="connsiteX11" fmla="*/ 57665 w 580767"/>
              <a:gd name="connsiteY11" fmla="*/ 156519 h 1000897"/>
              <a:gd name="connsiteX12" fmla="*/ 94735 w 580767"/>
              <a:gd name="connsiteY12" fmla="*/ 12357 h 1000897"/>
              <a:gd name="connsiteX0" fmla="*/ 94735 w 580767"/>
              <a:gd name="connsiteY0" fmla="*/ 12357 h 1000897"/>
              <a:gd name="connsiteX1" fmla="*/ 218303 w 580767"/>
              <a:gd name="connsiteY1" fmla="*/ 0 h 1000897"/>
              <a:gd name="connsiteX2" fmla="*/ 354227 w 580767"/>
              <a:gd name="connsiteY2" fmla="*/ 8238 h 1000897"/>
              <a:gd name="connsiteX3" fmla="*/ 543697 w 580767"/>
              <a:gd name="connsiteY3" fmla="*/ 205946 h 1000897"/>
              <a:gd name="connsiteX4" fmla="*/ 580767 w 580767"/>
              <a:gd name="connsiteY4" fmla="*/ 543697 h 1000897"/>
              <a:gd name="connsiteX5" fmla="*/ 481913 w 580767"/>
              <a:gd name="connsiteY5" fmla="*/ 807308 h 1000897"/>
              <a:gd name="connsiteX6" fmla="*/ 275967 w 580767"/>
              <a:gd name="connsiteY6" fmla="*/ 1000897 h 1000897"/>
              <a:gd name="connsiteX7" fmla="*/ 86497 w 580767"/>
              <a:gd name="connsiteY7" fmla="*/ 992660 h 1000897"/>
              <a:gd name="connsiteX8" fmla="*/ 28832 w 580767"/>
              <a:gd name="connsiteY8" fmla="*/ 951470 h 1000897"/>
              <a:gd name="connsiteX9" fmla="*/ 0 w 580767"/>
              <a:gd name="connsiteY9" fmla="*/ 659027 h 1000897"/>
              <a:gd name="connsiteX10" fmla="*/ 74140 w 580767"/>
              <a:gd name="connsiteY10" fmla="*/ 399535 h 1000897"/>
              <a:gd name="connsiteX11" fmla="*/ 57665 w 580767"/>
              <a:gd name="connsiteY11" fmla="*/ 156519 h 1000897"/>
              <a:gd name="connsiteX12" fmla="*/ 94735 w 580767"/>
              <a:gd name="connsiteY12" fmla="*/ 12357 h 1000897"/>
              <a:gd name="connsiteX0" fmla="*/ 94735 w 580767"/>
              <a:gd name="connsiteY0" fmla="*/ 4119 h 992659"/>
              <a:gd name="connsiteX1" fmla="*/ 354227 w 580767"/>
              <a:gd name="connsiteY1" fmla="*/ 0 h 992659"/>
              <a:gd name="connsiteX2" fmla="*/ 543697 w 580767"/>
              <a:gd name="connsiteY2" fmla="*/ 197708 h 992659"/>
              <a:gd name="connsiteX3" fmla="*/ 580767 w 580767"/>
              <a:gd name="connsiteY3" fmla="*/ 535459 h 992659"/>
              <a:gd name="connsiteX4" fmla="*/ 481913 w 580767"/>
              <a:gd name="connsiteY4" fmla="*/ 799070 h 992659"/>
              <a:gd name="connsiteX5" fmla="*/ 275967 w 580767"/>
              <a:gd name="connsiteY5" fmla="*/ 992659 h 992659"/>
              <a:gd name="connsiteX6" fmla="*/ 86497 w 580767"/>
              <a:gd name="connsiteY6" fmla="*/ 984422 h 992659"/>
              <a:gd name="connsiteX7" fmla="*/ 28832 w 580767"/>
              <a:gd name="connsiteY7" fmla="*/ 943232 h 992659"/>
              <a:gd name="connsiteX8" fmla="*/ 0 w 580767"/>
              <a:gd name="connsiteY8" fmla="*/ 650789 h 992659"/>
              <a:gd name="connsiteX9" fmla="*/ 74140 w 580767"/>
              <a:gd name="connsiteY9" fmla="*/ 391297 h 992659"/>
              <a:gd name="connsiteX10" fmla="*/ 57665 w 580767"/>
              <a:gd name="connsiteY10" fmla="*/ 148281 h 992659"/>
              <a:gd name="connsiteX11" fmla="*/ 94735 w 580767"/>
              <a:gd name="connsiteY11" fmla="*/ 4119 h 992659"/>
              <a:gd name="connsiteX0" fmla="*/ 94735 w 580767"/>
              <a:gd name="connsiteY0" fmla="*/ 0 h 988540"/>
              <a:gd name="connsiteX1" fmla="*/ 543697 w 580767"/>
              <a:gd name="connsiteY1" fmla="*/ 193589 h 988540"/>
              <a:gd name="connsiteX2" fmla="*/ 580767 w 580767"/>
              <a:gd name="connsiteY2" fmla="*/ 531340 h 988540"/>
              <a:gd name="connsiteX3" fmla="*/ 481913 w 580767"/>
              <a:gd name="connsiteY3" fmla="*/ 794951 h 988540"/>
              <a:gd name="connsiteX4" fmla="*/ 275967 w 580767"/>
              <a:gd name="connsiteY4" fmla="*/ 988540 h 988540"/>
              <a:gd name="connsiteX5" fmla="*/ 86497 w 580767"/>
              <a:gd name="connsiteY5" fmla="*/ 980303 h 988540"/>
              <a:gd name="connsiteX6" fmla="*/ 28832 w 580767"/>
              <a:gd name="connsiteY6" fmla="*/ 939113 h 988540"/>
              <a:gd name="connsiteX7" fmla="*/ 0 w 580767"/>
              <a:gd name="connsiteY7" fmla="*/ 646670 h 988540"/>
              <a:gd name="connsiteX8" fmla="*/ 74140 w 580767"/>
              <a:gd name="connsiteY8" fmla="*/ 387178 h 988540"/>
              <a:gd name="connsiteX9" fmla="*/ 57665 w 580767"/>
              <a:gd name="connsiteY9" fmla="*/ 144162 h 988540"/>
              <a:gd name="connsiteX10" fmla="*/ 94735 w 580767"/>
              <a:gd name="connsiteY10" fmla="*/ 0 h 988540"/>
              <a:gd name="connsiteX0" fmla="*/ 94735 w 580767"/>
              <a:gd name="connsiteY0" fmla="*/ 0 h 988540"/>
              <a:gd name="connsiteX1" fmla="*/ 543697 w 580767"/>
              <a:gd name="connsiteY1" fmla="*/ 193589 h 988540"/>
              <a:gd name="connsiteX2" fmla="*/ 580767 w 580767"/>
              <a:gd name="connsiteY2" fmla="*/ 531340 h 988540"/>
              <a:gd name="connsiteX3" fmla="*/ 481913 w 580767"/>
              <a:gd name="connsiteY3" fmla="*/ 794951 h 988540"/>
              <a:gd name="connsiteX4" fmla="*/ 275967 w 580767"/>
              <a:gd name="connsiteY4" fmla="*/ 988540 h 988540"/>
              <a:gd name="connsiteX5" fmla="*/ 86497 w 580767"/>
              <a:gd name="connsiteY5" fmla="*/ 980303 h 988540"/>
              <a:gd name="connsiteX6" fmla="*/ 28832 w 580767"/>
              <a:gd name="connsiteY6" fmla="*/ 939113 h 988540"/>
              <a:gd name="connsiteX7" fmla="*/ 0 w 580767"/>
              <a:gd name="connsiteY7" fmla="*/ 646670 h 988540"/>
              <a:gd name="connsiteX8" fmla="*/ 74140 w 580767"/>
              <a:gd name="connsiteY8" fmla="*/ 387178 h 988540"/>
              <a:gd name="connsiteX9" fmla="*/ 94735 w 580767"/>
              <a:gd name="connsiteY9" fmla="*/ 0 h 988540"/>
              <a:gd name="connsiteX0" fmla="*/ 94735 w 580767"/>
              <a:gd name="connsiteY0" fmla="*/ 13845 h 1002385"/>
              <a:gd name="connsiteX1" fmla="*/ 543697 w 580767"/>
              <a:gd name="connsiteY1" fmla="*/ 207434 h 1002385"/>
              <a:gd name="connsiteX2" fmla="*/ 580767 w 580767"/>
              <a:gd name="connsiteY2" fmla="*/ 545185 h 1002385"/>
              <a:gd name="connsiteX3" fmla="*/ 481913 w 580767"/>
              <a:gd name="connsiteY3" fmla="*/ 808796 h 1002385"/>
              <a:gd name="connsiteX4" fmla="*/ 275967 w 580767"/>
              <a:gd name="connsiteY4" fmla="*/ 1002385 h 1002385"/>
              <a:gd name="connsiteX5" fmla="*/ 86497 w 580767"/>
              <a:gd name="connsiteY5" fmla="*/ 994148 h 1002385"/>
              <a:gd name="connsiteX6" fmla="*/ 28832 w 580767"/>
              <a:gd name="connsiteY6" fmla="*/ 952958 h 1002385"/>
              <a:gd name="connsiteX7" fmla="*/ 0 w 580767"/>
              <a:gd name="connsiteY7" fmla="*/ 660515 h 1002385"/>
              <a:gd name="connsiteX8" fmla="*/ 74140 w 580767"/>
              <a:gd name="connsiteY8" fmla="*/ 401023 h 1002385"/>
              <a:gd name="connsiteX9" fmla="*/ 94735 w 580767"/>
              <a:gd name="connsiteY9" fmla="*/ 13845 h 1002385"/>
              <a:gd name="connsiteX0" fmla="*/ 94735 w 580767"/>
              <a:gd name="connsiteY0" fmla="*/ 9562 h 998102"/>
              <a:gd name="connsiteX1" fmla="*/ 576648 w 580767"/>
              <a:gd name="connsiteY1" fmla="*/ 314362 h 998102"/>
              <a:gd name="connsiteX2" fmla="*/ 580767 w 580767"/>
              <a:gd name="connsiteY2" fmla="*/ 540902 h 998102"/>
              <a:gd name="connsiteX3" fmla="*/ 481913 w 580767"/>
              <a:gd name="connsiteY3" fmla="*/ 804513 h 998102"/>
              <a:gd name="connsiteX4" fmla="*/ 275967 w 580767"/>
              <a:gd name="connsiteY4" fmla="*/ 998102 h 998102"/>
              <a:gd name="connsiteX5" fmla="*/ 86497 w 580767"/>
              <a:gd name="connsiteY5" fmla="*/ 989865 h 998102"/>
              <a:gd name="connsiteX6" fmla="*/ 28832 w 580767"/>
              <a:gd name="connsiteY6" fmla="*/ 948675 h 998102"/>
              <a:gd name="connsiteX7" fmla="*/ 0 w 580767"/>
              <a:gd name="connsiteY7" fmla="*/ 656232 h 998102"/>
              <a:gd name="connsiteX8" fmla="*/ 74140 w 580767"/>
              <a:gd name="connsiteY8" fmla="*/ 396740 h 998102"/>
              <a:gd name="connsiteX9" fmla="*/ 94735 w 580767"/>
              <a:gd name="connsiteY9" fmla="*/ 9562 h 998102"/>
              <a:gd name="connsiteX0" fmla="*/ 94735 w 580767"/>
              <a:gd name="connsiteY0" fmla="*/ 18277 h 1006817"/>
              <a:gd name="connsiteX1" fmla="*/ 576648 w 580767"/>
              <a:gd name="connsiteY1" fmla="*/ 323077 h 1006817"/>
              <a:gd name="connsiteX2" fmla="*/ 580767 w 580767"/>
              <a:gd name="connsiteY2" fmla="*/ 549617 h 1006817"/>
              <a:gd name="connsiteX3" fmla="*/ 481913 w 580767"/>
              <a:gd name="connsiteY3" fmla="*/ 813228 h 1006817"/>
              <a:gd name="connsiteX4" fmla="*/ 275967 w 580767"/>
              <a:gd name="connsiteY4" fmla="*/ 1006817 h 1006817"/>
              <a:gd name="connsiteX5" fmla="*/ 86497 w 580767"/>
              <a:gd name="connsiteY5" fmla="*/ 998580 h 1006817"/>
              <a:gd name="connsiteX6" fmla="*/ 28832 w 580767"/>
              <a:gd name="connsiteY6" fmla="*/ 957390 h 1006817"/>
              <a:gd name="connsiteX7" fmla="*/ 0 w 580767"/>
              <a:gd name="connsiteY7" fmla="*/ 664947 h 1006817"/>
              <a:gd name="connsiteX8" fmla="*/ 74140 w 580767"/>
              <a:gd name="connsiteY8" fmla="*/ 405455 h 1006817"/>
              <a:gd name="connsiteX9" fmla="*/ 94735 w 580767"/>
              <a:gd name="connsiteY9" fmla="*/ 18277 h 1006817"/>
              <a:gd name="connsiteX0" fmla="*/ 94735 w 576648"/>
              <a:gd name="connsiteY0" fmla="*/ 18277 h 1006817"/>
              <a:gd name="connsiteX1" fmla="*/ 576648 w 576648"/>
              <a:gd name="connsiteY1" fmla="*/ 323077 h 1006817"/>
              <a:gd name="connsiteX2" fmla="*/ 481913 w 576648"/>
              <a:gd name="connsiteY2" fmla="*/ 813228 h 1006817"/>
              <a:gd name="connsiteX3" fmla="*/ 275967 w 576648"/>
              <a:gd name="connsiteY3" fmla="*/ 1006817 h 1006817"/>
              <a:gd name="connsiteX4" fmla="*/ 86497 w 576648"/>
              <a:gd name="connsiteY4" fmla="*/ 998580 h 1006817"/>
              <a:gd name="connsiteX5" fmla="*/ 28832 w 576648"/>
              <a:gd name="connsiteY5" fmla="*/ 957390 h 1006817"/>
              <a:gd name="connsiteX6" fmla="*/ 0 w 576648"/>
              <a:gd name="connsiteY6" fmla="*/ 664947 h 1006817"/>
              <a:gd name="connsiteX7" fmla="*/ 74140 w 576648"/>
              <a:gd name="connsiteY7" fmla="*/ 405455 h 1006817"/>
              <a:gd name="connsiteX8" fmla="*/ 94735 w 576648"/>
              <a:gd name="connsiteY8" fmla="*/ 18277 h 1006817"/>
              <a:gd name="connsiteX0" fmla="*/ 94735 w 576648"/>
              <a:gd name="connsiteY0" fmla="*/ 18277 h 1006817"/>
              <a:gd name="connsiteX1" fmla="*/ 576648 w 576648"/>
              <a:gd name="connsiteY1" fmla="*/ 323077 h 1006817"/>
              <a:gd name="connsiteX2" fmla="*/ 275967 w 576648"/>
              <a:gd name="connsiteY2" fmla="*/ 1006817 h 1006817"/>
              <a:gd name="connsiteX3" fmla="*/ 86497 w 576648"/>
              <a:gd name="connsiteY3" fmla="*/ 998580 h 1006817"/>
              <a:gd name="connsiteX4" fmla="*/ 28832 w 576648"/>
              <a:gd name="connsiteY4" fmla="*/ 957390 h 1006817"/>
              <a:gd name="connsiteX5" fmla="*/ 0 w 576648"/>
              <a:gd name="connsiteY5" fmla="*/ 664947 h 1006817"/>
              <a:gd name="connsiteX6" fmla="*/ 74140 w 576648"/>
              <a:gd name="connsiteY6" fmla="*/ 405455 h 1006817"/>
              <a:gd name="connsiteX7" fmla="*/ 94735 w 576648"/>
              <a:gd name="connsiteY7" fmla="*/ 18277 h 1006817"/>
              <a:gd name="connsiteX0" fmla="*/ 94735 w 576648"/>
              <a:gd name="connsiteY0" fmla="*/ 18277 h 998580"/>
              <a:gd name="connsiteX1" fmla="*/ 576648 w 576648"/>
              <a:gd name="connsiteY1" fmla="*/ 323077 h 998580"/>
              <a:gd name="connsiteX2" fmla="*/ 86497 w 576648"/>
              <a:gd name="connsiteY2" fmla="*/ 998580 h 998580"/>
              <a:gd name="connsiteX3" fmla="*/ 28832 w 576648"/>
              <a:gd name="connsiteY3" fmla="*/ 957390 h 998580"/>
              <a:gd name="connsiteX4" fmla="*/ 0 w 576648"/>
              <a:gd name="connsiteY4" fmla="*/ 664947 h 998580"/>
              <a:gd name="connsiteX5" fmla="*/ 74140 w 576648"/>
              <a:gd name="connsiteY5" fmla="*/ 405455 h 998580"/>
              <a:gd name="connsiteX6" fmla="*/ 94735 w 576648"/>
              <a:gd name="connsiteY6" fmla="*/ 18277 h 998580"/>
              <a:gd name="connsiteX0" fmla="*/ 94735 w 581310"/>
              <a:gd name="connsiteY0" fmla="*/ 18277 h 998580"/>
              <a:gd name="connsiteX1" fmla="*/ 576648 w 581310"/>
              <a:gd name="connsiteY1" fmla="*/ 323077 h 998580"/>
              <a:gd name="connsiteX2" fmla="*/ 86497 w 581310"/>
              <a:gd name="connsiteY2" fmla="*/ 998580 h 998580"/>
              <a:gd name="connsiteX3" fmla="*/ 28832 w 581310"/>
              <a:gd name="connsiteY3" fmla="*/ 957390 h 998580"/>
              <a:gd name="connsiteX4" fmla="*/ 0 w 581310"/>
              <a:gd name="connsiteY4" fmla="*/ 664947 h 998580"/>
              <a:gd name="connsiteX5" fmla="*/ 74140 w 581310"/>
              <a:gd name="connsiteY5" fmla="*/ 405455 h 998580"/>
              <a:gd name="connsiteX6" fmla="*/ 94735 w 581310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28832 w 583521"/>
              <a:gd name="connsiteY3" fmla="*/ 957390 h 998580"/>
              <a:gd name="connsiteX4" fmla="*/ 0 w 583521"/>
              <a:gd name="connsiteY4" fmla="*/ 664947 h 998580"/>
              <a:gd name="connsiteX5" fmla="*/ 74140 w 583521"/>
              <a:gd name="connsiteY5" fmla="*/ 405455 h 998580"/>
              <a:gd name="connsiteX6" fmla="*/ 94735 w 583521"/>
              <a:gd name="connsiteY6" fmla="*/ 18277 h 998580"/>
              <a:gd name="connsiteX0" fmla="*/ 94735 w 583521"/>
              <a:gd name="connsiteY0" fmla="*/ 18277 h 998580"/>
              <a:gd name="connsiteX1" fmla="*/ 576648 w 583521"/>
              <a:gd name="connsiteY1" fmla="*/ 323077 h 998580"/>
              <a:gd name="connsiteX2" fmla="*/ 86497 w 583521"/>
              <a:gd name="connsiteY2" fmla="*/ 998580 h 998580"/>
              <a:gd name="connsiteX3" fmla="*/ 0 w 583521"/>
              <a:gd name="connsiteY3" fmla="*/ 664947 h 998580"/>
              <a:gd name="connsiteX4" fmla="*/ 74140 w 583521"/>
              <a:gd name="connsiteY4" fmla="*/ 405455 h 998580"/>
              <a:gd name="connsiteX5" fmla="*/ 94735 w 583521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65902 w 575283"/>
              <a:gd name="connsiteY4" fmla="*/ 405455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86497 w 575283"/>
              <a:gd name="connsiteY0" fmla="*/ 18277 h 998580"/>
              <a:gd name="connsiteX1" fmla="*/ 568410 w 575283"/>
              <a:gd name="connsiteY1" fmla="*/ 323077 h 998580"/>
              <a:gd name="connsiteX2" fmla="*/ 78259 w 575283"/>
              <a:gd name="connsiteY2" fmla="*/ 998580 h 998580"/>
              <a:gd name="connsiteX3" fmla="*/ 0 w 575283"/>
              <a:gd name="connsiteY3" fmla="*/ 718493 h 998580"/>
              <a:gd name="connsiteX4" fmla="*/ 49427 w 575283"/>
              <a:gd name="connsiteY4" fmla="*/ 207747 h 998580"/>
              <a:gd name="connsiteX5" fmla="*/ 86497 w 575283"/>
              <a:gd name="connsiteY5" fmla="*/ 18277 h 998580"/>
              <a:gd name="connsiteX0" fmla="*/ 119449 w 608235"/>
              <a:gd name="connsiteY0" fmla="*/ 18277 h 998580"/>
              <a:gd name="connsiteX1" fmla="*/ 601362 w 608235"/>
              <a:gd name="connsiteY1" fmla="*/ 323077 h 998580"/>
              <a:gd name="connsiteX2" fmla="*/ 111211 w 608235"/>
              <a:gd name="connsiteY2" fmla="*/ 998580 h 998580"/>
              <a:gd name="connsiteX3" fmla="*/ 32952 w 608235"/>
              <a:gd name="connsiteY3" fmla="*/ 718493 h 998580"/>
              <a:gd name="connsiteX4" fmla="*/ 0 w 608235"/>
              <a:gd name="connsiteY4" fmla="*/ 236579 h 998580"/>
              <a:gd name="connsiteX5" fmla="*/ 119449 w 608235"/>
              <a:gd name="connsiteY5" fmla="*/ 18277 h 998580"/>
              <a:gd name="connsiteX0" fmla="*/ 193590 w 608235"/>
              <a:gd name="connsiteY0" fmla="*/ 32415 h 913864"/>
              <a:gd name="connsiteX1" fmla="*/ 601362 w 608235"/>
              <a:gd name="connsiteY1" fmla="*/ 238361 h 913864"/>
              <a:gd name="connsiteX2" fmla="*/ 111211 w 608235"/>
              <a:gd name="connsiteY2" fmla="*/ 913864 h 913864"/>
              <a:gd name="connsiteX3" fmla="*/ 32952 w 608235"/>
              <a:gd name="connsiteY3" fmla="*/ 633777 h 913864"/>
              <a:gd name="connsiteX4" fmla="*/ 0 w 608235"/>
              <a:gd name="connsiteY4" fmla="*/ 151863 h 913864"/>
              <a:gd name="connsiteX5" fmla="*/ 193590 w 608235"/>
              <a:gd name="connsiteY5" fmla="*/ 32415 h 913864"/>
              <a:gd name="connsiteX0" fmla="*/ 193590 w 608235"/>
              <a:gd name="connsiteY0" fmla="*/ 0 h 881449"/>
              <a:gd name="connsiteX1" fmla="*/ 601362 w 608235"/>
              <a:gd name="connsiteY1" fmla="*/ 205946 h 881449"/>
              <a:gd name="connsiteX2" fmla="*/ 111211 w 608235"/>
              <a:gd name="connsiteY2" fmla="*/ 881449 h 881449"/>
              <a:gd name="connsiteX3" fmla="*/ 32952 w 608235"/>
              <a:gd name="connsiteY3" fmla="*/ 601362 h 881449"/>
              <a:gd name="connsiteX4" fmla="*/ 0 w 608235"/>
              <a:gd name="connsiteY4" fmla="*/ 119448 h 881449"/>
              <a:gd name="connsiteX5" fmla="*/ 193590 w 608235"/>
              <a:gd name="connsiteY5" fmla="*/ 0 h 881449"/>
              <a:gd name="connsiteX0" fmla="*/ 193590 w 608235"/>
              <a:gd name="connsiteY0" fmla="*/ 3183 h 884632"/>
              <a:gd name="connsiteX1" fmla="*/ 601362 w 608235"/>
              <a:gd name="connsiteY1" fmla="*/ 209129 h 884632"/>
              <a:gd name="connsiteX2" fmla="*/ 111211 w 608235"/>
              <a:gd name="connsiteY2" fmla="*/ 884632 h 884632"/>
              <a:gd name="connsiteX3" fmla="*/ 32952 w 608235"/>
              <a:gd name="connsiteY3" fmla="*/ 604545 h 884632"/>
              <a:gd name="connsiteX4" fmla="*/ 0 w 608235"/>
              <a:gd name="connsiteY4" fmla="*/ 122631 h 884632"/>
              <a:gd name="connsiteX5" fmla="*/ 193590 w 608235"/>
              <a:gd name="connsiteY5" fmla="*/ 3183 h 88463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32952 w 609758"/>
              <a:gd name="connsiteY3" fmla="*/ 604545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65903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65903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65903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65903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193590 w 609758"/>
              <a:gd name="connsiteY0" fmla="*/ 3183 h 847562"/>
              <a:gd name="connsiteX1" fmla="*/ 601362 w 609758"/>
              <a:gd name="connsiteY1" fmla="*/ 209129 h 847562"/>
              <a:gd name="connsiteX2" fmla="*/ 164757 w 609758"/>
              <a:gd name="connsiteY2" fmla="*/ 847562 h 847562"/>
              <a:gd name="connsiteX3" fmla="*/ 50488 w 609758"/>
              <a:gd name="connsiteY3" fmla="*/ 583950 h 847562"/>
              <a:gd name="connsiteX4" fmla="*/ 0 w 609758"/>
              <a:gd name="connsiteY4" fmla="*/ 122631 h 847562"/>
              <a:gd name="connsiteX5" fmla="*/ 193590 w 609758"/>
              <a:gd name="connsiteY5" fmla="*/ 3183 h 847562"/>
              <a:gd name="connsiteX0" fmla="*/ 215173 w 631341"/>
              <a:gd name="connsiteY0" fmla="*/ 2882 h 847261"/>
              <a:gd name="connsiteX1" fmla="*/ 622945 w 631341"/>
              <a:gd name="connsiteY1" fmla="*/ 208828 h 847261"/>
              <a:gd name="connsiteX2" fmla="*/ 186340 w 631341"/>
              <a:gd name="connsiteY2" fmla="*/ 847261 h 847261"/>
              <a:gd name="connsiteX3" fmla="*/ 72071 w 631341"/>
              <a:gd name="connsiteY3" fmla="*/ 583649 h 847261"/>
              <a:gd name="connsiteX4" fmla="*/ 0 w 631341"/>
              <a:gd name="connsiteY4" fmla="*/ 128496 h 847261"/>
              <a:gd name="connsiteX5" fmla="*/ 215173 w 631341"/>
              <a:gd name="connsiteY5" fmla="*/ 2882 h 847261"/>
              <a:gd name="connsiteX0" fmla="*/ 215173 w 631341"/>
              <a:gd name="connsiteY0" fmla="*/ 2882 h 847261"/>
              <a:gd name="connsiteX1" fmla="*/ 622945 w 631341"/>
              <a:gd name="connsiteY1" fmla="*/ 208828 h 847261"/>
              <a:gd name="connsiteX2" fmla="*/ 186340 w 631341"/>
              <a:gd name="connsiteY2" fmla="*/ 847261 h 847261"/>
              <a:gd name="connsiteX3" fmla="*/ 72071 w 631341"/>
              <a:gd name="connsiteY3" fmla="*/ 583649 h 847261"/>
              <a:gd name="connsiteX4" fmla="*/ 0 w 631341"/>
              <a:gd name="connsiteY4" fmla="*/ 128496 h 847261"/>
              <a:gd name="connsiteX5" fmla="*/ 215173 w 631341"/>
              <a:gd name="connsiteY5" fmla="*/ 2882 h 847261"/>
              <a:gd name="connsiteX0" fmla="*/ 209006 w 631341"/>
              <a:gd name="connsiteY0" fmla="*/ 2628 h 853174"/>
              <a:gd name="connsiteX1" fmla="*/ 622945 w 631341"/>
              <a:gd name="connsiteY1" fmla="*/ 214741 h 853174"/>
              <a:gd name="connsiteX2" fmla="*/ 186340 w 631341"/>
              <a:gd name="connsiteY2" fmla="*/ 853174 h 853174"/>
              <a:gd name="connsiteX3" fmla="*/ 72071 w 631341"/>
              <a:gd name="connsiteY3" fmla="*/ 589562 h 853174"/>
              <a:gd name="connsiteX4" fmla="*/ 0 w 631341"/>
              <a:gd name="connsiteY4" fmla="*/ 134409 h 853174"/>
              <a:gd name="connsiteX5" fmla="*/ 209006 w 631341"/>
              <a:gd name="connsiteY5" fmla="*/ 2628 h 853174"/>
              <a:gd name="connsiteX0" fmla="*/ 209006 w 632494"/>
              <a:gd name="connsiteY0" fmla="*/ 2628 h 826397"/>
              <a:gd name="connsiteX1" fmla="*/ 622945 w 632494"/>
              <a:gd name="connsiteY1" fmla="*/ 214741 h 826397"/>
              <a:gd name="connsiteX2" fmla="*/ 216092 w 632494"/>
              <a:gd name="connsiteY2" fmla="*/ 826397 h 826397"/>
              <a:gd name="connsiteX3" fmla="*/ 72071 w 632494"/>
              <a:gd name="connsiteY3" fmla="*/ 589562 h 826397"/>
              <a:gd name="connsiteX4" fmla="*/ 0 w 632494"/>
              <a:gd name="connsiteY4" fmla="*/ 134409 h 826397"/>
              <a:gd name="connsiteX5" fmla="*/ 209006 w 632494"/>
              <a:gd name="connsiteY5" fmla="*/ 2628 h 826397"/>
              <a:gd name="connsiteX0" fmla="*/ 209006 w 632494"/>
              <a:gd name="connsiteY0" fmla="*/ 2628 h 826397"/>
              <a:gd name="connsiteX1" fmla="*/ 622945 w 632494"/>
              <a:gd name="connsiteY1" fmla="*/ 214741 h 826397"/>
              <a:gd name="connsiteX2" fmla="*/ 216092 w 632494"/>
              <a:gd name="connsiteY2" fmla="*/ 826397 h 826397"/>
              <a:gd name="connsiteX3" fmla="*/ 75046 w 632494"/>
              <a:gd name="connsiteY3" fmla="*/ 536008 h 826397"/>
              <a:gd name="connsiteX4" fmla="*/ 0 w 632494"/>
              <a:gd name="connsiteY4" fmla="*/ 134409 h 826397"/>
              <a:gd name="connsiteX5" fmla="*/ 209006 w 632494"/>
              <a:gd name="connsiteY5" fmla="*/ 2628 h 826397"/>
              <a:gd name="connsiteX0" fmla="*/ 209006 w 632494"/>
              <a:gd name="connsiteY0" fmla="*/ 2628 h 826397"/>
              <a:gd name="connsiteX1" fmla="*/ 622945 w 632494"/>
              <a:gd name="connsiteY1" fmla="*/ 214741 h 826397"/>
              <a:gd name="connsiteX2" fmla="*/ 216092 w 632494"/>
              <a:gd name="connsiteY2" fmla="*/ 826397 h 826397"/>
              <a:gd name="connsiteX3" fmla="*/ 75046 w 632494"/>
              <a:gd name="connsiteY3" fmla="*/ 536008 h 826397"/>
              <a:gd name="connsiteX4" fmla="*/ 0 w 632494"/>
              <a:gd name="connsiteY4" fmla="*/ 134409 h 826397"/>
              <a:gd name="connsiteX5" fmla="*/ 209006 w 632494"/>
              <a:gd name="connsiteY5" fmla="*/ 2628 h 826397"/>
              <a:gd name="connsiteX0" fmla="*/ 209006 w 632494"/>
              <a:gd name="connsiteY0" fmla="*/ 2628 h 826397"/>
              <a:gd name="connsiteX1" fmla="*/ 622945 w 632494"/>
              <a:gd name="connsiteY1" fmla="*/ 214741 h 826397"/>
              <a:gd name="connsiteX2" fmla="*/ 216092 w 632494"/>
              <a:gd name="connsiteY2" fmla="*/ 826397 h 826397"/>
              <a:gd name="connsiteX3" fmla="*/ 75046 w 632494"/>
              <a:gd name="connsiteY3" fmla="*/ 536008 h 826397"/>
              <a:gd name="connsiteX4" fmla="*/ 0 w 632494"/>
              <a:gd name="connsiteY4" fmla="*/ 134409 h 826397"/>
              <a:gd name="connsiteX5" fmla="*/ 209006 w 632494"/>
              <a:gd name="connsiteY5" fmla="*/ 2628 h 826397"/>
              <a:gd name="connsiteX0" fmla="*/ 209006 w 632494"/>
              <a:gd name="connsiteY0" fmla="*/ 0 h 823769"/>
              <a:gd name="connsiteX1" fmla="*/ 622945 w 632494"/>
              <a:gd name="connsiteY1" fmla="*/ 212113 h 823769"/>
              <a:gd name="connsiteX2" fmla="*/ 216092 w 632494"/>
              <a:gd name="connsiteY2" fmla="*/ 823769 h 823769"/>
              <a:gd name="connsiteX3" fmla="*/ 75046 w 632494"/>
              <a:gd name="connsiteY3" fmla="*/ 533380 h 823769"/>
              <a:gd name="connsiteX4" fmla="*/ 0 w 632494"/>
              <a:gd name="connsiteY4" fmla="*/ 131781 h 823769"/>
              <a:gd name="connsiteX5" fmla="*/ 209006 w 632494"/>
              <a:gd name="connsiteY5" fmla="*/ 0 h 823769"/>
              <a:gd name="connsiteX0" fmla="*/ 200081 w 632494"/>
              <a:gd name="connsiteY0" fmla="*/ 0 h 811868"/>
              <a:gd name="connsiteX1" fmla="*/ 622945 w 632494"/>
              <a:gd name="connsiteY1" fmla="*/ 200212 h 811868"/>
              <a:gd name="connsiteX2" fmla="*/ 216092 w 632494"/>
              <a:gd name="connsiteY2" fmla="*/ 811868 h 811868"/>
              <a:gd name="connsiteX3" fmla="*/ 75046 w 632494"/>
              <a:gd name="connsiteY3" fmla="*/ 521479 h 811868"/>
              <a:gd name="connsiteX4" fmla="*/ 0 w 632494"/>
              <a:gd name="connsiteY4" fmla="*/ 119880 h 811868"/>
              <a:gd name="connsiteX5" fmla="*/ 200081 w 632494"/>
              <a:gd name="connsiteY5" fmla="*/ 0 h 811868"/>
              <a:gd name="connsiteX0" fmla="*/ 200081 w 632494"/>
              <a:gd name="connsiteY0" fmla="*/ 0 h 811868"/>
              <a:gd name="connsiteX1" fmla="*/ 622945 w 632494"/>
              <a:gd name="connsiteY1" fmla="*/ 200212 h 811868"/>
              <a:gd name="connsiteX2" fmla="*/ 216092 w 632494"/>
              <a:gd name="connsiteY2" fmla="*/ 811868 h 811868"/>
              <a:gd name="connsiteX3" fmla="*/ 75046 w 632494"/>
              <a:gd name="connsiteY3" fmla="*/ 521479 h 811868"/>
              <a:gd name="connsiteX4" fmla="*/ 0 w 632494"/>
              <a:gd name="connsiteY4" fmla="*/ 119880 h 811868"/>
              <a:gd name="connsiteX5" fmla="*/ 200081 w 632494"/>
              <a:gd name="connsiteY5" fmla="*/ 0 h 811868"/>
              <a:gd name="connsiteX0" fmla="*/ 200081 w 632494"/>
              <a:gd name="connsiteY0" fmla="*/ 0 h 811868"/>
              <a:gd name="connsiteX1" fmla="*/ 622945 w 632494"/>
              <a:gd name="connsiteY1" fmla="*/ 200212 h 811868"/>
              <a:gd name="connsiteX2" fmla="*/ 216092 w 632494"/>
              <a:gd name="connsiteY2" fmla="*/ 811868 h 811868"/>
              <a:gd name="connsiteX3" fmla="*/ 75046 w 632494"/>
              <a:gd name="connsiteY3" fmla="*/ 521479 h 811868"/>
              <a:gd name="connsiteX4" fmla="*/ 0 w 632494"/>
              <a:gd name="connsiteY4" fmla="*/ 119880 h 811868"/>
              <a:gd name="connsiteX5" fmla="*/ 200081 w 632494"/>
              <a:gd name="connsiteY5" fmla="*/ 0 h 811868"/>
              <a:gd name="connsiteX0" fmla="*/ 200081 w 632494"/>
              <a:gd name="connsiteY0" fmla="*/ 0 h 796323"/>
              <a:gd name="connsiteX1" fmla="*/ 622945 w 632494"/>
              <a:gd name="connsiteY1" fmla="*/ 200212 h 796323"/>
              <a:gd name="connsiteX2" fmla="*/ 216092 w 632494"/>
              <a:gd name="connsiteY2" fmla="*/ 796323 h 796323"/>
              <a:gd name="connsiteX3" fmla="*/ 75046 w 632494"/>
              <a:gd name="connsiteY3" fmla="*/ 521479 h 796323"/>
              <a:gd name="connsiteX4" fmla="*/ 0 w 632494"/>
              <a:gd name="connsiteY4" fmla="*/ 119880 h 796323"/>
              <a:gd name="connsiteX5" fmla="*/ 200081 w 632494"/>
              <a:gd name="connsiteY5" fmla="*/ 0 h 796323"/>
              <a:gd name="connsiteX0" fmla="*/ 200081 w 579702"/>
              <a:gd name="connsiteY0" fmla="*/ 0 h 796323"/>
              <a:gd name="connsiteX1" fmla="*/ 566983 w 579702"/>
              <a:gd name="connsiteY1" fmla="*/ 249955 h 796323"/>
              <a:gd name="connsiteX2" fmla="*/ 216092 w 579702"/>
              <a:gd name="connsiteY2" fmla="*/ 796323 h 796323"/>
              <a:gd name="connsiteX3" fmla="*/ 75046 w 579702"/>
              <a:gd name="connsiteY3" fmla="*/ 521479 h 796323"/>
              <a:gd name="connsiteX4" fmla="*/ 0 w 579702"/>
              <a:gd name="connsiteY4" fmla="*/ 119880 h 796323"/>
              <a:gd name="connsiteX5" fmla="*/ 200081 w 579702"/>
              <a:gd name="connsiteY5" fmla="*/ 0 h 796323"/>
              <a:gd name="connsiteX0" fmla="*/ 196972 w 579702"/>
              <a:gd name="connsiteY0" fmla="*/ 0 h 749689"/>
              <a:gd name="connsiteX1" fmla="*/ 566983 w 579702"/>
              <a:gd name="connsiteY1" fmla="*/ 203321 h 749689"/>
              <a:gd name="connsiteX2" fmla="*/ 216092 w 579702"/>
              <a:gd name="connsiteY2" fmla="*/ 749689 h 749689"/>
              <a:gd name="connsiteX3" fmla="*/ 75046 w 579702"/>
              <a:gd name="connsiteY3" fmla="*/ 474845 h 749689"/>
              <a:gd name="connsiteX4" fmla="*/ 0 w 579702"/>
              <a:gd name="connsiteY4" fmla="*/ 73246 h 749689"/>
              <a:gd name="connsiteX5" fmla="*/ 196972 w 579702"/>
              <a:gd name="connsiteY5" fmla="*/ 0 h 749689"/>
              <a:gd name="connsiteX0" fmla="*/ 196972 w 579702"/>
              <a:gd name="connsiteY0" fmla="*/ 0 h 749689"/>
              <a:gd name="connsiteX1" fmla="*/ 566983 w 579702"/>
              <a:gd name="connsiteY1" fmla="*/ 203321 h 749689"/>
              <a:gd name="connsiteX2" fmla="*/ 216092 w 579702"/>
              <a:gd name="connsiteY2" fmla="*/ 749689 h 749689"/>
              <a:gd name="connsiteX3" fmla="*/ 75046 w 579702"/>
              <a:gd name="connsiteY3" fmla="*/ 474845 h 749689"/>
              <a:gd name="connsiteX4" fmla="*/ 0 w 579702"/>
              <a:gd name="connsiteY4" fmla="*/ 213149 h 749689"/>
              <a:gd name="connsiteX5" fmla="*/ 196972 w 579702"/>
              <a:gd name="connsiteY5" fmla="*/ 0 h 749689"/>
              <a:gd name="connsiteX0" fmla="*/ 196972 w 579702"/>
              <a:gd name="connsiteY0" fmla="*/ 0 h 749689"/>
              <a:gd name="connsiteX1" fmla="*/ 566983 w 579702"/>
              <a:gd name="connsiteY1" fmla="*/ 203321 h 749689"/>
              <a:gd name="connsiteX2" fmla="*/ 216092 w 579702"/>
              <a:gd name="connsiteY2" fmla="*/ 749689 h 749689"/>
              <a:gd name="connsiteX3" fmla="*/ 75046 w 579702"/>
              <a:gd name="connsiteY3" fmla="*/ 474845 h 749689"/>
              <a:gd name="connsiteX4" fmla="*/ 0 w 579702"/>
              <a:gd name="connsiteY4" fmla="*/ 213149 h 749689"/>
              <a:gd name="connsiteX5" fmla="*/ 196972 w 579702"/>
              <a:gd name="connsiteY5" fmla="*/ 0 h 749689"/>
              <a:gd name="connsiteX0" fmla="*/ 202965 w 585695"/>
              <a:gd name="connsiteY0" fmla="*/ 0 h 749689"/>
              <a:gd name="connsiteX1" fmla="*/ 572976 w 585695"/>
              <a:gd name="connsiteY1" fmla="*/ 203321 h 749689"/>
              <a:gd name="connsiteX2" fmla="*/ 222085 w 585695"/>
              <a:gd name="connsiteY2" fmla="*/ 749689 h 749689"/>
              <a:gd name="connsiteX3" fmla="*/ 81039 w 585695"/>
              <a:gd name="connsiteY3" fmla="*/ 474845 h 749689"/>
              <a:gd name="connsiteX4" fmla="*/ 5993 w 585695"/>
              <a:gd name="connsiteY4" fmla="*/ 213149 h 749689"/>
              <a:gd name="connsiteX5" fmla="*/ 202965 w 585695"/>
              <a:gd name="connsiteY5" fmla="*/ 0 h 749689"/>
              <a:gd name="connsiteX0" fmla="*/ 202965 w 585695"/>
              <a:gd name="connsiteY0" fmla="*/ 0 h 737253"/>
              <a:gd name="connsiteX1" fmla="*/ 572976 w 585695"/>
              <a:gd name="connsiteY1" fmla="*/ 190885 h 737253"/>
              <a:gd name="connsiteX2" fmla="*/ 222085 w 585695"/>
              <a:gd name="connsiteY2" fmla="*/ 737253 h 737253"/>
              <a:gd name="connsiteX3" fmla="*/ 81039 w 585695"/>
              <a:gd name="connsiteY3" fmla="*/ 462409 h 737253"/>
              <a:gd name="connsiteX4" fmla="*/ 5993 w 585695"/>
              <a:gd name="connsiteY4" fmla="*/ 200713 h 737253"/>
              <a:gd name="connsiteX5" fmla="*/ 202965 w 585695"/>
              <a:gd name="connsiteY5" fmla="*/ 0 h 737253"/>
              <a:gd name="connsiteX0" fmla="*/ 201990 w 584720"/>
              <a:gd name="connsiteY0" fmla="*/ 4231 h 741484"/>
              <a:gd name="connsiteX1" fmla="*/ 572001 w 584720"/>
              <a:gd name="connsiteY1" fmla="*/ 195116 h 741484"/>
              <a:gd name="connsiteX2" fmla="*/ 221110 w 584720"/>
              <a:gd name="connsiteY2" fmla="*/ 741484 h 741484"/>
              <a:gd name="connsiteX3" fmla="*/ 80064 w 584720"/>
              <a:gd name="connsiteY3" fmla="*/ 466640 h 741484"/>
              <a:gd name="connsiteX4" fmla="*/ 5018 w 584720"/>
              <a:gd name="connsiteY4" fmla="*/ 204944 h 741484"/>
              <a:gd name="connsiteX5" fmla="*/ 201990 w 584720"/>
              <a:gd name="connsiteY5" fmla="*/ 4231 h 741484"/>
              <a:gd name="connsiteX0" fmla="*/ 201990 w 584720"/>
              <a:gd name="connsiteY0" fmla="*/ 4231 h 741484"/>
              <a:gd name="connsiteX1" fmla="*/ 572001 w 584720"/>
              <a:gd name="connsiteY1" fmla="*/ 195116 h 741484"/>
              <a:gd name="connsiteX2" fmla="*/ 221110 w 584720"/>
              <a:gd name="connsiteY2" fmla="*/ 741484 h 741484"/>
              <a:gd name="connsiteX3" fmla="*/ 80064 w 584720"/>
              <a:gd name="connsiteY3" fmla="*/ 466640 h 741484"/>
              <a:gd name="connsiteX4" fmla="*/ 5018 w 584720"/>
              <a:gd name="connsiteY4" fmla="*/ 204944 h 741484"/>
              <a:gd name="connsiteX5" fmla="*/ 201990 w 584720"/>
              <a:gd name="connsiteY5" fmla="*/ 4231 h 741484"/>
              <a:gd name="connsiteX0" fmla="*/ 201990 w 584720"/>
              <a:gd name="connsiteY0" fmla="*/ 4231 h 741484"/>
              <a:gd name="connsiteX1" fmla="*/ 572001 w 584720"/>
              <a:gd name="connsiteY1" fmla="*/ 195116 h 741484"/>
              <a:gd name="connsiteX2" fmla="*/ 221110 w 584720"/>
              <a:gd name="connsiteY2" fmla="*/ 741484 h 741484"/>
              <a:gd name="connsiteX3" fmla="*/ 80064 w 584720"/>
              <a:gd name="connsiteY3" fmla="*/ 466640 h 741484"/>
              <a:gd name="connsiteX4" fmla="*/ 5018 w 584720"/>
              <a:gd name="connsiteY4" fmla="*/ 204944 h 741484"/>
              <a:gd name="connsiteX5" fmla="*/ 201990 w 584720"/>
              <a:gd name="connsiteY5" fmla="*/ 4231 h 741484"/>
              <a:gd name="connsiteX0" fmla="*/ 201990 w 585617"/>
              <a:gd name="connsiteY0" fmla="*/ 4231 h 742424"/>
              <a:gd name="connsiteX1" fmla="*/ 572001 w 585617"/>
              <a:gd name="connsiteY1" fmla="*/ 195116 h 742424"/>
              <a:gd name="connsiteX2" fmla="*/ 221110 w 585617"/>
              <a:gd name="connsiteY2" fmla="*/ 741484 h 742424"/>
              <a:gd name="connsiteX3" fmla="*/ 80064 w 585617"/>
              <a:gd name="connsiteY3" fmla="*/ 466640 h 742424"/>
              <a:gd name="connsiteX4" fmla="*/ 5018 w 585617"/>
              <a:gd name="connsiteY4" fmla="*/ 204944 h 742424"/>
              <a:gd name="connsiteX5" fmla="*/ 201990 w 585617"/>
              <a:gd name="connsiteY5" fmla="*/ 4231 h 742424"/>
              <a:gd name="connsiteX0" fmla="*/ 201990 w 585368"/>
              <a:gd name="connsiteY0" fmla="*/ 4231 h 730330"/>
              <a:gd name="connsiteX1" fmla="*/ 572001 w 585368"/>
              <a:gd name="connsiteY1" fmla="*/ 195116 h 730330"/>
              <a:gd name="connsiteX2" fmla="*/ 218001 w 585368"/>
              <a:gd name="connsiteY2" fmla="*/ 729048 h 730330"/>
              <a:gd name="connsiteX3" fmla="*/ 80064 w 585368"/>
              <a:gd name="connsiteY3" fmla="*/ 466640 h 730330"/>
              <a:gd name="connsiteX4" fmla="*/ 5018 w 585368"/>
              <a:gd name="connsiteY4" fmla="*/ 204944 h 730330"/>
              <a:gd name="connsiteX5" fmla="*/ 201990 w 585368"/>
              <a:gd name="connsiteY5" fmla="*/ 4231 h 730330"/>
              <a:gd name="connsiteX0" fmla="*/ 201990 w 584497"/>
              <a:gd name="connsiteY0" fmla="*/ 4231 h 736144"/>
              <a:gd name="connsiteX1" fmla="*/ 572001 w 584497"/>
              <a:gd name="connsiteY1" fmla="*/ 195116 h 736144"/>
              <a:gd name="connsiteX2" fmla="*/ 218001 w 584497"/>
              <a:gd name="connsiteY2" fmla="*/ 729048 h 736144"/>
              <a:gd name="connsiteX3" fmla="*/ 80064 w 584497"/>
              <a:gd name="connsiteY3" fmla="*/ 466640 h 736144"/>
              <a:gd name="connsiteX4" fmla="*/ 5018 w 584497"/>
              <a:gd name="connsiteY4" fmla="*/ 204944 h 736144"/>
              <a:gd name="connsiteX5" fmla="*/ 201990 w 584497"/>
              <a:gd name="connsiteY5" fmla="*/ 4231 h 736144"/>
              <a:gd name="connsiteX0" fmla="*/ 201990 w 584497"/>
              <a:gd name="connsiteY0" fmla="*/ 4231 h 736144"/>
              <a:gd name="connsiteX1" fmla="*/ 572001 w 584497"/>
              <a:gd name="connsiteY1" fmla="*/ 195116 h 736144"/>
              <a:gd name="connsiteX2" fmla="*/ 218001 w 584497"/>
              <a:gd name="connsiteY2" fmla="*/ 729048 h 736144"/>
              <a:gd name="connsiteX3" fmla="*/ 80064 w 584497"/>
              <a:gd name="connsiteY3" fmla="*/ 466640 h 736144"/>
              <a:gd name="connsiteX4" fmla="*/ 5018 w 584497"/>
              <a:gd name="connsiteY4" fmla="*/ 204944 h 736144"/>
              <a:gd name="connsiteX5" fmla="*/ 201990 w 584497"/>
              <a:gd name="connsiteY5" fmla="*/ 4231 h 736144"/>
              <a:gd name="connsiteX0" fmla="*/ 201990 w 584497"/>
              <a:gd name="connsiteY0" fmla="*/ 4231 h 736144"/>
              <a:gd name="connsiteX1" fmla="*/ 572001 w 584497"/>
              <a:gd name="connsiteY1" fmla="*/ 195116 h 736144"/>
              <a:gd name="connsiteX2" fmla="*/ 218001 w 584497"/>
              <a:gd name="connsiteY2" fmla="*/ 729048 h 736144"/>
              <a:gd name="connsiteX3" fmla="*/ 86282 w 584497"/>
              <a:gd name="connsiteY3" fmla="*/ 497729 h 736144"/>
              <a:gd name="connsiteX4" fmla="*/ 5018 w 584497"/>
              <a:gd name="connsiteY4" fmla="*/ 204944 h 736144"/>
              <a:gd name="connsiteX5" fmla="*/ 201990 w 584497"/>
              <a:gd name="connsiteY5" fmla="*/ 4231 h 736144"/>
              <a:gd name="connsiteX0" fmla="*/ 201990 w 584497"/>
              <a:gd name="connsiteY0" fmla="*/ 4231 h 736144"/>
              <a:gd name="connsiteX1" fmla="*/ 572001 w 584497"/>
              <a:gd name="connsiteY1" fmla="*/ 195116 h 736144"/>
              <a:gd name="connsiteX2" fmla="*/ 218001 w 584497"/>
              <a:gd name="connsiteY2" fmla="*/ 729048 h 736144"/>
              <a:gd name="connsiteX3" fmla="*/ 86282 w 584497"/>
              <a:gd name="connsiteY3" fmla="*/ 497729 h 736144"/>
              <a:gd name="connsiteX4" fmla="*/ 5018 w 584497"/>
              <a:gd name="connsiteY4" fmla="*/ 204944 h 736144"/>
              <a:gd name="connsiteX5" fmla="*/ 201990 w 584497"/>
              <a:gd name="connsiteY5" fmla="*/ 4231 h 736144"/>
              <a:gd name="connsiteX0" fmla="*/ 201990 w 584497"/>
              <a:gd name="connsiteY0" fmla="*/ 4231 h 736144"/>
              <a:gd name="connsiteX1" fmla="*/ 572001 w 584497"/>
              <a:gd name="connsiteY1" fmla="*/ 195116 h 736144"/>
              <a:gd name="connsiteX2" fmla="*/ 218001 w 584497"/>
              <a:gd name="connsiteY2" fmla="*/ 729048 h 736144"/>
              <a:gd name="connsiteX3" fmla="*/ 86282 w 584497"/>
              <a:gd name="connsiteY3" fmla="*/ 497729 h 736144"/>
              <a:gd name="connsiteX4" fmla="*/ 5018 w 584497"/>
              <a:gd name="connsiteY4" fmla="*/ 204944 h 736144"/>
              <a:gd name="connsiteX5" fmla="*/ 201990 w 584497"/>
              <a:gd name="connsiteY5" fmla="*/ 4231 h 736144"/>
              <a:gd name="connsiteX0" fmla="*/ 202439 w 584946"/>
              <a:gd name="connsiteY0" fmla="*/ 0 h 731913"/>
              <a:gd name="connsiteX1" fmla="*/ 572450 w 584946"/>
              <a:gd name="connsiteY1" fmla="*/ 190885 h 731913"/>
              <a:gd name="connsiteX2" fmla="*/ 218450 w 584946"/>
              <a:gd name="connsiteY2" fmla="*/ 724817 h 731913"/>
              <a:gd name="connsiteX3" fmla="*/ 86731 w 584946"/>
              <a:gd name="connsiteY3" fmla="*/ 493498 h 731913"/>
              <a:gd name="connsiteX4" fmla="*/ 5467 w 584946"/>
              <a:gd name="connsiteY4" fmla="*/ 200713 h 731913"/>
              <a:gd name="connsiteX5" fmla="*/ 202439 w 584946"/>
              <a:gd name="connsiteY5" fmla="*/ 0 h 731913"/>
              <a:gd name="connsiteX0" fmla="*/ 202439 w 584946"/>
              <a:gd name="connsiteY0" fmla="*/ 0 h 731913"/>
              <a:gd name="connsiteX1" fmla="*/ 572450 w 584946"/>
              <a:gd name="connsiteY1" fmla="*/ 190885 h 731913"/>
              <a:gd name="connsiteX2" fmla="*/ 218450 w 584946"/>
              <a:gd name="connsiteY2" fmla="*/ 724817 h 731913"/>
              <a:gd name="connsiteX3" fmla="*/ 86731 w 584946"/>
              <a:gd name="connsiteY3" fmla="*/ 493498 h 731913"/>
              <a:gd name="connsiteX4" fmla="*/ 5467 w 584946"/>
              <a:gd name="connsiteY4" fmla="*/ 200713 h 731913"/>
              <a:gd name="connsiteX5" fmla="*/ 202439 w 584946"/>
              <a:gd name="connsiteY5" fmla="*/ 0 h 731913"/>
              <a:gd name="connsiteX0" fmla="*/ 202439 w 584946"/>
              <a:gd name="connsiteY0" fmla="*/ 0 h 731913"/>
              <a:gd name="connsiteX1" fmla="*/ 572450 w 584946"/>
              <a:gd name="connsiteY1" fmla="*/ 190885 h 731913"/>
              <a:gd name="connsiteX2" fmla="*/ 218450 w 584946"/>
              <a:gd name="connsiteY2" fmla="*/ 724817 h 731913"/>
              <a:gd name="connsiteX3" fmla="*/ 86731 w 584946"/>
              <a:gd name="connsiteY3" fmla="*/ 493498 h 731913"/>
              <a:gd name="connsiteX4" fmla="*/ 5467 w 584946"/>
              <a:gd name="connsiteY4" fmla="*/ 200713 h 731913"/>
              <a:gd name="connsiteX5" fmla="*/ 202439 w 584946"/>
              <a:gd name="connsiteY5" fmla="*/ 0 h 731913"/>
              <a:gd name="connsiteX0" fmla="*/ 201990 w 584497"/>
              <a:gd name="connsiteY0" fmla="*/ 0 h 731913"/>
              <a:gd name="connsiteX1" fmla="*/ 572001 w 584497"/>
              <a:gd name="connsiteY1" fmla="*/ 190885 h 731913"/>
              <a:gd name="connsiteX2" fmla="*/ 218001 w 584497"/>
              <a:gd name="connsiteY2" fmla="*/ 724817 h 731913"/>
              <a:gd name="connsiteX3" fmla="*/ 86282 w 584497"/>
              <a:gd name="connsiteY3" fmla="*/ 493498 h 731913"/>
              <a:gd name="connsiteX4" fmla="*/ 5018 w 584497"/>
              <a:gd name="connsiteY4" fmla="*/ 200713 h 731913"/>
              <a:gd name="connsiteX5" fmla="*/ 201990 w 584497"/>
              <a:gd name="connsiteY5" fmla="*/ 0 h 731913"/>
              <a:gd name="connsiteX0" fmla="*/ 201990 w 584497"/>
              <a:gd name="connsiteY0" fmla="*/ 0 h 731913"/>
              <a:gd name="connsiteX1" fmla="*/ 572001 w 584497"/>
              <a:gd name="connsiteY1" fmla="*/ 190885 h 731913"/>
              <a:gd name="connsiteX2" fmla="*/ 218001 w 584497"/>
              <a:gd name="connsiteY2" fmla="*/ 724817 h 731913"/>
              <a:gd name="connsiteX3" fmla="*/ 86282 w 584497"/>
              <a:gd name="connsiteY3" fmla="*/ 493498 h 731913"/>
              <a:gd name="connsiteX4" fmla="*/ 5018 w 584497"/>
              <a:gd name="connsiteY4" fmla="*/ 200713 h 731913"/>
              <a:gd name="connsiteX5" fmla="*/ 201990 w 584497"/>
              <a:gd name="connsiteY5" fmla="*/ 0 h 731913"/>
              <a:gd name="connsiteX0" fmla="*/ 202832 w 585339"/>
              <a:gd name="connsiteY0" fmla="*/ 0 h 731913"/>
              <a:gd name="connsiteX1" fmla="*/ 572843 w 585339"/>
              <a:gd name="connsiteY1" fmla="*/ 190885 h 731913"/>
              <a:gd name="connsiteX2" fmla="*/ 218843 w 585339"/>
              <a:gd name="connsiteY2" fmla="*/ 724817 h 731913"/>
              <a:gd name="connsiteX3" fmla="*/ 87124 w 585339"/>
              <a:gd name="connsiteY3" fmla="*/ 493498 h 731913"/>
              <a:gd name="connsiteX4" fmla="*/ 5860 w 585339"/>
              <a:gd name="connsiteY4" fmla="*/ 200713 h 731913"/>
              <a:gd name="connsiteX5" fmla="*/ 202832 w 585339"/>
              <a:gd name="connsiteY5" fmla="*/ 0 h 731913"/>
              <a:gd name="connsiteX0" fmla="*/ 196868 w 579375"/>
              <a:gd name="connsiteY0" fmla="*/ 0 h 731913"/>
              <a:gd name="connsiteX1" fmla="*/ 566879 w 579375"/>
              <a:gd name="connsiteY1" fmla="*/ 190885 h 731913"/>
              <a:gd name="connsiteX2" fmla="*/ 212879 w 579375"/>
              <a:gd name="connsiteY2" fmla="*/ 724817 h 731913"/>
              <a:gd name="connsiteX3" fmla="*/ 81160 w 579375"/>
              <a:gd name="connsiteY3" fmla="*/ 493498 h 731913"/>
              <a:gd name="connsiteX4" fmla="*/ 6114 w 579375"/>
              <a:gd name="connsiteY4" fmla="*/ 200713 h 731913"/>
              <a:gd name="connsiteX5" fmla="*/ 196868 w 579375"/>
              <a:gd name="connsiteY5" fmla="*/ 0 h 731913"/>
              <a:gd name="connsiteX0" fmla="*/ 203754 w 586261"/>
              <a:gd name="connsiteY0" fmla="*/ 0 h 731913"/>
              <a:gd name="connsiteX1" fmla="*/ 573765 w 586261"/>
              <a:gd name="connsiteY1" fmla="*/ 190885 h 731913"/>
              <a:gd name="connsiteX2" fmla="*/ 219765 w 586261"/>
              <a:gd name="connsiteY2" fmla="*/ 724817 h 731913"/>
              <a:gd name="connsiteX3" fmla="*/ 88046 w 586261"/>
              <a:gd name="connsiteY3" fmla="*/ 493498 h 731913"/>
              <a:gd name="connsiteX4" fmla="*/ 13000 w 586261"/>
              <a:gd name="connsiteY4" fmla="*/ 200713 h 731913"/>
              <a:gd name="connsiteX5" fmla="*/ 203754 w 586261"/>
              <a:gd name="connsiteY5" fmla="*/ 0 h 731913"/>
              <a:gd name="connsiteX0" fmla="*/ 203754 w 586261"/>
              <a:gd name="connsiteY0" fmla="*/ 0 h 731913"/>
              <a:gd name="connsiteX1" fmla="*/ 573765 w 586261"/>
              <a:gd name="connsiteY1" fmla="*/ 190885 h 731913"/>
              <a:gd name="connsiteX2" fmla="*/ 219765 w 586261"/>
              <a:gd name="connsiteY2" fmla="*/ 724817 h 731913"/>
              <a:gd name="connsiteX3" fmla="*/ 94264 w 586261"/>
              <a:gd name="connsiteY3" fmla="*/ 496607 h 731913"/>
              <a:gd name="connsiteX4" fmla="*/ 13000 w 586261"/>
              <a:gd name="connsiteY4" fmla="*/ 200713 h 731913"/>
              <a:gd name="connsiteX5" fmla="*/ 203754 w 586261"/>
              <a:gd name="connsiteY5" fmla="*/ 0 h 731913"/>
              <a:gd name="connsiteX0" fmla="*/ 203754 w 586261"/>
              <a:gd name="connsiteY0" fmla="*/ 0 h 731913"/>
              <a:gd name="connsiteX1" fmla="*/ 573765 w 586261"/>
              <a:gd name="connsiteY1" fmla="*/ 190885 h 731913"/>
              <a:gd name="connsiteX2" fmla="*/ 219765 w 586261"/>
              <a:gd name="connsiteY2" fmla="*/ 724817 h 731913"/>
              <a:gd name="connsiteX3" fmla="*/ 94264 w 586261"/>
              <a:gd name="connsiteY3" fmla="*/ 496607 h 731913"/>
              <a:gd name="connsiteX4" fmla="*/ 13000 w 586261"/>
              <a:gd name="connsiteY4" fmla="*/ 200713 h 731913"/>
              <a:gd name="connsiteX5" fmla="*/ 203754 w 586261"/>
              <a:gd name="connsiteY5" fmla="*/ 0 h 731913"/>
              <a:gd name="connsiteX0" fmla="*/ 203754 w 586261"/>
              <a:gd name="connsiteY0" fmla="*/ 0 h 731913"/>
              <a:gd name="connsiteX1" fmla="*/ 573765 w 586261"/>
              <a:gd name="connsiteY1" fmla="*/ 190885 h 731913"/>
              <a:gd name="connsiteX2" fmla="*/ 219765 w 586261"/>
              <a:gd name="connsiteY2" fmla="*/ 724817 h 731913"/>
              <a:gd name="connsiteX3" fmla="*/ 94264 w 586261"/>
              <a:gd name="connsiteY3" fmla="*/ 496607 h 731913"/>
              <a:gd name="connsiteX4" fmla="*/ 13000 w 586261"/>
              <a:gd name="connsiteY4" fmla="*/ 200713 h 731913"/>
              <a:gd name="connsiteX5" fmla="*/ 203754 w 586261"/>
              <a:gd name="connsiteY5" fmla="*/ 0 h 731913"/>
              <a:gd name="connsiteX0" fmla="*/ 195177 w 586942"/>
              <a:gd name="connsiteY0" fmla="*/ 0 h 699511"/>
              <a:gd name="connsiteX1" fmla="*/ 574446 w 586942"/>
              <a:gd name="connsiteY1" fmla="*/ 158483 h 699511"/>
              <a:gd name="connsiteX2" fmla="*/ 220446 w 586942"/>
              <a:gd name="connsiteY2" fmla="*/ 692415 h 699511"/>
              <a:gd name="connsiteX3" fmla="*/ 94945 w 586942"/>
              <a:gd name="connsiteY3" fmla="*/ 464205 h 699511"/>
              <a:gd name="connsiteX4" fmla="*/ 13681 w 586942"/>
              <a:gd name="connsiteY4" fmla="*/ 168311 h 699511"/>
              <a:gd name="connsiteX5" fmla="*/ 195177 w 586942"/>
              <a:gd name="connsiteY5" fmla="*/ 0 h 699511"/>
              <a:gd name="connsiteX0" fmla="*/ 195177 w 586942"/>
              <a:gd name="connsiteY0" fmla="*/ 13695 h 713206"/>
              <a:gd name="connsiteX1" fmla="*/ 574446 w 586942"/>
              <a:gd name="connsiteY1" fmla="*/ 172178 h 713206"/>
              <a:gd name="connsiteX2" fmla="*/ 220446 w 586942"/>
              <a:gd name="connsiteY2" fmla="*/ 706110 h 713206"/>
              <a:gd name="connsiteX3" fmla="*/ 94945 w 586942"/>
              <a:gd name="connsiteY3" fmla="*/ 477900 h 713206"/>
              <a:gd name="connsiteX4" fmla="*/ 13681 w 586942"/>
              <a:gd name="connsiteY4" fmla="*/ 182006 h 713206"/>
              <a:gd name="connsiteX5" fmla="*/ 195177 w 586942"/>
              <a:gd name="connsiteY5" fmla="*/ 13695 h 713206"/>
              <a:gd name="connsiteX0" fmla="*/ 195177 w 610451"/>
              <a:gd name="connsiteY0" fmla="*/ 13695 h 709616"/>
              <a:gd name="connsiteX1" fmla="*/ 574446 w 610451"/>
              <a:gd name="connsiteY1" fmla="*/ 172178 h 709616"/>
              <a:gd name="connsiteX2" fmla="*/ 220446 w 610451"/>
              <a:gd name="connsiteY2" fmla="*/ 706110 h 709616"/>
              <a:gd name="connsiteX3" fmla="*/ 94945 w 610451"/>
              <a:gd name="connsiteY3" fmla="*/ 477900 h 709616"/>
              <a:gd name="connsiteX4" fmla="*/ 13681 w 610451"/>
              <a:gd name="connsiteY4" fmla="*/ 182006 h 709616"/>
              <a:gd name="connsiteX5" fmla="*/ 195177 w 610451"/>
              <a:gd name="connsiteY5" fmla="*/ 13695 h 709616"/>
              <a:gd name="connsiteX0" fmla="*/ 195177 w 609636"/>
              <a:gd name="connsiteY0" fmla="*/ 13695 h 745908"/>
              <a:gd name="connsiteX1" fmla="*/ 574446 w 609636"/>
              <a:gd name="connsiteY1" fmla="*/ 172178 h 745908"/>
              <a:gd name="connsiteX2" fmla="*/ 213503 w 609636"/>
              <a:gd name="connsiteY2" fmla="*/ 743141 h 745908"/>
              <a:gd name="connsiteX3" fmla="*/ 94945 w 609636"/>
              <a:gd name="connsiteY3" fmla="*/ 477900 h 745908"/>
              <a:gd name="connsiteX4" fmla="*/ 13681 w 609636"/>
              <a:gd name="connsiteY4" fmla="*/ 182006 h 745908"/>
              <a:gd name="connsiteX5" fmla="*/ 195177 w 609636"/>
              <a:gd name="connsiteY5" fmla="*/ 13695 h 745908"/>
              <a:gd name="connsiteX0" fmla="*/ 195177 w 607763"/>
              <a:gd name="connsiteY0" fmla="*/ 13695 h 743149"/>
              <a:gd name="connsiteX1" fmla="*/ 574446 w 607763"/>
              <a:gd name="connsiteY1" fmla="*/ 172178 h 743149"/>
              <a:gd name="connsiteX2" fmla="*/ 213503 w 607763"/>
              <a:gd name="connsiteY2" fmla="*/ 743141 h 743149"/>
              <a:gd name="connsiteX3" fmla="*/ 94945 w 607763"/>
              <a:gd name="connsiteY3" fmla="*/ 477900 h 743149"/>
              <a:gd name="connsiteX4" fmla="*/ 13681 w 607763"/>
              <a:gd name="connsiteY4" fmla="*/ 182006 h 743149"/>
              <a:gd name="connsiteX5" fmla="*/ 195177 w 607763"/>
              <a:gd name="connsiteY5" fmla="*/ 13695 h 743149"/>
              <a:gd name="connsiteX0" fmla="*/ 195177 w 596249"/>
              <a:gd name="connsiteY0" fmla="*/ 13695 h 752202"/>
              <a:gd name="connsiteX1" fmla="*/ 574446 w 596249"/>
              <a:gd name="connsiteY1" fmla="*/ 172178 h 752202"/>
              <a:gd name="connsiteX2" fmla="*/ 510333 w 596249"/>
              <a:gd name="connsiteY2" fmla="*/ 635348 h 752202"/>
              <a:gd name="connsiteX3" fmla="*/ 213503 w 596249"/>
              <a:gd name="connsiteY3" fmla="*/ 743141 h 752202"/>
              <a:gd name="connsiteX4" fmla="*/ 94945 w 596249"/>
              <a:gd name="connsiteY4" fmla="*/ 477900 h 752202"/>
              <a:gd name="connsiteX5" fmla="*/ 13681 w 596249"/>
              <a:gd name="connsiteY5" fmla="*/ 182006 h 752202"/>
              <a:gd name="connsiteX6" fmla="*/ 195177 w 596249"/>
              <a:gd name="connsiteY6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94945 w 615993"/>
              <a:gd name="connsiteY4" fmla="*/ 477900 h 752202"/>
              <a:gd name="connsiteX5" fmla="*/ 13681 w 615993"/>
              <a:gd name="connsiteY5" fmla="*/ 182006 h 752202"/>
              <a:gd name="connsiteX6" fmla="*/ 195177 w 615993"/>
              <a:gd name="connsiteY6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177053 w 615993"/>
              <a:gd name="connsiteY4" fmla="*/ 642290 h 752202"/>
              <a:gd name="connsiteX5" fmla="*/ 94945 w 615993"/>
              <a:gd name="connsiteY5" fmla="*/ 477900 h 752202"/>
              <a:gd name="connsiteX6" fmla="*/ 13681 w 615993"/>
              <a:gd name="connsiteY6" fmla="*/ 182006 h 752202"/>
              <a:gd name="connsiteX7" fmla="*/ 195177 w 615993"/>
              <a:gd name="connsiteY7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177053 w 615993"/>
              <a:gd name="connsiteY4" fmla="*/ 642290 h 752202"/>
              <a:gd name="connsiteX5" fmla="*/ 94945 w 615993"/>
              <a:gd name="connsiteY5" fmla="*/ 477900 h 752202"/>
              <a:gd name="connsiteX6" fmla="*/ 13681 w 615993"/>
              <a:gd name="connsiteY6" fmla="*/ 182006 h 752202"/>
              <a:gd name="connsiteX7" fmla="*/ 195177 w 615993"/>
              <a:gd name="connsiteY7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177053 w 615993"/>
              <a:gd name="connsiteY4" fmla="*/ 642290 h 752202"/>
              <a:gd name="connsiteX5" fmla="*/ 71801 w 615993"/>
              <a:gd name="connsiteY5" fmla="*/ 447813 h 752202"/>
              <a:gd name="connsiteX6" fmla="*/ 13681 w 615993"/>
              <a:gd name="connsiteY6" fmla="*/ 182006 h 752202"/>
              <a:gd name="connsiteX7" fmla="*/ 195177 w 615993"/>
              <a:gd name="connsiteY7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177053 w 615993"/>
              <a:gd name="connsiteY4" fmla="*/ 642290 h 752202"/>
              <a:gd name="connsiteX5" fmla="*/ 71801 w 615993"/>
              <a:gd name="connsiteY5" fmla="*/ 447813 h 752202"/>
              <a:gd name="connsiteX6" fmla="*/ 13681 w 615993"/>
              <a:gd name="connsiteY6" fmla="*/ 182006 h 752202"/>
              <a:gd name="connsiteX7" fmla="*/ 195177 w 615993"/>
              <a:gd name="connsiteY7" fmla="*/ 13695 h 752202"/>
              <a:gd name="connsiteX0" fmla="*/ 195177 w 615993"/>
              <a:gd name="connsiteY0" fmla="*/ 13695 h 752202"/>
              <a:gd name="connsiteX1" fmla="*/ 574446 w 615993"/>
              <a:gd name="connsiteY1" fmla="*/ 172178 h 752202"/>
              <a:gd name="connsiteX2" fmla="*/ 510333 w 615993"/>
              <a:gd name="connsiteY2" fmla="*/ 635348 h 752202"/>
              <a:gd name="connsiteX3" fmla="*/ 213503 w 615993"/>
              <a:gd name="connsiteY3" fmla="*/ 743141 h 752202"/>
              <a:gd name="connsiteX4" fmla="*/ 177053 w 615993"/>
              <a:gd name="connsiteY4" fmla="*/ 642290 h 752202"/>
              <a:gd name="connsiteX5" fmla="*/ 71801 w 615993"/>
              <a:gd name="connsiteY5" fmla="*/ 447813 h 752202"/>
              <a:gd name="connsiteX6" fmla="*/ 13681 w 615993"/>
              <a:gd name="connsiteY6" fmla="*/ 182006 h 752202"/>
              <a:gd name="connsiteX7" fmla="*/ 195177 w 615993"/>
              <a:gd name="connsiteY7" fmla="*/ 13695 h 752202"/>
              <a:gd name="connsiteX0" fmla="*/ 174068 w 594884"/>
              <a:gd name="connsiteY0" fmla="*/ 13695 h 752202"/>
              <a:gd name="connsiteX1" fmla="*/ 553337 w 594884"/>
              <a:gd name="connsiteY1" fmla="*/ 172178 h 752202"/>
              <a:gd name="connsiteX2" fmla="*/ 489224 w 594884"/>
              <a:gd name="connsiteY2" fmla="*/ 635348 h 752202"/>
              <a:gd name="connsiteX3" fmla="*/ 192394 w 594884"/>
              <a:gd name="connsiteY3" fmla="*/ 743141 h 752202"/>
              <a:gd name="connsiteX4" fmla="*/ 155944 w 594884"/>
              <a:gd name="connsiteY4" fmla="*/ 642290 h 752202"/>
              <a:gd name="connsiteX5" fmla="*/ 50692 w 594884"/>
              <a:gd name="connsiteY5" fmla="*/ 447813 h 752202"/>
              <a:gd name="connsiteX6" fmla="*/ 15716 w 594884"/>
              <a:gd name="connsiteY6" fmla="*/ 221352 h 752202"/>
              <a:gd name="connsiteX7" fmla="*/ 174068 w 594884"/>
              <a:gd name="connsiteY7" fmla="*/ 13695 h 752202"/>
              <a:gd name="connsiteX0" fmla="*/ 158352 w 579168"/>
              <a:gd name="connsiteY0" fmla="*/ 13695 h 752202"/>
              <a:gd name="connsiteX1" fmla="*/ 537621 w 579168"/>
              <a:gd name="connsiteY1" fmla="*/ 172178 h 752202"/>
              <a:gd name="connsiteX2" fmla="*/ 473508 w 579168"/>
              <a:gd name="connsiteY2" fmla="*/ 635348 h 752202"/>
              <a:gd name="connsiteX3" fmla="*/ 176678 w 579168"/>
              <a:gd name="connsiteY3" fmla="*/ 743141 h 752202"/>
              <a:gd name="connsiteX4" fmla="*/ 140228 w 579168"/>
              <a:gd name="connsiteY4" fmla="*/ 642290 h 752202"/>
              <a:gd name="connsiteX5" fmla="*/ 34976 w 579168"/>
              <a:gd name="connsiteY5" fmla="*/ 447813 h 752202"/>
              <a:gd name="connsiteX6" fmla="*/ 0 w 579168"/>
              <a:gd name="connsiteY6" fmla="*/ 221352 h 752202"/>
              <a:gd name="connsiteX7" fmla="*/ 158352 w 579168"/>
              <a:gd name="connsiteY7" fmla="*/ 13695 h 752202"/>
              <a:gd name="connsiteX0" fmla="*/ 158352 w 579168"/>
              <a:gd name="connsiteY0" fmla="*/ 13695 h 752202"/>
              <a:gd name="connsiteX1" fmla="*/ 537621 w 579168"/>
              <a:gd name="connsiteY1" fmla="*/ 172178 h 752202"/>
              <a:gd name="connsiteX2" fmla="*/ 473508 w 579168"/>
              <a:gd name="connsiteY2" fmla="*/ 635348 h 752202"/>
              <a:gd name="connsiteX3" fmla="*/ 176678 w 579168"/>
              <a:gd name="connsiteY3" fmla="*/ 743141 h 752202"/>
              <a:gd name="connsiteX4" fmla="*/ 140228 w 579168"/>
              <a:gd name="connsiteY4" fmla="*/ 642290 h 752202"/>
              <a:gd name="connsiteX5" fmla="*/ 37291 w 579168"/>
              <a:gd name="connsiteY5" fmla="*/ 420040 h 752202"/>
              <a:gd name="connsiteX6" fmla="*/ 0 w 579168"/>
              <a:gd name="connsiteY6" fmla="*/ 221352 h 752202"/>
              <a:gd name="connsiteX7" fmla="*/ 158352 w 579168"/>
              <a:gd name="connsiteY7" fmla="*/ 13695 h 752202"/>
              <a:gd name="connsiteX0" fmla="*/ 158352 w 579168"/>
              <a:gd name="connsiteY0" fmla="*/ 13695 h 752202"/>
              <a:gd name="connsiteX1" fmla="*/ 537621 w 579168"/>
              <a:gd name="connsiteY1" fmla="*/ 172178 h 752202"/>
              <a:gd name="connsiteX2" fmla="*/ 473508 w 579168"/>
              <a:gd name="connsiteY2" fmla="*/ 635348 h 752202"/>
              <a:gd name="connsiteX3" fmla="*/ 176678 w 579168"/>
              <a:gd name="connsiteY3" fmla="*/ 743141 h 752202"/>
              <a:gd name="connsiteX4" fmla="*/ 140228 w 579168"/>
              <a:gd name="connsiteY4" fmla="*/ 642290 h 752202"/>
              <a:gd name="connsiteX5" fmla="*/ 37291 w 579168"/>
              <a:gd name="connsiteY5" fmla="*/ 420040 h 752202"/>
              <a:gd name="connsiteX6" fmla="*/ 0 w 579168"/>
              <a:gd name="connsiteY6" fmla="*/ 221352 h 752202"/>
              <a:gd name="connsiteX7" fmla="*/ 158352 w 579168"/>
              <a:gd name="connsiteY7" fmla="*/ 13695 h 752202"/>
              <a:gd name="connsiteX0" fmla="*/ 159672 w 580488"/>
              <a:gd name="connsiteY0" fmla="*/ 13695 h 752202"/>
              <a:gd name="connsiteX1" fmla="*/ 538941 w 580488"/>
              <a:gd name="connsiteY1" fmla="*/ 172178 h 752202"/>
              <a:gd name="connsiteX2" fmla="*/ 474828 w 580488"/>
              <a:gd name="connsiteY2" fmla="*/ 635348 h 752202"/>
              <a:gd name="connsiteX3" fmla="*/ 177998 w 580488"/>
              <a:gd name="connsiteY3" fmla="*/ 743141 h 752202"/>
              <a:gd name="connsiteX4" fmla="*/ 141548 w 580488"/>
              <a:gd name="connsiteY4" fmla="*/ 642290 h 752202"/>
              <a:gd name="connsiteX5" fmla="*/ 38611 w 580488"/>
              <a:gd name="connsiteY5" fmla="*/ 420040 h 752202"/>
              <a:gd name="connsiteX6" fmla="*/ 1320 w 580488"/>
              <a:gd name="connsiteY6" fmla="*/ 221352 h 752202"/>
              <a:gd name="connsiteX7" fmla="*/ 23511 w 580488"/>
              <a:gd name="connsiteY7" fmla="*/ 59049 h 752202"/>
              <a:gd name="connsiteX8" fmla="*/ 159672 w 580488"/>
              <a:gd name="connsiteY8" fmla="*/ 13695 h 752202"/>
              <a:gd name="connsiteX0" fmla="*/ 159672 w 580488"/>
              <a:gd name="connsiteY0" fmla="*/ 13695 h 752202"/>
              <a:gd name="connsiteX1" fmla="*/ 538941 w 580488"/>
              <a:gd name="connsiteY1" fmla="*/ 172178 h 752202"/>
              <a:gd name="connsiteX2" fmla="*/ 474828 w 580488"/>
              <a:gd name="connsiteY2" fmla="*/ 635348 h 752202"/>
              <a:gd name="connsiteX3" fmla="*/ 177998 w 580488"/>
              <a:gd name="connsiteY3" fmla="*/ 743141 h 752202"/>
              <a:gd name="connsiteX4" fmla="*/ 141548 w 580488"/>
              <a:gd name="connsiteY4" fmla="*/ 642290 h 752202"/>
              <a:gd name="connsiteX5" fmla="*/ 38611 w 580488"/>
              <a:gd name="connsiteY5" fmla="*/ 420040 h 752202"/>
              <a:gd name="connsiteX6" fmla="*/ 1320 w 580488"/>
              <a:gd name="connsiteY6" fmla="*/ 221352 h 752202"/>
              <a:gd name="connsiteX7" fmla="*/ 23511 w 580488"/>
              <a:gd name="connsiteY7" fmla="*/ 59049 h 752202"/>
              <a:gd name="connsiteX8" fmla="*/ 159672 w 580488"/>
              <a:gd name="connsiteY8" fmla="*/ 13695 h 752202"/>
              <a:gd name="connsiteX0" fmla="*/ 159672 w 580488"/>
              <a:gd name="connsiteY0" fmla="*/ 13695 h 752202"/>
              <a:gd name="connsiteX1" fmla="*/ 538941 w 580488"/>
              <a:gd name="connsiteY1" fmla="*/ 172178 h 752202"/>
              <a:gd name="connsiteX2" fmla="*/ 474828 w 580488"/>
              <a:gd name="connsiteY2" fmla="*/ 635348 h 752202"/>
              <a:gd name="connsiteX3" fmla="*/ 177998 w 580488"/>
              <a:gd name="connsiteY3" fmla="*/ 743141 h 752202"/>
              <a:gd name="connsiteX4" fmla="*/ 141548 w 580488"/>
              <a:gd name="connsiteY4" fmla="*/ 642290 h 752202"/>
              <a:gd name="connsiteX5" fmla="*/ 38611 w 580488"/>
              <a:gd name="connsiteY5" fmla="*/ 420040 h 752202"/>
              <a:gd name="connsiteX6" fmla="*/ 1320 w 580488"/>
              <a:gd name="connsiteY6" fmla="*/ 221352 h 752202"/>
              <a:gd name="connsiteX7" fmla="*/ 23511 w 580488"/>
              <a:gd name="connsiteY7" fmla="*/ 59049 h 752202"/>
              <a:gd name="connsiteX8" fmla="*/ 159672 w 580488"/>
              <a:gd name="connsiteY8" fmla="*/ 13695 h 752202"/>
              <a:gd name="connsiteX0" fmla="*/ 159672 w 580488"/>
              <a:gd name="connsiteY0" fmla="*/ 13695 h 752202"/>
              <a:gd name="connsiteX1" fmla="*/ 538941 w 580488"/>
              <a:gd name="connsiteY1" fmla="*/ 172178 h 752202"/>
              <a:gd name="connsiteX2" fmla="*/ 474828 w 580488"/>
              <a:gd name="connsiteY2" fmla="*/ 635348 h 752202"/>
              <a:gd name="connsiteX3" fmla="*/ 177998 w 580488"/>
              <a:gd name="connsiteY3" fmla="*/ 743141 h 752202"/>
              <a:gd name="connsiteX4" fmla="*/ 141548 w 580488"/>
              <a:gd name="connsiteY4" fmla="*/ 642290 h 752202"/>
              <a:gd name="connsiteX5" fmla="*/ 38611 w 580488"/>
              <a:gd name="connsiteY5" fmla="*/ 420040 h 752202"/>
              <a:gd name="connsiteX6" fmla="*/ 1320 w 580488"/>
              <a:gd name="connsiteY6" fmla="*/ 221352 h 752202"/>
              <a:gd name="connsiteX7" fmla="*/ 23511 w 580488"/>
              <a:gd name="connsiteY7" fmla="*/ 59049 h 752202"/>
              <a:gd name="connsiteX8" fmla="*/ 159672 w 580488"/>
              <a:gd name="connsiteY8" fmla="*/ 13695 h 752202"/>
              <a:gd name="connsiteX0" fmla="*/ 192074 w 580488"/>
              <a:gd name="connsiteY0" fmla="*/ 14464 h 750656"/>
              <a:gd name="connsiteX1" fmla="*/ 538941 w 580488"/>
              <a:gd name="connsiteY1" fmla="*/ 170632 h 750656"/>
              <a:gd name="connsiteX2" fmla="*/ 474828 w 580488"/>
              <a:gd name="connsiteY2" fmla="*/ 633802 h 750656"/>
              <a:gd name="connsiteX3" fmla="*/ 177998 w 580488"/>
              <a:gd name="connsiteY3" fmla="*/ 741595 h 750656"/>
              <a:gd name="connsiteX4" fmla="*/ 141548 w 580488"/>
              <a:gd name="connsiteY4" fmla="*/ 640744 h 750656"/>
              <a:gd name="connsiteX5" fmla="*/ 38611 w 580488"/>
              <a:gd name="connsiteY5" fmla="*/ 418494 h 750656"/>
              <a:gd name="connsiteX6" fmla="*/ 1320 w 580488"/>
              <a:gd name="connsiteY6" fmla="*/ 219806 h 750656"/>
              <a:gd name="connsiteX7" fmla="*/ 23511 w 580488"/>
              <a:gd name="connsiteY7" fmla="*/ 57503 h 750656"/>
              <a:gd name="connsiteX8" fmla="*/ 192074 w 580488"/>
              <a:gd name="connsiteY8" fmla="*/ 14464 h 750656"/>
              <a:gd name="connsiteX0" fmla="*/ 190754 w 579168"/>
              <a:gd name="connsiteY0" fmla="*/ 14464 h 750656"/>
              <a:gd name="connsiteX1" fmla="*/ 537621 w 579168"/>
              <a:gd name="connsiteY1" fmla="*/ 170632 h 750656"/>
              <a:gd name="connsiteX2" fmla="*/ 473508 w 579168"/>
              <a:gd name="connsiteY2" fmla="*/ 633802 h 750656"/>
              <a:gd name="connsiteX3" fmla="*/ 176678 w 579168"/>
              <a:gd name="connsiteY3" fmla="*/ 741595 h 750656"/>
              <a:gd name="connsiteX4" fmla="*/ 140228 w 579168"/>
              <a:gd name="connsiteY4" fmla="*/ 640744 h 750656"/>
              <a:gd name="connsiteX5" fmla="*/ 37291 w 579168"/>
              <a:gd name="connsiteY5" fmla="*/ 418494 h 750656"/>
              <a:gd name="connsiteX6" fmla="*/ 0 w 579168"/>
              <a:gd name="connsiteY6" fmla="*/ 219806 h 750656"/>
              <a:gd name="connsiteX7" fmla="*/ 22191 w 579168"/>
              <a:gd name="connsiteY7" fmla="*/ 57503 h 750656"/>
              <a:gd name="connsiteX8" fmla="*/ 190754 w 579168"/>
              <a:gd name="connsiteY8" fmla="*/ 14464 h 750656"/>
              <a:gd name="connsiteX0" fmla="*/ 190754 w 579168"/>
              <a:gd name="connsiteY0" fmla="*/ 14464 h 750656"/>
              <a:gd name="connsiteX1" fmla="*/ 537621 w 579168"/>
              <a:gd name="connsiteY1" fmla="*/ 170632 h 750656"/>
              <a:gd name="connsiteX2" fmla="*/ 473508 w 579168"/>
              <a:gd name="connsiteY2" fmla="*/ 633802 h 750656"/>
              <a:gd name="connsiteX3" fmla="*/ 176678 w 579168"/>
              <a:gd name="connsiteY3" fmla="*/ 741595 h 750656"/>
              <a:gd name="connsiteX4" fmla="*/ 140228 w 579168"/>
              <a:gd name="connsiteY4" fmla="*/ 640744 h 750656"/>
              <a:gd name="connsiteX5" fmla="*/ 37291 w 579168"/>
              <a:gd name="connsiteY5" fmla="*/ 418494 h 750656"/>
              <a:gd name="connsiteX6" fmla="*/ 0 w 579168"/>
              <a:gd name="connsiteY6" fmla="*/ 219806 h 750656"/>
              <a:gd name="connsiteX7" fmla="*/ 22191 w 579168"/>
              <a:gd name="connsiteY7" fmla="*/ 57503 h 750656"/>
              <a:gd name="connsiteX8" fmla="*/ 190754 w 579168"/>
              <a:gd name="connsiteY8" fmla="*/ 14464 h 750656"/>
              <a:gd name="connsiteX0" fmla="*/ 190754 w 579168"/>
              <a:gd name="connsiteY0" fmla="*/ 14464 h 750656"/>
              <a:gd name="connsiteX1" fmla="*/ 537621 w 579168"/>
              <a:gd name="connsiteY1" fmla="*/ 170632 h 750656"/>
              <a:gd name="connsiteX2" fmla="*/ 473508 w 579168"/>
              <a:gd name="connsiteY2" fmla="*/ 633802 h 750656"/>
              <a:gd name="connsiteX3" fmla="*/ 176678 w 579168"/>
              <a:gd name="connsiteY3" fmla="*/ 741595 h 750656"/>
              <a:gd name="connsiteX4" fmla="*/ 140228 w 579168"/>
              <a:gd name="connsiteY4" fmla="*/ 640744 h 750656"/>
              <a:gd name="connsiteX5" fmla="*/ 37291 w 579168"/>
              <a:gd name="connsiteY5" fmla="*/ 418494 h 750656"/>
              <a:gd name="connsiteX6" fmla="*/ 0 w 579168"/>
              <a:gd name="connsiteY6" fmla="*/ 219806 h 750656"/>
              <a:gd name="connsiteX7" fmla="*/ 22191 w 579168"/>
              <a:gd name="connsiteY7" fmla="*/ 57503 h 750656"/>
              <a:gd name="connsiteX8" fmla="*/ 190754 w 579168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28033 w 569910"/>
              <a:gd name="connsiteY5" fmla="*/ 418494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28033 w 569910"/>
              <a:gd name="connsiteY5" fmla="*/ 418494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28033 w 569910"/>
              <a:gd name="connsiteY5" fmla="*/ 418494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30347 w 569910"/>
              <a:gd name="connsiteY5" fmla="*/ 406922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30347 w 569910"/>
              <a:gd name="connsiteY5" fmla="*/ 406922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0656"/>
              <a:gd name="connsiteX1" fmla="*/ 528363 w 569910"/>
              <a:gd name="connsiteY1" fmla="*/ 170632 h 750656"/>
              <a:gd name="connsiteX2" fmla="*/ 464250 w 569910"/>
              <a:gd name="connsiteY2" fmla="*/ 633802 h 750656"/>
              <a:gd name="connsiteX3" fmla="*/ 167420 w 569910"/>
              <a:gd name="connsiteY3" fmla="*/ 741595 h 750656"/>
              <a:gd name="connsiteX4" fmla="*/ 130970 w 569910"/>
              <a:gd name="connsiteY4" fmla="*/ 640744 h 750656"/>
              <a:gd name="connsiteX5" fmla="*/ 30347 w 569910"/>
              <a:gd name="connsiteY5" fmla="*/ 406922 h 750656"/>
              <a:gd name="connsiteX6" fmla="*/ 0 w 569910"/>
              <a:gd name="connsiteY6" fmla="*/ 208234 h 750656"/>
              <a:gd name="connsiteX7" fmla="*/ 12933 w 569910"/>
              <a:gd name="connsiteY7" fmla="*/ 57503 h 750656"/>
              <a:gd name="connsiteX8" fmla="*/ 181496 w 569910"/>
              <a:gd name="connsiteY8" fmla="*/ 14464 h 750656"/>
              <a:gd name="connsiteX0" fmla="*/ 181496 w 569910"/>
              <a:gd name="connsiteY0" fmla="*/ 14464 h 757058"/>
              <a:gd name="connsiteX1" fmla="*/ 528363 w 569910"/>
              <a:gd name="connsiteY1" fmla="*/ 170632 h 757058"/>
              <a:gd name="connsiteX2" fmla="*/ 464250 w 569910"/>
              <a:gd name="connsiteY2" fmla="*/ 633802 h 757058"/>
              <a:gd name="connsiteX3" fmla="*/ 117285 w 569910"/>
              <a:gd name="connsiteY3" fmla="*/ 748757 h 757058"/>
              <a:gd name="connsiteX4" fmla="*/ 130970 w 569910"/>
              <a:gd name="connsiteY4" fmla="*/ 640744 h 757058"/>
              <a:gd name="connsiteX5" fmla="*/ 30347 w 569910"/>
              <a:gd name="connsiteY5" fmla="*/ 406922 h 757058"/>
              <a:gd name="connsiteX6" fmla="*/ 0 w 569910"/>
              <a:gd name="connsiteY6" fmla="*/ 208234 h 757058"/>
              <a:gd name="connsiteX7" fmla="*/ 12933 w 569910"/>
              <a:gd name="connsiteY7" fmla="*/ 57503 h 757058"/>
              <a:gd name="connsiteX8" fmla="*/ 181496 w 569910"/>
              <a:gd name="connsiteY8" fmla="*/ 14464 h 757058"/>
              <a:gd name="connsiteX0" fmla="*/ 181496 w 569910"/>
              <a:gd name="connsiteY0" fmla="*/ 14464 h 757058"/>
              <a:gd name="connsiteX1" fmla="*/ 528363 w 569910"/>
              <a:gd name="connsiteY1" fmla="*/ 170632 h 757058"/>
              <a:gd name="connsiteX2" fmla="*/ 464250 w 569910"/>
              <a:gd name="connsiteY2" fmla="*/ 633802 h 757058"/>
              <a:gd name="connsiteX3" fmla="*/ 117285 w 569910"/>
              <a:gd name="connsiteY3" fmla="*/ 748757 h 757058"/>
              <a:gd name="connsiteX4" fmla="*/ 104709 w 569910"/>
              <a:gd name="connsiteY4" fmla="*/ 638357 h 757058"/>
              <a:gd name="connsiteX5" fmla="*/ 30347 w 569910"/>
              <a:gd name="connsiteY5" fmla="*/ 406922 h 757058"/>
              <a:gd name="connsiteX6" fmla="*/ 0 w 569910"/>
              <a:gd name="connsiteY6" fmla="*/ 208234 h 757058"/>
              <a:gd name="connsiteX7" fmla="*/ 12933 w 569910"/>
              <a:gd name="connsiteY7" fmla="*/ 57503 h 757058"/>
              <a:gd name="connsiteX8" fmla="*/ 181496 w 569910"/>
              <a:gd name="connsiteY8" fmla="*/ 14464 h 757058"/>
              <a:gd name="connsiteX0" fmla="*/ 181496 w 569910"/>
              <a:gd name="connsiteY0" fmla="*/ 14464 h 757058"/>
              <a:gd name="connsiteX1" fmla="*/ 528363 w 569910"/>
              <a:gd name="connsiteY1" fmla="*/ 170632 h 757058"/>
              <a:gd name="connsiteX2" fmla="*/ 464250 w 569910"/>
              <a:gd name="connsiteY2" fmla="*/ 633802 h 757058"/>
              <a:gd name="connsiteX3" fmla="*/ 117285 w 569910"/>
              <a:gd name="connsiteY3" fmla="*/ 748757 h 757058"/>
              <a:gd name="connsiteX4" fmla="*/ 104709 w 569910"/>
              <a:gd name="connsiteY4" fmla="*/ 638357 h 757058"/>
              <a:gd name="connsiteX5" fmla="*/ 30347 w 569910"/>
              <a:gd name="connsiteY5" fmla="*/ 406922 h 757058"/>
              <a:gd name="connsiteX6" fmla="*/ 0 w 569910"/>
              <a:gd name="connsiteY6" fmla="*/ 208234 h 757058"/>
              <a:gd name="connsiteX7" fmla="*/ 12933 w 569910"/>
              <a:gd name="connsiteY7" fmla="*/ 57503 h 757058"/>
              <a:gd name="connsiteX8" fmla="*/ 181496 w 569910"/>
              <a:gd name="connsiteY8" fmla="*/ 14464 h 757058"/>
              <a:gd name="connsiteX0" fmla="*/ 181496 w 569910"/>
              <a:gd name="connsiteY0" fmla="*/ 14464 h 757058"/>
              <a:gd name="connsiteX1" fmla="*/ 528363 w 569910"/>
              <a:gd name="connsiteY1" fmla="*/ 170632 h 757058"/>
              <a:gd name="connsiteX2" fmla="*/ 464250 w 569910"/>
              <a:gd name="connsiteY2" fmla="*/ 633802 h 757058"/>
              <a:gd name="connsiteX3" fmla="*/ 117285 w 569910"/>
              <a:gd name="connsiteY3" fmla="*/ 748757 h 757058"/>
              <a:gd name="connsiteX4" fmla="*/ 104709 w 569910"/>
              <a:gd name="connsiteY4" fmla="*/ 638357 h 757058"/>
              <a:gd name="connsiteX5" fmla="*/ 30347 w 569910"/>
              <a:gd name="connsiteY5" fmla="*/ 406922 h 757058"/>
              <a:gd name="connsiteX6" fmla="*/ 0 w 569910"/>
              <a:gd name="connsiteY6" fmla="*/ 208234 h 757058"/>
              <a:gd name="connsiteX7" fmla="*/ 12933 w 569910"/>
              <a:gd name="connsiteY7" fmla="*/ 57503 h 757058"/>
              <a:gd name="connsiteX8" fmla="*/ 181496 w 569910"/>
              <a:gd name="connsiteY8" fmla="*/ 14464 h 757058"/>
              <a:gd name="connsiteX0" fmla="*/ 183883 w 572297"/>
              <a:gd name="connsiteY0" fmla="*/ 14464 h 757058"/>
              <a:gd name="connsiteX1" fmla="*/ 530750 w 572297"/>
              <a:gd name="connsiteY1" fmla="*/ 170632 h 757058"/>
              <a:gd name="connsiteX2" fmla="*/ 466637 w 572297"/>
              <a:gd name="connsiteY2" fmla="*/ 633802 h 757058"/>
              <a:gd name="connsiteX3" fmla="*/ 119672 w 572297"/>
              <a:gd name="connsiteY3" fmla="*/ 748757 h 757058"/>
              <a:gd name="connsiteX4" fmla="*/ 107096 w 572297"/>
              <a:gd name="connsiteY4" fmla="*/ 638357 h 757058"/>
              <a:gd name="connsiteX5" fmla="*/ 32734 w 572297"/>
              <a:gd name="connsiteY5" fmla="*/ 406922 h 757058"/>
              <a:gd name="connsiteX6" fmla="*/ 0 w 572297"/>
              <a:gd name="connsiteY6" fmla="*/ 191522 h 757058"/>
              <a:gd name="connsiteX7" fmla="*/ 15320 w 572297"/>
              <a:gd name="connsiteY7" fmla="*/ 57503 h 757058"/>
              <a:gd name="connsiteX8" fmla="*/ 183883 w 572297"/>
              <a:gd name="connsiteY8" fmla="*/ 14464 h 757058"/>
              <a:gd name="connsiteX0" fmla="*/ 183883 w 572297"/>
              <a:gd name="connsiteY0" fmla="*/ 14464 h 757058"/>
              <a:gd name="connsiteX1" fmla="*/ 530750 w 572297"/>
              <a:gd name="connsiteY1" fmla="*/ 170632 h 757058"/>
              <a:gd name="connsiteX2" fmla="*/ 466637 w 572297"/>
              <a:gd name="connsiteY2" fmla="*/ 633802 h 757058"/>
              <a:gd name="connsiteX3" fmla="*/ 119672 w 572297"/>
              <a:gd name="connsiteY3" fmla="*/ 748757 h 757058"/>
              <a:gd name="connsiteX4" fmla="*/ 107096 w 572297"/>
              <a:gd name="connsiteY4" fmla="*/ 638357 h 757058"/>
              <a:gd name="connsiteX5" fmla="*/ 32734 w 572297"/>
              <a:gd name="connsiteY5" fmla="*/ 406922 h 757058"/>
              <a:gd name="connsiteX6" fmla="*/ 0 w 572297"/>
              <a:gd name="connsiteY6" fmla="*/ 191522 h 757058"/>
              <a:gd name="connsiteX7" fmla="*/ 15320 w 572297"/>
              <a:gd name="connsiteY7" fmla="*/ 57503 h 757058"/>
              <a:gd name="connsiteX8" fmla="*/ 183883 w 572297"/>
              <a:gd name="connsiteY8" fmla="*/ 14464 h 757058"/>
              <a:gd name="connsiteX0" fmla="*/ 183883 w 560723"/>
              <a:gd name="connsiteY0" fmla="*/ 14464 h 757058"/>
              <a:gd name="connsiteX1" fmla="*/ 530750 w 560723"/>
              <a:gd name="connsiteY1" fmla="*/ 170632 h 757058"/>
              <a:gd name="connsiteX2" fmla="*/ 466637 w 560723"/>
              <a:gd name="connsiteY2" fmla="*/ 633802 h 757058"/>
              <a:gd name="connsiteX3" fmla="*/ 119672 w 560723"/>
              <a:gd name="connsiteY3" fmla="*/ 748757 h 757058"/>
              <a:gd name="connsiteX4" fmla="*/ 107096 w 560723"/>
              <a:gd name="connsiteY4" fmla="*/ 638357 h 757058"/>
              <a:gd name="connsiteX5" fmla="*/ 32734 w 560723"/>
              <a:gd name="connsiteY5" fmla="*/ 406922 h 757058"/>
              <a:gd name="connsiteX6" fmla="*/ 0 w 560723"/>
              <a:gd name="connsiteY6" fmla="*/ 191522 h 757058"/>
              <a:gd name="connsiteX7" fmla="*/ 15320 w 560723"/>
              <a:gd name="connsiteY7" fmla="*/ 57503 h 757058"/>
              <a:gd name="connsiteX8" fmla="*/ 183883 w 560723"/>
              <a:gd name="connsiteY8" fmla="*/ 14464 h 757058"/>
              <a:gd name="connsiteX0" fmla="*/ 183883 w 551980"/>
              <a:gd name="connsiteY0" fmla="*/ 14464 h 757058"/>
              <a:gd name="connsiteX1" fmla="*/ 530750 w 551980"/>
              <a:gd name="connsiteY1" fmla="*/ 170632 h 757058"/>
              <a:gd name="connsiteX2" fmla="*/ 466637 w 551980"/>
              <a:gd name="connsiteY2" fmla="*/ 633802 h 757058"/>
              <a:gd name="connsiteX3" fmla="*/ 119672 w 551980"/>
              <a:gd name="connsiteY3" fmla="*/ 748757 h 757058"/>
              <a:gd name="connsiteX4" fmla="*/ 107096 w 551980"/>
              <a:gd name="connsiteY4" fmla="*/ 638357 h 757058"/>
              <a:gd name="connsiteX5" fmla="*/ 32734 w 551980"/>
              <a:gd name="connsiteY5" fmla="*/ 406922 h 757058"/>
              <a:gd name="connsiteX6" fmla="*/ 0 w 551980"/>
              <a:gd name="connsiteY6" fmla="*/ 191522 h 757058"/>
              <a:gd name="connsiteX7" fmla="*/ 15320 w 551980"/>
              <a:gd name="connsiteY7" fmla="*/ 57503 h 757058"/>
              <a:gd name="connsiteX8" fmla="*/ 183883 w 551980"/>
              <a:gd name="connsiteY8" fmla="*/ 14464 h 757058"/>
              <a:gd name="connsiteX0" fmla="*/ 183883 w 558213"/>
              <a:gd name="connsiteY0" fmla="*/ 14464 h 757058"/>
              <a:gd name="connsiteX1" fmla="*/ 530750 w 558213"/>
              <a:gd name="connsiteY1" fmla="*/ 170632 h 757058"/>
              <a:gd name="connsiteX2" fmla="*/ 466637 w 558213"/>
              <a:gd name="connsiteY2" fmla="*/ 633802 h 757058"/>
              <a:gd name="connsiteX3" fmla="*/ 119672 w 558213"/>
              <a:gd name="connsiteY3" fmla="*/ 748757 h 757058"/>
              <a:gd name="connsiteX4" fmla="*/ 107096 w 558213"/>
              <a:gd name="connsiteY4" fmla="*/ 638357 h 757058"/>
              <a:gd name="connsiteX5" fmla="*/ 32734 w 558213"/>
              <a:gd name="connsiteY5" fmla="*/ 406922 h 757058"/>
              <a:gd name="connsiteX6" fmla="*/ 0 w 558213"/>
              <a:gd name="connsiteY6" fmla="*/ 191522 h 757058"/>
              <a:gd name="connsiteX7" fmla="*/ 15320 w 558213"/>
              <a:gd name="connsiteY7" fmla="*/ 57503 h 757058"/>
              <a:gd name="connsiteX8" fmla="*/ 183883 w 558213"/>
              <a:gd name="connsiteY8" fmla="*/ 14464 h 757058"/>
              <a:gd name="connsiteX0" fmla="*/ 183883 w 558213"/>
              <a:gd name="connsiteY0" fmla="*/ 14464 h 757058"/>
              <a:gd name="connsiteX1" fmla="*/ 530750 w 558213"/>
              <a:gd name="connsiteY1" fmla="*/ 170632 h 757058"/>
              <a:gd name="connsiteX2" fmla="*/ 466637 w 558213"/>
              <a:gd name="connsiteY2" fmla="*/ 633802 h 757058"/>
              <a:gd name="connsiteX3" fmla="*/ 119672 w 558213"/>
              <a:gd name="connsiteY3" fmla="*/ 748757 h 757058"/>
              <a:gd name="connsiteX4" fmla="*/ 107096 w 558213"/>
              <a:gd name="connsiteY4" fmla="*/ 638357 h 757058"/>
              <a:gd name="connsiteX5" fmla="*/ 32734 w 558213"/>
              <a:gd name="connsiteY5" fmla="*/ 406922 h 757058"/>
              <a:gd name="connsiteX6" fmla="*/ 0 w 558213"/>
              <a:gd name="connsiteY6" fmla="*/ 191522 h 757058"/>
              <a:gd name="connsiteX7" fmla="*/ 15320 w 558213"/>
              <a:gd name="connsiteY7" fmla="*/ 57503 h 757058"/>
              <a:gd name="connsiteX8" fmla="*/ 183883 w 558213"/>
              <a:gd name="connsiteY8" fmla="*/ 14464 h 7570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58213" h="757058">
                <a:moveTo>
                  <a:pt x="183883" y="14464"/>
                </a:moveTo>
                <a:cubicBezTo>
                  <a:pt x="377574" y="7953"/>
                  <a:pt x="440781" y="-60595"/>
                  <a:pt x="530750" y="170632"/>
                </a:cubicBezTo>
                <a:cubicBezTo>
                  <a:pt x="556941" y="274554"/>
                  <a:pt x="598323" y="517300"/>
                  <a:pt x="466637" y="633802"/>
                </a:cubicBezTo>
                <a:cubicBezTo>
                  <a:pt x="406480" y="728963"/>
                  <a:pt x="191218" y="777699"/>
                  <a:pt x="119672" y="748757"/>
                </a:cubicBezTo>
                <a:cubicBezTo>
                  <a:pt x="97737" y="737185"/>
                  <a:pt x="121586" y="695329"/>
                  <a:pt x="107096" y="638357"/>
                </a:cubicBezTo>
                <a:cubicBezTo>
                  <a:pt x="92606" y="581385"/>
                  <a:pt x="56107" y="590038"/>
                  <a:pt x="32734" y="406922"/>
                </a:cubicBezTo>
                <a:cubicBezTo>
                  <a:pt x="42183" y="255718"/>
                  <a:pt x="41535" y="279495"/>
                  <a:pt x="0" y="191522"/>
                </a:cubicBezTo>
                <a:cubicBezTo>
                  <a:pt x="41457" y="85068"/>
                  <a:pt x="-13386" y="80540"/>
                  <a:pt x="15320" y="57503"/>
                </a:cubicBezTo>
                <a:cubicBezTo>
                  <a:pt x="41712" y="25209"/>
                  <a:pt x="109550" y="16439"/>
                  <a:pt x="183883" y="14464"/>
                </a:cubicBezTo>
                <a:close/>
              </a:path>
            </a:pathLst>
          </a:custGeom>
          <a:noFill/>
          <a:ln w="28575">
            <a:solidFill>
              <a:srgbClr val="00206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4542128" y="3642192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i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4542128" y="5762752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i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2464561" y="3642192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 err="1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2464561" y="5762752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 err="1">
                <a:solidFill>
                  <a:schemeClr val="bg1"/>
                </a:solidFill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4542128" y="1543596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Arial" panose="020B0604020202020204"/>
                <a:ea typeface="ＭＳ Ｐゴシック" panose="020B0600070205080204" pitchFamily="50" charset="-128"/>
              </a:rPr>
              <a:t>i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1AB34AE-01E1-4640-8C14-6363DF0C36DC}"/>
              </a:ext>
            </a:extLst>
          </p:cNvPr>
          <p:cNvSpPr txBox="1"/>
          <p:nvPr/>
        </p:nvSpPr>
        <p:spPr>
          <a:xfrm>
            <a:off x="2464561" y="1543596"/>
            <a:ext cx="494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 err="1"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i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78531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BC0410FB-EDD2-4B58-9156-AE632C6BA9B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942" t="25942" r="25942" b="25942"/>
          <a:stretch/>
        </p:blipFill>
        <p:spPr>
          <a:xfrm rot="10800000">
            <a:off x="1403415" y="1839219"/>
            <a:ext cx="1980000" cy="1980000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68BE972-DAED-45D2-914E-5AB5AEAD94DA}"/>
              </a:ext>
            </a:extLst>
          </p:cNvPr>
          <p:cNvSpPr/>
          <p:nvPr/>
        </p:nvSpPr>
        <p:spPr>
          <a:xfrm>
            <a:off x="1223098" y="3820628"/>
            <a:ext cx="2160318" cy="513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 (0.98)</a:t>
            </a:r>
            <a:endParaRPr kumimoji="0" lang="ja-JP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1757C6E-B310-4A71-9FCD-B8CB86D7FB99}"/>
              </a:ext>
            </a:extLst>
          </p:cNvPr>
          <p:cNvSpPr txBox="1"/>
          <p:nvPr/>
        </p:nvSpPr>
        <p:spPr>
          <a:xfrm>
            <a:off x="83662" y="34925"/>
            <a:ext cx="2954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  <a:cs typeface="+mn-cs"/>
              </a:rPr>
              <a:t>Supplementary Fig. 2 		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41C4E218-DCB9-4DD2-934E-05C5D964C1B3}"/>
              </a:ext>
            </a:extLst>
          </p:cNvPr>
          <p:cNvCxnSpPr>
            <a:cxnSpLocks/>
          </p:cNvCxnSpPr>
          <p:nvPr/>
        </p:nvCxnSpPr>
        <p:spPr>
          <a:xfrm>
            <a:off x="2547664" y="2023918"/>
            <a:ext cx="152266" cy="27615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図 13">
            <a:extLst>
              <a:ext uri="{FF2B5EF4-FFF2-40B4-BE49-F238E27FC236}">
                <a16:creationId xmlns:a16="http://schemas.microsoft.com/office/drawing/2014/main" id="{12B42FC0-C6FB-4F10-9109-45D0FF5996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471" t="52465" r="52516" b="35555"/>
          <a:stretch/>
        </p:blipFill>
        <p:spPr>
          <a:xfrm rot="10800000">
            <a:off x="3429000" y="1839219"/>
            <a:ext cx="1985362" cy="1980001"/>
          </a:xfrm>
          <a:prstGeom prst="rect">
            <a:avLst/>
          </a:prstGeom>
        </p:spPr>
      </p:pic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3BF097CB-FF91-478B-93E6-1C58DA017934}"/>
              </a:ext>
            </a:extLst>
          </p:cNvPr>
          <p:cNvCxnSpPr>
            <a:cxnSpLocks/>
          </p:cNvCxnSpPr>
          <p:nvPr/>
        </p:nvCxnSpPr>
        <p:spPr>
          <a:xfrm>
            <a:off x="4269414" y="2084878"/>
            <a:ext cx="152266" cy="27615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63129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4横" id="{D57EA1DD-FD0C-4FA2-A970-54F14D3B2B9C}" vid="{4DD567FC-60D8-4D6A-966C-56C5A9AEB11E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A4縦MSPゴシックとArial</Template>
  <TotalTime>10641</TotalTime>
  <Words>34</Words>
  <Application>Microsoft Office PowerPoint</Application>
  <PresentationFormat>A4 210 x 297 mm</PresentationFormat>
  <Paragraphs>15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5" baseType="lpstr">
      <vt:lpstr>游ゴシック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no Hisako</dc:creator>
  <cp:lastModifiedBy>Ichiro Sekiya</cp:lastModifiedBy>
  <cp:revision>150</cp:revision>
  <dcterms:created xsi:type="dcterms:W3CDTF">2020-12-17T07:33:28Z</dcterms:created>
  <dcterms:modified xsi:type="dcterms:W3CDTF">2022-02-13T08:42:51Z</dcterms:modified>
</cp:coreProperties>
</file>